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5"/>
  </p:notesMasterIdLst>
  <p:sldIdLst>
    <p:sldId id="266" r:id="rId2"/>
    <p:sldId id="256" r:id="rId3"/>
    <p:sldId id="293" r:id="rId4"/>
    <p:sldId id="258" r:id="rId5"/>
    <p:sldId id="259" r:id="rId6"/>
    <p:sldId id="275" r:id="rId7"/>
    <p:sldId id="260" r:id="rId8"/>
    <p:sldId id="261" r:id="rId9"/>
    <p:sldId id="267" r:id="rId10"/>
    <p:sldId id="268" r:id="rId11"/>
    <p:sldId id="270" r:id="rId12"/>
    <p:sldId id="269" r:id="rId13"/>
    <p:sldId id="271" r:id="rId14"/>
    <p:sldId id="272" r:id="rId15"/>
    <p:sldId id="273" r:id="rId16"/>
    <p:sldId id="274" r:id="rId17"/>
    <p:sldId id="276" r:id="rId18"/>
    <p:sldId id="279" r:id="rId19"/>
    <p:sldId id="277" r:id="rId20"/>
    <p:sldId id="278" r:id="rId21"/>
    <p:sldId id="280" r:id="rId22"/>
    <p:sldId id="281" r:id="rId23"/>
    <p:sldId id="282" r:id="rId24"/>
    <p:sldId id="283" r:id="rId25"/>
    <p:sldId id="288" r:id="rId26"/>
    <p:sldId id="289" r:id="rId27"/>
    <p:sldId id="284" r:id="rId28"/>
    <p:sldId id="285" r:id="rId29"/>
    <p:sldId id="286" r:id="rId30"/>
    <p:sldId id="287" r:id="rId31"/>
    <p:sldId id="290" r:id="rId32"/>
    <p:sldId id="291" r:id="rId33"/>
    <p:sldId id="292" r:id="rId3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0" userDrawn="1">
          <p15:clr>
            <a:srgbClr val="A4A3A4"/>
          </p15:clr>
        </p15:guide>
        <p15:guide id="2" pos="66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04" autoAdjust="0"/>
    <p:restoredTop sz="95184" autoAdjust="0"/>
  </p:normalViewPr>
  <p:slideViewPr>
    <p:cSldViewPr snapToGrid="0" showGuides="1">
      <p:cViewPr varScale="1">
        <p:scale>
          <a:sx n="81" d="100"/>
          <a:sy n="81" d="100"/>
        </p:scale>
        <p:origin x="744" y="58"/>
      </p:cViewPr>
      <p:guideLst>
        <p:guide orient="horz" pos="210"/>
        <p:guide pos="665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ableStyles" Target="tableStyle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notesMaster" Target="notesMasters/notesMaster1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625B22-AC44-470C-B50B-4FAD4A8A8F21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4C8098-E70A-4D07-AEED-DF2F37087C2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4536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14C8098-E70A-4D07-AEED-DF2F37087C22}" type="slidenum">
              <a:rPr lang="zh-CN" altLang="en-US" smtClean="0"/>
              <a:t>2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0155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9E3B77-D455-48AB-96BC-D822DCBBA4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9D89C31-1246-A8F7-2AF9-FD1E311D14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6F8AB0-24BB-E5A3-0A60-EFBE5D2CA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DE392E-E25D-C4F2-10D6-3DD96E428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F6198E-1126-2AD5-C352-4792E3215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8394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769772-8BEA-F072-BA9F-4B90E87C29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80F5520-7F37-6B97-E407-E5F2011156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09C6341-056C-DE17-676D-48DA17E5F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4B2F40-B327-3B89-9986-FF209DB82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EBD663F-766B-1772-F6C0-D6A450C06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1842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08EA74-825A-4FEF-35CD-AE51166A6A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28339A9-69A4-48BA-5C86-0224D15BB4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D88470-6568-AF97-DC6C-DF4B5AFB3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202FE7-07C3-8239-0163-5E4C6276E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C282665-B753-D3EE-F474-412E46686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8702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8E38C7-D52B-92EB-A16D-37BE6D2A39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7F490D-23EC-B4D8-846D-A6FCE966BE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F977432-ABEF-F6C0-D655-C6099B329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647A57-9C86-B4D9-1156-1B0EF0BD1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DAF794-9FF4-0D82-426E-768E1A913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3288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7C2DA1-F9CE-7CCC-4D05-3B026F1CDB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A125CE-186E-77D1-0B1F-CDEECB8CCD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F42673C-43E1-F59E-FFE0-371EBC310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A66711-54C0-3FC3-F581-04460475D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77281A-AF22-E606-BA4E-4568D1456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0116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5D899F-1ADC-00CA-8AD8-FDEF2844A6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6A85C77-2EE5-39DE-343D-9A23DE44FF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83CF7C3-7A4A-A9B3-09FA-BF50AABCCE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C4EA81-AA7D-307F-9BD8-F0D058C15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2526516-B21E-6957-8748-BC6DF9F66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3530109-45D6-C07E-9D91-C26D8282E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850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CD25DC-220F-C862-7A9A-50945B90A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CD1E208-9516-79CC-F1B6-BA18F6DE37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010C8E3-CB48-0588-42CB-21B2AC910D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8BD6059-88A4-DB56-7FE0-5B4C814DBA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83997FD-A607-6E06-D047-4F36DA63AA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20E391B-5F87-CF71-2D14-0392AF366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6DA74B9-C1F4-E121-F7A7-EF2FF17D5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4A273E2-0366-1D14-127D-57F93ECF5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9508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A309F8-168A-08AA-D149-94ACC71501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025442E-5794-F5C7-6B85-5068E01C7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9F745FF-7396-B517-A1A9-8B28377B3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8296709-A98B-BF48-DBBB-2ECA74544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7442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F04A98B-D610-0AD2-7DE4-A5EE09B72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1B7BA23-8FA2-E622-581B-75B080524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01D1F75-AD2D-B8CA-0615-0C76E5F7D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5584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0E3288-DF18-D0CF-A114-6D4D707A7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58EB56-DCD5-6D10-95A4-C0CE91F9E3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06C8B61-0A9A-F854-4666-7BBD38B35D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E0D6A2D-88EF-65B8-8792-7123F1290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B786AB-A103-0FCA-6A16-B1FE35269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E94AB3D-05A9-CD76-C96B-6C8FD0E28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095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272945-4B85-CA36-436A-4F120BDB99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1AEDB4-5499-69AB-DA5F-ADB29A1A26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AEDEFE9-A8B3-9090-1822-A4C166D9A7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EBF1751-A852-D533-BC4E-78D52BDC7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6184BF-5E21-08CC-1C6E-BCF1EE76D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B77534F-CB5F-128F-BADC-3A1A0C859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053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111F8A8-C032-F7EC-EDD6-27D8A8226B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B9846C2-DF68-1481-0BC6-A794632437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68C298-91AF-D4AF-86DC-166482A83C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135D2-A59F-4990-8874-E0C45CAB3418}" type="datetimeFigureOut">
              <a:rPr lang="zh-CN" altLang="en-US" smtClean="0"/>
              <a:t>2025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0F3EB8-24DF-6459-CB76-3F88F0E9A5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46B7C2-0EFC-F5EC-E9D0-1E001084E7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34FCF-6AB2-49A2-9128-AE503FC974A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0386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jpg"/><Relationship Id="rId3" Type="http://schemas.openxmlformats.org/officeDocument/2006/relationships/image" Target="../media/image32.jpg"/><Relationship Id="rId7" Type="http://schemas.openxmlformats.org/officeDocument/2006/relationships/image" Target="../media/image36.jp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5.jpg"/><Relationship Id="rId5" Type="http://schemas.openxmlformats.org/officeDocument/2006/relationships/image" Target="../media/image34.jpg"/><Relationship Id="rId10" Type="http://schemas.openxmlformats.org/officeDocument/2006/relationships/image" Target="../media/image39.jpg"/><Relationship Id="rId4" Type="http://schemas.openxmlformats.org/officeDocument/2006/relationships/image" Target="../media/image33.jpg"/><Relationship Id="rId9" Type="http://schemas.openxmlformats.org/officeDocument/2006/relationships/image" Target="../media/image38.jp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jpg"/><Relationship Id="rId3" Type="http://schemas.openxmlformats.org/officeDocument/2006/relationships/image" Target="../media/image41.jpg"/><Relationship Id="rId7" Type="http://schemas.openxmlformats.org/officeDocument/2006/relationships/image" Target="../media/image45.jpg"/><Relationship Id="rId2" Type="http://schemas.openxmlformats.org/officeDocument/2006/relationships/image" Target="../media/image4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4.jpg"/><Relationship Id="rId5" Type="http://schemas.openxmlformats.org/officeDocument/2006/relationships/image" Target="../media/image43.jpg"/><Relationship Id="rId4" Type="http://schemas.openxmlformats.org/officeDocument/2006/relationships/image" Target="../media/image42.jp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jpg"/><Relationship Id="rId3" Type="http://schemas.openxmlformats.org/officeDocument/2006/relationships/image" Target="../media/image48.jpg"/><Relationship Id="rId7" Type="http://schemas.openxmlformats.org/officeDocument/2006/relationships/image" Target="../media/image52.jpg"/><Relationship Id="rId2" Type="http://schemas.openxmlformats.org/officeDocument/2006/relationships/image" Target="../media/image47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1.jpg"/><Relationship Id="rId5" Type="http://schemas.openxmlformats.org/officeDocument/2006/relationships/image" Target="../media/image50.jpg"/><Relationship Id="rId4" Type="http://schemas.openxmlformats.org/officeDocument/2006/relationships/image" Target="../media/image49.jp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jpg"/><Relationship Id="rId2" Type="http://schemas.openxmlformats.org/officeDocument/2006/relationships/image" Target="../media/image54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7.jpg"/><Relationship Id="rId4" Type="http://schemas.openxmlformats.org/officeDocument/2006/relationships/image" Target="../media/image56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jpg"/><Relationship Id="rId2" Type="http://schemas.openxmlformats.org/officeDocument/2006/relationships/image" Target="../media/image5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2.jpg"/><Relationship Id="rId5" Type="http://schemas.openxmlformats.org/officeDocument/2006/relationships/image" Target="../media/image61.jpg"/><Relationship Id="rId4" Type="http://schemas.openxmlformats.org/officeDocument/2006/relationships/image" Target="../media/image60.jp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jpg"/><Relationship Id="rId2" Type="http://schemas.openxmlformats.org/officeDocument/2006/relationships/image" Target="../media/image63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5.jp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jpg"/><Relationship Id="rId2" Type="http://schemas.openxmlformats.org/officeDocument/2006/relationships/image" Target="../media/image66.jp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jpg"/><Relationship Id="rId7" Type="http://schemas.openxmlformats.org/officeDocument/2006/relationships/image" Target="../media/image73.jpg"/><Relationship Id="rId2" Type="http://schemas.openxmlformats.org/officeDocument/2006/relationships/image" Target="../media/image6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2.jpg"/><Relationship Id="rId5" Type="http://schemas.openxmlformats.org/officeDocument/2006/relationships/image" Target="../media/image71.jpg"/><Relationship Id="rId4" Type="http://schemas.openxmlformats.org/officeDocument/2006/relationships/image" Target="../media/image70.jp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jpg"/><Relationship Id="rId2" Type="http://schemas.openxmlformats.org/officeDocument/2006/relationships/image" Target="../media/image74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7.jpg"/><Relationship Id="rId4" Type="http://schemas.openxmlformats.org/officeDocument/2006/relationships/image" Target="../media/image76.jp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jpg"/><Relationship Id="rId2" Type="http://schemas.openxmlformats.org/officeDocument/2006/relationships/image" Target="../media/image78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0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jpg"/><Relationship Id="rId2" Type="http://schemas.openxmlformats.org/officeDocument/2006/relationships/image" Target="../media/image81.jp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jpg"/><Relationship Id="rId2" Type="http://schemas.openxmlformats.org/officeDocument/2006/relationships/image" Target="../media/image83.jp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jp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jpeg"/><Relationship Id="rId2" Type="http://schemas.openxmlformats.org/officeDocument/2006/relationships/image" Target="../media/image85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7.jpe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3.jpg"/><Relationship Id="rId3" Type="http://schemas.openxmlformats.org/officeDocument/2006/relationships/image" Target="../media/image88.jpg"/><Relationship Id="rId7" Type="http://schemas.openxmlformats.org/officeDocument/2006/relationships/image" Target="../media/image92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1.jpg"/><Relationship Id="rId5" Type="http://schemas.openxmlformats.org/officeDocument/2006/relationships/image" Target="../media/image90.jpg"/><Relationship Id="rId4" Type="http://schemas.openxmlformats.org/officeDocument/2006/relationships/image" Target="../media/image89.jpg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0.jpg"/><Relationship Id="rId3" Type="http://schemas.openxmlformats.org/officeDocument/2006/relationships/image" Target="../media/image95.jpg"/><Relationship Id="rId7" Type="http://schemas.openxmlformats.org/officeDocument/2006/relationships/image" Target="../media/image99.jpg"/><Relationship Id="rId2" Type="http://schemas.openxmlformats.org/officeDocument/2006/relationships/image" Target="../media/image94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8.jpg"/><Relationship Id="rId5" Type="http://schemas.openxmlformats.org/officeDocument/2006/relationships/image" Target="../media/image97.jpg"/><Relationship Id="rId10" Type="http://schemas.openxmlformats.org/officeDocument/2006/relationships/image" Target="../media/image102.jpg"/><Relationship Id="rId4" Type="http://schemas.openxmlformats.org/officeDocument/2006/relationships/image" Target="../media/image96.jpg"/><Relationship Id="rId9" Type="http://schemas.openxmlformats.org/officeDocument/2006/relationships/image" Target="../media/image101.jp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jpg"/><Relationship Id="rId2" Type="http://schemas.openxmlformats.org/officeDocument/2006/relationships/image" Target="../media/image103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7.jpg"/><Relationship Id="rId5" Type="http://schemas.openxmlformats.org/officeDocument/2006/relationships/image" Target="../media/image106.jpg"/><Relationship Id="rId4" Type="http://schemas.openxmlformats.org/officeDocument/2006/relationships/image" Target="../media/image105.jpg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4.jpg"/><Relationship Id="rId3" Type="http://schemas.openxmlformats.org/officeDocument/2006/relationships/image" Target="../media/image109.jpg"/><Relationship Id="rId7" Type="http://schemas.openxmlformats.org/officeDocument/2006/relationships/image" Target="../media/image113.jpg"/><Relationship Id="rId2" Type="http://schemas.openxmlformats.org/officeDocument/2006/relationships/image" Target="../media/image10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2.jpg"/><Relationship Id="rId5" Type="http://schemas.openxmlformats.org/officeDocument/2006/relationships/image" Target="../media/image111.jpg"/><Relationship Id="rId4" Type="http://schemas.openxmlformats.org/officeDocument/2006/relationships/image" Target="../media/image110.jp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6.jpg"/><Relationship Id="rId2" Type="http://schemas.openxmlformats.org/officeDocument/2006/relationships/image" Target="../media/image115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7.jp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7.jpg"/><Relationship Id="rId2" Type="http://schemas.openxmlformats.org/officeDocument/2006/relationships/image" Target="../media/image116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8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jp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0.jpg"/><Relationship Id="rId2" Type="http://schemas.openxmlformats.org/officeDocument/2006/relationships/image" Target="../media/image119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1.jp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3.jpg"/><Relationship Id="rId2" Type="http://schemas.openxmlformats.org/officeDocument/2006/relationships/image" Target="../media/image122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6.jpg"/><Relationship Id="rId5" Type="http://schemas.openxmlformats.org/officeDocument/2006/relationships/image" Target="../media/image125.jpg"/><Relationship Id="rId4" Type="http://schemas.openxmlformats.org/officeDocument/2006/relationships/image" Target="../media/image124.jp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jpg"/><Relationship Id="rId2" Type="http://schemas.openxmlformats.org/officeDocument/2006/relationships/image" Target="../media/image82.jp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8.jpg"/><Relationship Id="rId2" Type="http://schemas.openxmlformats.org/officeDocument/2006/relationships/image" Target="../media/image127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jpg"/><Relationship Id="rId5" Type="http://schemas.openxmlformats.org/officeDocument/2006/relationships/image" Target="../media/image18.jpg"/><Relationship Id="rId4" Type="http://schemas.openxmlformats.org/officeDocument/2006/relationships/image" Target="../media/image17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3.jpg"/><Relationship Id="rId4" Type="http://schemas.openxmlformats.org/officeDocument/2006/relationships/image" Target="../media/image22.jp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g"/><Relationship Id="rId3" Type="http://schemas.openxmlformats.org/officeDocument/2006/relationships/image" Target="../media/image25.jpg"/><Relationship Id="rId7" Type="http://schemas.openxmlformats.org/officeDocument/2006/relationships/image" Target="../media/image29.jpg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8.jpg"/><Relationship Id="rId5" Type="http://schemas.openxmlformats.org/officeDocument/2006/relationships/image" Target="../media/image27.jpg"/><Relationship Id="rId4" Type="http://schemas.openxmlformats.org/officeDocument/2006/relationships/image" Target="../media/image2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486710" y="2836561"/>
            <a:ext cx="531786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aw data of Western blot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74598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2572A04-1BB9-D6F3-8ABB-11042E319D5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203DCD04-EFB2-8DB1-EB1A-B4D9C99569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6194" y="385995"/>
            <a:ext cx="2347163" cy="323116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61E1804-5135-54B6-CA1E-0780768E43AD}"/>
              </a:ext>
            </a:extLst>
          </p:cNvPr>
          <p:cNvSpPr txBox="1"/>
          <p:nvPr/>
        </p:nvSpPr>
        <p:spPr>
          <a:xfrm>
            <a:off x="156987" y="116034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C354FE1-4C8E-B7B9-8B72-9D11D803D9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81216" y="805538"/>
            <a:ext cx="2026700" cy="278333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94A33A6-E5A9-AB49-1F90-FD568102D0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9583" y="3709541"/>
            <a:ext cx="2050420" cy="281591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FD45CAC-1919-5C7C-25EC-4F832C11EE7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4354" y="655307"/>
            <a:ext cx="1925352" cy="264415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8D6CE22-84B6-ED1B-3213-8CAF0C84A83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9651" y="617777"/>
            <a:ext cx="1978420" cy="2717031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9DD40ECF-9281-E11C-771E-DA06F9C42CD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5073" y="544587"/>
            <a:ext cx="1925352" cy="264415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1DEDB58E-03A5-9C30-F065-0ADF603F391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5474" y="3775845"/>
            <a:ext cx="2070353" cy="2843285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BE70ACC1-13EB-788D-C1F7-173588D773F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6898" y="3775845"/>
            <a:ext cx="1978420" cy="2717031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E62AB132-7D9D-DD2D-239C-F2D8A2EFA70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4268" y="3709541"/>
            <a:ext cx="2026700" cy="2783335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58994639-35FA-77D1-40F4-3DC29EFC2DCC}"/>
              </a:ext>
            </a:extLst>
          </p:cNvPr>
          <p:cNvSpPr/>
          <p:nvPr/>
        </p:nvSpPr>
        <p:spPr>
          <a:xfrm>
            <a:off x="6248777" y="2104291"/>
            <a:ext cx="758204" cy="1239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F5C1A8B-EEB5-5A9F-7E07-B3DA274AFD59}"/>
              </a:ext>
            </a:extLst>
          </p:cNvPr>
          <p:cNvSpPr txBox="1"/>
          <p:nvPr/>
        </p:nvSpPr>
        <p:spPr>
          <a:xfrm>
            <a:off x="7077738" y="2039105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7972793-D32B-6AA1-81A5-C99865A47197}"/>
              </a:ext>
            </a:extLst>
          </p:cNvPr>
          <p:cNvSpPr txBox="1"/>
          <p:nvPr/>
        </p:nvSpPr>
        <p:spPr>
          <a:xfrm>
            <a:off x="5759564" y="2031410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F7B3830D-C7CD-D86B-82E6-D1DCFCFFA878}"/>
              </a:ext>
            </a:extLst>
          </p:cNvPr>
          <p:cNvSpPr/>
          <p:nvPr/>
        </p:nvSpPr>
        <p:spPr>
          <a:xfrm>
            <a:off x="2092183" y="2030721"/>
            <a:ext cx="758204" cy="1949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DDCAFE9-6D8A-78F2-E5E4-3C26FBDF5C25}"/>
              </a:ext>
            </a:extLst>
          </p:cNvPr>
          <p:cNvSpPr txBox="1"/>
          <p:nvPr/>
        </p:nvSpPr>
        <p:spPr>
          <a:xfrm>
            <a:off x="2921144" y="2001575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22AC0E2-6813-FD5D-E687-BF01CF4750DF}"/>
              </a:ext>
            </a:extLst>
          </p:cNvPr>
          <p:cNvSpPr txBox="1"/>
          <p:nvPr/>
        </p:nvSpPr>
        <p:spPr>
          <a:xfrm>
            <a:off x="1602970" y="199388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4C1A0C4D-A8A0-687C-8CA2-35CAD12555E2}"/>
              </a:ext>
            </a:extLst>
          </p:cNvPr>
          <p:cNvSpPr/>
          <p:nvPr/>
        </p:nvSpPr>
        <p:spPr>
          <a:xfrm>
            <a:off x="2152966" y="5226087"/>
            <a:ext cx="554433" cy="634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9200E8B-4A0B-DF56-FA40-56022F7F6E95}"/>
              </a:ext>
            </a:extLst>
          </p:cNvPr>
          <p:cNvSpPr txBox="1"/>
          <p:nvPr/>
        </p:nvSpPr>
        <p:spPr>
          <a:xfrm>
            <a:off x="2704114" y="5125599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23D29F3-14CC-16E7-07A8-C242F1E54C76}"/>
              </a:ext>
            </a:extLst>
          </p:cNvPr>
          <p:cNvSpPr txBox="1"/>
          <p:nvPr/>
        </p:nvSpPr>
        <p:spPr>
          <a:xfrm>
            <a:off x="1618564" y="5135901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D172337F-5F12-2A9B-851D-1315AA3D138C}"/>
              </a:ext>
            </a:extLst>
          </p:cNvPr>
          <p:cNvSpPr/>
          <p:nvPr/>
        </p:nvSpPr>
        <p:spPr>
          <a:xfrm>
            <a:off x="4062301" y="2057868"/>
            <a:ext cx="648582" cy="1543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386F2FF-C510-18E5-7914-EFC5F75EF21A}"/>
              </a:ext>
            </a:extLst>
          </p:cNvPr>
          <p:cNvSpPr txBox="1"/>
          <p:nvPr/>
        </p:nvSpPr>
        <p:spPr>
          <a:xfrm>
            <a:off x="4722248" y="2015856"/>
            <a:ext cx="7922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G-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D5046EA-A7A2-0DB3-DF9A-62D93532C4AE}"/>
              </a:ext>
            </a:extLst>
          </p:cNvPr>
          <p:cNvSpPr txBox="1"/>
          <p:nvPr/>
        </p:nvSpPr>
        <p:spPr>
          <a:xfrm>
            <a:off x="3530869" y="203935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AB74BC6C-E7B9-5259-833A-5FD79AB8324A}"/>
              </a:ext>
            </a:extLst>
          </p:cNvPr>
          <p:cNvSpPr/>
          <p:nvPr/>
        </p:nvSpPr>
        <p:spPr>
          <a:xfrm>
            <a:off x="10611681" y="2090883"/>
            <a:ext cx="758204" cy="1239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C6986B00-F882-04BA-AAA6-B3A36532E051}"/>
              </a:ext>
            </a:extLst>
          </p:cNvPr>
          <p:cNvSpPr txBox="1"/>
          <p:nvPr/>
        </p:nvSpPr>
        <p:spPr>
          <a:xfrm>
            <a:off x="11440642" y="2025697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648381C-7BDC-138B-637A-065F0DDB4FCD}"/>
              </a:ext>
            </a:extLst>
          </p:cNvPr>
          <p:cNvSpPr txBox="1"/>
          <p:nvPr/>
        </p:nvSpPr>
        <p:spPr>
          <a:xfrm>
            <a:off x="10122468" y="201800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75C177BD-21C2-9EFA-B3AE-8226A288EA85}"/>
              </a:ext>
            </a:extLst>
          </p:cNvPr>
          <p:cNvSpPr/>
          <p:nvPr/>
        </p:nvSpPr>
        <p:spPr>
          <a:xfrm>
            <a:off x="4295532" y="5343650"/>
            <a:ext cx="758204" cy="1239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B1A09B3-024E-D933-2AC2-EA8AE18FA9A3}"/>
              </a:ext>
            </a:extLst>
          </p:cNvPr>
          <p:cNvSpPr txBox="1"/>
          <p:nvPr/>
        </p:nvSpPr>
        <p:spPr>
          <a:xfrm>
            <a:off x="5116979" y="5261168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607BCC93-6DAB-A9B3-06AD-5FDB1D9049C2}"/>
              </a:ext>
            </a:extLst>
          </p:cNvPr>
          <p:cNvSpPr txBox="1"/>
          <p:nvPr/>
        </p:nvSpPr>
        <p:spPr>
          <a:xfrm>
            <a:off x="3798805" y="5253473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B3E938ED-CC89-2E52-F733-48E974A4ED2C}"/>
              </a:ext>
            </a:extLst>
          </p:cNvPr>
          <p:cNvSpPr/>
          <p:nvPr/>
        </p:nvSpPr>
        <p:spPr>
          <a:xfrm>
            <a:off x="6996272" y="5072438"/>
            <a:ext cx="758204" cy="1239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3A5274A-3055-BF8A-9EBF-19F23944A8BF}"/>
              </a:ext>
            </a:extLst>
          </p:cNvPr>
          <p:cNvSpPr txBox="1"/>
          <p:nvPr/>
        </p:nvSpPr>
        <p:spPr>
          <a:xfrm>
            <a:off x="7744265" y="5002489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BA821D6A-8AE3-3058-45B5-AEB1CC720363}"/>
              </a:ext>
            </a:extLst>
          </p:cNvPr>
          <p:cNvSpPr txBox="1"/>
          <p:nvPr/>
        </p:nvSpPr>
        <p:spPr>
          <a:xfrm>
            <a:off x="6478481" y="5004320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315C0973-1D78-E1B1-3EE3-9D3C4315C1DF}"/>
              </a:ext>
            </a:extLst>
          </p:cNvPr>
          <p:cNvSpPr/>
          <p:nvPr/>
        </p:nvSpPr>
        <p:spPr>
          <a:xfrm>
            <a:off x="9976342" y="5226087"/>
            <a:ext cx="591670" cy="1239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DE40FDA-6733-C998-EA69-437D4ADB804C}"/>
              </a:ext>
            </a:extLst>
          </p:cNvPr>
          <p:cNvSpPr txBox="1"/>
          <p:nvPr/>
        </p:nvSpPr>
        <p:spPr>
          <a:xfrm>
            <a:off x="10568012" y="5159385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0BFEDF4-0BBC-5433-4FB1-17A3E408AB21}"/>
              </a:ext>
            </a:extLst>
          </p:cNvPr>
          <p:cNvSpPr txBox="1"/>
          <p:nvPr/>
        </p:nvSpPr>
        <p:spPr>
          <a:xfrm>
            <a:off x="9350124" y="5175387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6F8F9C23-BFFE-281E-1B59-8DBAB930449D}"/>
              </a:ext>
            </a:extLst>
          </p:cNvPr>
          <p:cNvSpPr/>
          <p:nvPr/>
        </p:nvSpPr>
        <p:spPr>
          <a:xfrm>
            <a:off x="8499697" y="2082722"/>
            <a:ext cx="758204" cy="1239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A6A17F40-A802-8699-89AB-825F178987A8}"/>
              </a:ext>
            </a:extLst>
          </p:cNvPr>
          <p:cNvSpPr txBox="1"/>
          <p:nvPr/>
        </p:nvSpPr>
        <p:spPr>
          <a:xfrm>
            <a:off x="9252455" y="2003346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1242E045-2008-9A7C-DF8D-C3EAE7CA52FE}"/>
              </a:ext>
            </a:extLst>
          </p:cNvPr>
          <p:cNvSpPr txBox="1"/>
          <p:nvPr/>
        </p:nvSpPr>
        <p:spPr>
          <a:xfrm>
            <a:off x="7977143" y="2009940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3EFB905-A500-E0EB-2392-815151EC5C06}"/>
              </a:ext>
            </a:extLst>
          </p:cNvPr>
          <p:cNvSpPr txBox="1"/>
          <p:nvPr/>
        </p:nvSpPr>
        <p:spPr>
          <a:xfrm>
            <a:off x="595406" y="1870251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3">
            <a:extLst>
              <a:ext uri="{FF2B5EF4-FFF2-40B4-BE49-F238E27FC236}">
                <a16:creationId xmlns:a16="http://schemas.microsoft.com/office/drawing/2014/main" id="{02E8B957-5A2C-AA37-E22F-70FE27B93ABF}"/>
              </a:ext>
            </a:extLst>
          </p:cNvPr>
          <p:cNvSpPr txBox="1"/>
          <p:nvPr/>
        </p:nvSpPr>
        <p:spPr>
          <a:xfrm>
            <a:off x="654036" y="4446583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2104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3B12C3-560F-6B4C-D1BD-6E09982BAA5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3899A44-0E42-B0FA-1691-E1551C2439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7559" y="248356"/>
            <a:ext cx="2687491" cy="369082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1C69941-35F9-20BD-E688-2C9291544B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415532">
            <a:off x="8867763" y="189190"/>
            <a:ext cx="2687491" cy="369082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FA49AA8-49D3-CC47-4ACB-9669D351DDB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556" y="201729"/>
            <a:ext cx="2687491" cy="369082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9EA8319-A0CE-9C3D-7C57-9872CB1D60D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6477" y="82950"/>
            <a:ext cx="2687491" cy="3690821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7A9BE980-5E0A-FE38-0BB0-4FA7B6F34FF1}"/>
              </a:ext>
            </a:extLst>
          </p:cNvPr>
          <p:cNvSpPr/>
          <p:nvPr/>
        </p:nvSpPr>
        <p:spPr>
          <a:xfrm>
            <a:off x="1598353" y="2316771"/>
            <a:ext cx="828961" cy="139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114B496-1402-3F5E-A2BB-06E0CC7C4CEC}"/>
              </a:ext>
            </a:extLst>
          </p:cNvPr>
          <p:cNvSpPr txBox="1"/>
          <p:nvPr/>
        </p:nvSpPr>
        <p:spPr>
          <a:xfrm>
            <a:off x="2388817" y="2255973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C77D6DC-4FA2-1B14-4E67-4DB98D6B1995}"/>
              </a:ext>
            </a:extLst>
          </p:cNvPr>
          <p:cNvSpPr txBox="1"/>
          <p:nvPr/>
        </p:nvSpPr>
        <p:spPr>
          <a:xfrm>
            <a:off x="1088996" y="2253766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32D1E6A9-754F-DC06-70A3-527B922A2A7B}"/>
              </a:ext>
            </a:extLst>
          </p:cNvPr>
          <p:cNvSpPr/>
          <p:nvPr/>
        </p:nvSpPr>
        <p:spPr>
          <a:xfrm>
            <a:off x="4336898" y="2037689"/>
            <a:ext cx="775868" cy="4188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BC0B158-EDEB-51E0-95AC-123DDAD08CA3}"/>
              </a:ext>
            </a:extLst>
          </p:cNvPr>
          <p:cNvSpPr txBox="1"/>
          <p:nvPr/>
        </p:nvSpPr>
        <p:spPr>
          <a:xfrm>
            <a:off x="5130398" y="2113638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001A6E0A-3758-7CDB-4FF6-421D81642354}"/>
              </a:ext>
            </a:extLst>
          </p:cNvPr>
          <p:cNvSpPr/>
          <p:nvPr/>
        </p:nvSpPr>
        <p:spPr>
          <a:xfrm>
            <a:off x="7077076" y="2051761"/>
            <a:ext cx="757580" cy="4047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C70974C-1B08-8741-5A1D-E295E9FDAA58}"/>
              </a:ext>
            </a:extLst>
          </p:cNvPr>
          <p:cNvSpPr txBox="1"/>
          <p:nvPr/>
        </p:nvSpPr>
        <p:spPr>
          <a:xfrm>
            <a:off x="7790174" y="225376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D280832B-7D22-FF7C-CDCF-1E99C39208B1}"/>
              </a:ext>
            </a:extLst>
          </p:cNvPr>
          <p:cNvSpPr/>
          <p:nvPr/>
        </p:nvSpPr>
        <p:spPr>
          <a:xfrm>
            <a:off x="9727609" y="2743746"/>
            <a:ext cx="828961" cy="139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B1A328C-F1B8-5FFD-6C95-A9E477764A3F}"/>
              </a:ext>
            </a:extLst>
          </p:cNvPr>
          <p:cNvSpPr txBox="1"/>
          <p:nvPr/>
        </p:nvSpPr>
        <p:spPr>
          <a:xfrm>
            <a:off x="10518073" y="2682948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3CF017F-F314-33FD-BA50-1255F6DBDD30}"/>
              </a:ext>
            </a:extLst>
          </p:cNvPr>
          <p:cNvSpPr txBox="1"/>
          <p:nvPr/>
        </p:nvSpPr>
        <p:spPr>
          <a:xfrm>
            <a:off x="9265882" y="2680741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43EC5BC4-4026-2DCD-8ADF-C77F2C20B4F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027" y="3129721"/>
            <a:ext cx="2687491" cy="3690821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D821FC08-96F8-C817-1C3A-BA794BCA66C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1612" y="3083488"/>
            <a:ext cx="2687491" cy="3690821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3E02761F-B2FB-2DC4-31DF-911E14BABBC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309075">
            <a:off x="5943464" y="3013356"/>
            <a:ext cx="2687491" cy="3690821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858C9F96-96D1-E0CD-9A82-7A709C4D341D}"/>
              </a:ext>
            </a:extLst>
          </p:cNvPr>
          <p:cNvSpPr txBox="1"/>
          <p:nvPr/>
        </p:nvSpPr>
        <p:spPr>
          <a:xfrm>
            <a:off x="166104" y="4310429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j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032D2AF0-F681-F71D-15B9-B05E17B845D4}"/>
              </a:ext>
            </a:extLst>
          </p:cNvPr>
          <p:cNvSpPr/>
          <p:nvPr/>
        </p:nvSpPr>
        <p:spPr>
          <a:xfrm>
            <a:off x="1426903" y="5333661"/>
            <a:ext cx="828961" cy="139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30358DE2-D50A-7544-4D74-0C2E9CAB2650}"/>
              </a:ext>
            </a:extLst>
          </p:cNvPr>
          <p:cNvSpPr txBox="1"/>
          <p:nvPr/>
        </p:nvSpPr>
        <p:spPr>
          <a:xfrm>
            <a:off x="2217367" y="5272863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E816A110-DBFF-2EC9-5C66-DE7536B2E2E7}"/>
              </a:ext>
            </a:extLst>
          </p:cNvPr>
          <p:cNvSpPr txBox="1"/>
          <p:nvPr/>
        </p:nvSpPr>
        <p:spPr>
          <a:xfrm>
            <a:off x="917546" y="5270656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EE9DAB65-E1AC-9229-AFB0-248FBF47ABF1}"/>
              </a:ext>
            </a:extLst>
          </p:cNvPr>
          <p:cNvSpPr/>
          <p:nvPr/>
        </p:nvSpPr>
        <p:spPr>
          <a:xfrm>
            <a:off x="4386312" y="4969799"/>
            <a:ext cx="758204" cy="2718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57DA788-4553-D056-2F10-45BE85324CC3}"/>
              </a:ext>
            </a:extLst>
          </p:cNvPr>
          <p:cNvSpPr txBox="1"/>
          <p:nvPr/>
        </p:nvSpPr>
        <p:spPr>
          <a:xfrm>
            <a:off x="5162148" y="5041628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3DF5D8BD-0847-F471-490B-7605EAC40E60}"/>
              </a:ext>
            </a:extLst>
          </p:cNvPr>
          <p:cNvSpPr txBox="1"/>
          <p:nvPr/>
        </p:nvSpPr>
        <p:spPr>
          <a:xfrm>
            <a:off x="3972621" y="498032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3B35267-A63B-6623-9E43-56724325D6AA}"/>
              </a:ext>
            </a:extLst>
          </p:cNvPr>
          <p:cNvSpPr txBox="1"/>
          <p:nvPr/>
        </p:nvSpPr>
        <p:spPr>
          <a:xfrm>
            <a:off x="3972621" y="5086198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366657DC-13E4-84F9-A07F-4C27DEFF5B95}"/>
              </a:ext>
            </a:extLst>
          </p:cNvPr>
          <p:cNvSpPr/>
          <p:nvPr/>
        </p:nvSpPr>
        <p:spPr>
          <a:xfrm>
            <a:off x="6900863" y="5160726"/>
            <a:ext cx="765391" cy="3126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227F298-CBAB-53AE-2AC1-F6360542211E}"/>
              </a:ext>
            </a:extLst>
          </p:cNvPr>
          <p:cNvSpPr txBox="1"/>
          <p:nvPr/>
        </p:nvSpPr>
        <p:spPr>
          <a:xfrm>
            <a:off x="7675874" y="523255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E709B4CD-36DD-4B4A-58D0-3E076CDA4331}"/>
              </a:ext>
            </a:extLst>
          </p:cNvPr>
          <p:cNvSpPr txBox="1"/>
          <p:nvPr/>
        </p:nvSpPr>
        <p:spPr>
          <a:xfrm>
            <a:off x="6454700" y="520930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501A2933-3FB0-2145-E142-12AD72E8F77D}"/>
              </a:ext>
            </a:extLst>
          </p:cNvPr>
          <p:cNvSpPr txBox="1"/>
          <p:nvPr/>
        </p:nvSpPr>
        <p:spPr>
          <a:xfrm>
            <a:off x="6454701" y="5355666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46">
            <a:extLst>
              <a:ext uri="{FF2B5EF4-FFF2-40B4-BE49-F238E27FC236}">
                <a16:creationId xmlns:a16="http://schemas.microsoft.com/office/drawing/2014/main" id="{E709B4CD-36DD-4B4A-58D0-3E076CDA4331}"/>
              </a:ext>
            </a:extLst>
          </p:cNvPr>
          <p:cNvSpPr txBox="1"/>
          <p:nvPr/>
        </p:nvSpPr>
        <p:spPr>
          <a:xfrm>
            <a:off x="6628920" y="2058886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47">
            <a:extLst>
              <a:ext uri="{FF2B5EF4-FFF2-40B4-BE49-F238E27FC236}">
                <a16:creationId xmlns:a16="http://schemas.microsoft.com/office/drawing/2014/main" id="{501A2933-3FB0-2145-E142-12AD72E8F77D}"/>
              </a:ext>
            </a:extLst>
          </p:cNvPr>
          <p:cNvSpPr txBox="1"/>
          <p:nvPr/>
        </p:nvSpPr>
        <p:spPr>
          <a:xfrm>
            <a:off x="6628920" y="223202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17A21AEA-7C7D-C383-E4FC-88EA8EABBF32}"/>
              </a:ext>
            </a:extLst>
          </p:cNvPr>
          <p:cNvSpPr txBox="1"/>
          <p:nvPr/>
        </p:nvSpPr>
        <p:spPr>
          <a:xfrm>
            <a:off x="271576" y="179943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i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46">
            <a:extLst>
              <a:ext uri="{FF2B5EF4-FFF2-40B4-BE49-F238E27FC236}">
                <a16:creationId xmlns:a16="http://schemas.microsoft.com/office/drawing/2014/main" id="{E709B4CD-36DD-4B4A-58D0-3E076CDA4331}"/>
              </a:ext>
            </a:extLst>
          </p:cNvPr>
          <p:cNvSpPr txBox="1"/>
          <p:nvPr/>
        </p:nvSpPr>
        <p:spPr>
          <a:xfrm>
            <a:off x="3909634" y="203530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47">
            <a:extLst>
              <a:ext uri="{FF2B5EF4-FFF2-40B4-BE49-F238E27FC236}">
                <a16:creationId xmlns:a16="http://schemas.microsoft.com/office/drawing/2014/main" id="{501A2933-3FB0-2145-E142-12AD72E8F77D}"/>
              </a:ext>
            </a:extLst>
          </p:cNvPr>
          <p:cNvSpPr txBox="1"/>
          <p:nvPr/>
        </p:nvSpPr>
        <p:spPr>
          <a:xfrm>
            <a:off x="3909634" y="220843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454409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90F72D-E30A-DCCF-0A45-ECF8242D342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4D80C11-4828-00C2-C917-F4EFCE9E6FAB}"/>
              </a:ext>
            </a:extLst>
          </p:cNvPr>
          <p:cNvSpPr txBox="1"/>
          <p:nvPr/>
        </p:nvSpPr>
        <p:spPr>
          <a:xfrm>
            <a:off x="158560" y="128964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k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722C8F8-7AB8-7B33-4C32-1CAA57195B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5409" y="549275"/>
            <a:ext cx="2321470" cy="318815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90E6F80-A925-7854-1214-A5F632E8EB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061" y="549275"/>
            <a:ext cx="2321470" cy="318815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913F91E-CE18-2475-F424-71AC86E354E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2566" y="549275"/>
            <a:ext cx="2321470" cy="318815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87BE7D9-E9AA-D24C-7689-629B411898D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9136" y="549275"/>
            <a:ext cx="2321470" cy="3188153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234BFDBE-515C-0E9A-639A-DD7870A4CAA5}"/>
              </a:ext>
            </a:extLst>
          </p:cNvPr>
          <p:cNvSpPr/>
          <p:nvPr/>
        </p:nvSpPr>
        <p:spPr>
          <a:xfrm>
            <a:off x="1546609" y="2170721"/>
            <a:ext cx="828961" cy="139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DB4960F-22D3-69C2-375F-3721DA9F9B68}"/>
              </a:ext>
            </a:extLst>
          </p:cNvPr>
          <p:cNvSpPr txBox="1"/>
          <p:nvPr/>
        </p:nvSpPr>
        <p:spPr>
          <a:xfrm>
            <a:off x="2337073" y="2109923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5CB6D4D-8B77-CBC8-A859-8164737519BB}"/>
              </a:ext>
            </a:extLst>
          </p:cNvPr>
          <p:cNvSpPr txBox="1"/>
          <p:nvPr/>
        </p:nvSpPr>
        <p:spPr>
          <a:xfrm>
            <a:off x="1037252" y="2107716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566E7D09-AA7F-D7F2-D789-AC1F8B221160}"/>
              </a:ext>
            </a:extLst>
          </p:cNvPr>
          <p:cNvSpPr/>
          <p:nvPr/>
        </p:nvSpPr>
        <p:spPr>
          <a:xfrm>
            <a:off x="4359968" y="1857659"/>
            <a:ext cx="758204" cy="4962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63C9429-288B-9AFE-97D4-89E18B0AD41F}"/>
              </a:ext>
            </a:extLst>
          </p:cNvPr>
          <p:cNvSpPr txBox="1"/>
          <p:nvPr/>
        </p:nvSpPr>
        <p:spPr>
          <a:xfrm>
            <a:off x="5135804" y="1929488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40BE7D3-C910-A08D-1453-7770D742D07B}"/>
              </a:ext>
            </a:extLst>
          </p:cNvPr>
          <p:cNvSpPr txBox="1"/>
          <p:nvPr/>
        </p:nvSpPr>
        <p:spPr>
          <a:xfrm>
            <a:off x="3914631" y="189049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7D4C9CB-2C1C-8643-9973-1878CD56A2F8}"/>
              </a:ext>
            </a:extLst>
          </p:cNvPr>
          <p:cNvSpPr txBox="1"/>
          <p:nvPr/>
        </p:nvSpPr>
        <p:spPr>
          <a:xfrm>
            <a:off x="3914630" y="210787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763A8B99-3E01-CD69-CED3-8EFB8FE52A74}"/>
              </a:ext>
            </a:extLst>
          </p:cNvPr>
          <p:cNvSpPr/>
          <p:nvPr/>
        </p:nvSpPr>
        <p:spPr>
          <a:xfrm>
            <a:off x="7918508" y="2001370"/>
            <a:ext cx="758204" cy="4319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A3A6D06-6E32-C04F-0493-B8513141EE0D}"/>
              </a:ext>
            </a:extLst>
          </p:cNvPr>
          <p:cNvSpPr txBox="1"/>
          <p:nvPr/>
        </p:nvSpPr>
        <p:spPr>
          <a:xfrm>
            <a:off x="8694344" y="2073199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58B91BE-5BA8-1148-4C15-195F9334D8A3}"/>
              </a:ext>
            </a:extLst>
          </p:cNvPr>
          <p:cNvSpPr txBox="1"/>
          <p:nvPr/>
        </p:nvSpPr>
        <p:spPr>
          <a:xfrm>
            <a:off x="7480416" y="2003288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885DE48-6A23-5333-C054-9B7313A4D4FE}"/>
              </a:ext>
            </a:extLst>
          </p:cNvPr>
          <p:cNvSpPr txBox="1"/>
          <p:nvPr/>
        </p:nvSpPr>
        <p:spPr>
          <a:xfrm>
            <a:off x="7489232" y="220660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9ED624BD-3CA6-8102-6F0F-84AC0CD6FBE7}"/>
              </a:ext>
            </a:extLst>
          </p:cNvPr>
          <p:cNvSpPr/>
          <p:nvPr/>
        </p:nvSpPr>
        <p:spPr>
          <a:xfrm>
            <a:off x="9919997" y="2433326"/>
            <a:ext cx="828961" cy="139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0D3AB4E-C94B-3FEF-FA95-427E16DF25E8}"/>
              </a:ext>
            </a:extLst>
          </p:cNvPr>
          <p:cNvSpPr txBox="1"/>
          <p:nvPr/>
        </p:nvSpPr>
        <p:spPr>
          <a:xfrm>
            <a:off x="10710461" y="2372528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C3CA39C-DBB6-BEB8-0C0F-40ADF520596C}"/>
              </a:ext>
            </a:extLst>
          </p:cNvPr>
          <p:cNvSpPr txBox="1"/>
          <p:nvPr/>
        </p:nvSpPr>
        <p:spPr>
          <a:xfrm>
            <a:off x="9452133" y="2376458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24138012-89D6-C914-645D-DF4D1B1BF59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9136" y="3624083"/>
            <a:ext cx="2279767" cy="313088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E72C2BF5-2817-D61E-A992-77D760E5195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9735" y="3669848"/>
            <a:ext cx="2321470" cy="3188152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F7144FF8-EB3A-ACED-9D76-8942C6E94632}"/>
              </a:ext>
            </a:extLst>
          </p:cNvPr>
          <p:cNvSpPr/>
          <p:nvPr/>
        </p:nvSpPr>
        <p:spPr>
          <a:xfrm>
            <a:off x="4359968" y="5224453"/>
            <a:ext cx="758204" cy="4962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C9C0C0A5-6D3D-26B3-36C5-77AA8433314F}"/>
              </a:ext>
            </a:extLst>
          </p:cNvPr>
          <p:cNvSpPr txBox="1"/>
          <p:nvPr/>
        </p:nvSpPr>
        <p:spPr>
          <a:xfrm>
            <a:off x="5135804" y="5296282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E0C1F4F-CD15-A824-27AF-6CDD8BDA47C2}"/>
              </a:ext>
            </a:extLst>
          </p:cNvPr>
          <p:cNvSpPr txBox="1"/>
          <p:nvPr/>
        </p:nvSpPr>
        <p:spPr>
          <a:xfrm>
            <a:off x="3914631" y="521775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1FA920F-211D-9D18-A3FC-46B34C17C8C6}"/>
              </a:ext>
            </a:extLst>
          </p:cNvPr>
          <p:cNvSpPr txBox="1"/>
          <p:nvPr/>
        </p:nvSpPr>
        <p:spPr>
          <a:xfrm>
            <a:off x="3914630" y="543513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37BD537E-F463-E02A-6DB7-99ADB0B16A3B}"/>
              </a:ext>
            </a:extLst>
          </p:cNvPr>
          <p:cNvSpPr/>
          <p:nvPr/>
        </p:nvSpPr>
        <p:spPr>
          <a:xfrm>
            <a:off x="7850014" y="5189523"/>
            <a:ext cx="758204" cy="5499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B8ED6063-A20D-1F81-D5C9-50C4B8CFEFA8}"/>
              </a:ext>
            </a:extLst>
          </p:cNvPr>
          <p:cNvSpPr txBox="1"/>
          <p:nvPr/>
        </p:nvSpPr>
        <p:spPr>
          <a:xfrm>
            <a:off x="8625850" y="526135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EB29E2A0-BC2B-460A-62C1-E548F528D585}"/>
              </a:ext>
            </a:extLst>
          </p:cNvPr>
          <p:cNvSpPr txBox="1"/>
          <p:nvPr/>
        </p:nvSpPr>
        <p:spPr>
          <a:xfrm>
            <a:off x="7404677" y="519806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257F0D25-A168-BE75-89BD-F48887C76808}"/>
              </a:ext>
            </a:extLst>
          </p:cNvPr>
          <p:cNvSpPr txBox="1"/>
          <p:nvPr/>
        </p:nvSpPr>
        <p:spPr>
          <a:xfrm>
            <a:off x="7404676" y="541544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E123DCFF-81E2-B570-DD53-63BDB76CA0D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881" y="3642204"/>
            <a:ext cx="2276502" cy="3126398"/>
          </a:xfrm>
          <a:prstGeom prst="rect">
            <a:avLst/>
          </a:prstGeom>
        </p:spPr>
      </p:pic>
      <p:sp>
        <p:nvSpPr>
          <p:cNvPr id="56" name="矩形 55">
            <a:extLst>
              <a:ext uri="{FF2B5EF4-FFF2-40B4-BE49-F238E27FC236}">
                <a16:creationId xmlns:a16="http://schemas.microsoft.com/office/drawing/2014/main" id="{A773FE37-AF2C-07AA-4F6C-ED102BC383CB}"/>
              </a:ext>
            </a:extLst>
          </p:cNvPr>
          <p:cNvSpPr/>
          <p:nvPr/>
        </p:nvSpPr>
        <p:spPr>
          <a:xfrm>
            <a:off x="1404156" y="5384713"/>
            <a:ext cx="828961" cy="139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524DECDC-39C7-EDD0-5104-3D75C061D1C5}"/>
              </a:ext>
            </a:extLst>
          </p:cNvPr>
          <p:cNvSpPr txBox="1"/>
          <p:nvPr/>
        </p:nvSpPr>
        <p:spPr>
          <a:xfrm>
            <a:off x="2194620" y="5323915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931D5009-AF78-ABF3-FAB3-2A40ED0D764F}"/>
              </a:ext>
            </a:extLst>
          </p:cNvPr>
          <p:cNvSpPr txBox="1"/>
          <p:nvPr/>
        </p:nvSpPr>
        <p:spPr>
          <a:xfrm>
            <a:off x="894799" y="5321708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F98DDC70-402C-EB3D-E8B8-7EC406C98A8E}"/>
              </a:ext>
            </a:extLst>
          </p:cNvPr>
          <p:cNvSpPr txBox="1"/>
          <p:nvPr/>
        </p:nvSpPr>
        <p:spPr>
          <a:xfrm>
            <a:off x="93415" y="4926950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50806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B1EB58-AE72-61FA-41B1-37BE444C43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5FE4F616-1EFF-6FBC-1F2D-6E34F03D159C}"/>
              </a:ext>
            </a:extLst>
          </p:cNvPr>
          <p:cNvSpPr txBox="1"/>
          <p:nvPr/>
        </p:nvSpPr>
        <p:spPr>
          <a:xfrm>
            <a:off x="271576" y="179943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BAADE02A-6DD8-7F86-B4E5-0B35216D66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20488">
            <a:off x="9099376" y="1340791"/>
            <a:ext cx="2495262" cy="342682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EFA1715-4AB4-CE95-3500-A8F8AAC4EDE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3642" y="1340794"/>
            <a:ext cx="2495262" cy="342682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FB3C9A4-7B18-87F4-7AB2-2C88F23462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15" y="1403575"/>
            <a:ext cx="2495262" cy="342682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841BA684-43EC-F0EB-E40A-42F93E28882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4634" y="898001"/>
            <a:ext cx="2495262" cy="3426827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F5ACE385-B261-8027-D148-9844D2B55EFA}"/>
              </a:ext>
            </a:extLst>
          </p:cNvPr>
          <p:cNvSpPr/>
          <p:nvPr/>
        </p:nvSpPr>
        <p:spPr>
          <a:xfrm>
            <a:off x="1118309" y="2178239"/>
            <a:ext cx="1321575" cy="2014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94D0EE3-D509-5A17-C1A7-4406D3E37783}"/>
              </a:ext>
            </a:extLst>
          </p:cNvPr>
          <p:cNvSpPr txBox="1"/>
          <p:nvPr/>
        </p:nvSpPr>
        <p:spPr>
          <a:xfrm>
            <a:off x="2410254" y="2141157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76C8CA1-B50A-FEA7-F157-B45CB0BB3762}"/>
              </a:ext>
            </a:extLst>
          </p:cNvPr>
          <p:cNvSpPr txBox="1"/>
          <p:nvPr/>
        </p:nvSpPr>
        <p:spPr>
          <a:xfrm>
            <a:off x="644664" y="220807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0504D26-B77B-E61D-432D-533AD29D47B2}"/>
              </a:ext>
            </a:extLst>
          </p:cNvPr>
          <p:cNvSpPr txBox="1"/>
          <p:nvPr/>
        </p:nvSpPr>
        <p:spPr>
          <a:xfrm>
            <a:off x="8427832" y="2248339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25">
            <a:extLst>
              <a:ext uri="{FF2B5EF4-FFF2-40B4-BE49-F238E27FC236}">
                <a16:creationId xmlns:a16="http://schemas.microsoft.com/office/drawing/2014/main" id="{B25D010D-F942-DEAC-B35C-A878F6334128}"/>
              </a:ext>
            </a:extLst>
          </p:cNvPr>
          <p:cNvSpPr txBox="1"/>
          <p:nvPr/>
        </p:nvSpPr>
        <p:spPr>
          <a:xfrm>
            <a:off x="6647931" y="225669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6E3BCF2C-B519-2A1F-159A-2CE2AAAEF272}"/>
              </a:ext>
            </a:extLst>
          </p:cNvPr>
          <p:cNvSpPr/>
          <p:nvPr/>
        </p:nvSpPr>
        <p:spPr>
          <a:xfrm>
            <a:off x="7095464" y="2269785"/>
            <a:ext cx="1369296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801CA9F9-F980-3D82-EE9A-E283F092AFCF}"/>
              </a:ext>
            </a:extLst>
          </p:cNvPr>
          <p:cNvSpPr/>
          <p:nvPr/>
        </p:nvSpPr>
        <p:spPr>
          <a:xfrm>
            <a:off x="3921626" y="2220062"/>
            <a:ext cx="1282997" cy="1968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5AD08E3-D698-C310-A775-3F40A849D256}"/>
              </a:ext>
            </a:extLst>
          </p:cNvPr>
          <p:cNvSpPr txBox="1"/>
          <p:nvPr/>
        </p:nvSpPr>
        <p:spPr>
          <a:xfrm>
            <a:off x="5142483" y="2201488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AD47D3F-9DCE-7CC1-CF2A-F536F4FFCF3F}"/>
              </a:ext>
            </a:extLst>
          </p:cNvPr>
          <p:cNvSpPr txBox="1"/>
          <p:nvPr/>
        </p:nvSpPr>
        <p:spPr>
          <a:xfrm>
            <a:off x="3438298" y="2193756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89329A00-FE96-B63E-9CE8-ED3B2C5AA92C}"/>
              </a:ext>
            </a:extLst>
          </p:cNvPr>
          <p:cNvSpPr/>
          <p:nvPr/>
        </p:nvSpPr>
        <p:spPr>
          <a:xfrm>
            <a:off x="10069578" y="2414575"/>
            <a:ext cx="1346956" cy="1474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53AE7E8-A29B-B049-B952-1285473EA1FF}"/>
              </a:ext>
            </a:extLst>
          </p:cNvPr>
          <p:cNvSpPr txBox="1"/>
          <p:nvPr/>
        </p:nvSpPr>
        <p:spPr>
          <a:xfrm>
            <a:off x="11399739" y="2365194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FBDCE58-F86C-073D-4BF5-161B47E6B457}"/>
              </a:ext>
            </a:extLst>
          </p:cNvPr>
          <p:cNvSpPr txBox="1"/>
          <p:nvPr/>
        </p:nvSpPr>
        <p:spPr>
          <a:xfrm>
            <a:off x="9611867" y="235230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255292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8AA3FC-AF8E-13C7-172A-AB867C256F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A30AD658-A56B-FEEA-D4F3-2D93DF1EDD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458712">
            <a:off x="7206812" y="347600"/>
            <a:ext cx="2253002" cy="3094124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DE7F92B-39E3-FCBF-C634-2FD5CF68E9E3}"/>
              </a:ext>
            </a:extLst>
          </p:cNvPr>
          <p:cNvSpPr txBox="1"/>
          <p:nvPr/>
        </p:nvSpPr>
        <p:spPr>
          <a:xfrm>
            <a:off x="217485" y="0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D799ADBC-5B93-691E-BB08-7147DEE01D5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9390" y="555562"/>
            <a:ext cx="2253003" cy="309412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C2800640-44A0-EC8A-DB0D-60D1DF9840A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126" y="619612"/>
            <a:ext cx="2253003" cy="309412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F365A23-06AE-5C82-E887-C68A4960145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7024" y="3755581"/>
            <a:ext cx="2253003" cy="3094125"/>
          </a:xfrm>
          <a:prstGeom prst="rect">
            <a:avLst/>
          </a:prstGeom>
        </p:spPr>
      </p:pic>
      <p:sp>
        <p:nvSpPr>
          <p:cNvPr id="15" name="矩形 14">
            <a:extLst>
              <a:ext uri="{FF2B5EF4-FFF2-40B4-BE49-F238E27FC236}">
                <a16:creationId xmlns:a16="http://schemas.microsoft.com/office/drawing/2014/main" id="{F0B491F5-1D0A-893F-42D5-5FF5533057B6}"/>
              </a:ext>
            </a:extLst>
          </p:cNvPr>
          <p:cNvSpPr/>
          <p:nvPr/>
        </p:nvSpPr>
        <p:spPr>
          <a:xfrm>
            <a:off x="5694192" y="2082310"/>
            <a:ext cx="482600" cy="1320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F6921D2-E5D7-EE99-4CD5-A1A0991ED5D2}"/>
              </a:ext>
            </a:extLst>
          </p:cNvPr>
          <p:cNvSpPr txBox="1"/>
          <p:nvPr/>
        </p:nvSpPr>
        <p:spPr>
          <a:xfrm>
            <a:off x="6138296" y="2023326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9A5AAAF-AAAC-ECD6-AF18-B15B89FD98E1}"/>
              </a:ext>
            </a:extLst>
          </p:cNvPr>
          <p:cNvSpPr txBox="1"/>
          <p:nvPr/>
        </p:nvSpPr>
        <p:spPr>
          <a:xfrm>
            <a:off x="5196832" y="2023325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9AEC9204-A439-8AE1-733F-014AB11F7814}"/>
              </a:ext>
            </a:extLst>
          </p:cNvPr>
          <p:cNvSpPr/>
          <p:nvPr/>
        </p:nvSpPr>
        <p:spPr>
          <a:xfrm>
            <a:off x="8234195" y="2086050"/>
            <a:ext cx="663333" cy="1224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250584B-D7BB-0BB1-11E7-9D467279E4E2}"/>
              </a:ext>
            </a:extLst>
          </p:cNvPr>
          <p:cNvSpPr txBox="1"/>
          <p:nvPr/>
        </p:nvSpPr>
        <p:spPr>
          <a:xfrm>
            <a:off x="8843002" y="2005662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0DFADA0-1732-9B28-946E-214731ED69D3}"/>
              </a:ext>
            </a:extLst>
          </p:cNvPr>
          <p:cNvSpPr txBox="1"/>
          <p:nvPr/>
        </p:nvSpPr>
        <p:spPr>
          <a:xfrm>
            <a:off x="7744982" y="201316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3C970423-AAB3-6EF3-6C41-EACB6666C43B}"/>
              </a:ext>
            </a:extLst>
          </p:cNvPr>
          <p:cNvSpPr/>
          <p:nvPr/>
        </p:nvSpPr>
        <p:spPr>
          <a:xfrm>
            <a:off x="2555093" y="2142711"/>
            <a:ext cx="530852" cy="2095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61E4E65-75D8-1ABD-4001-64035DB964D6}"/>
              </a:ext>
            </a:extLst>
          </p:cNvPr>
          <p:cNvSpPr txBox="1"/>
          <p:nvPr/>
        </p:nvSpPr>
        <p:spPr>
          <a:xfrm>
            <a:off x="3133150" y="2106015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195AA2B-E36A-34E0-E2B9-16BD5192188C}"/>
              </a:ext>
            </a:extLst>
          </p:cNvPr>
          <p:cNvSpPr txBox="1"/>
          <p:nvPr/>
        </p:nvSpPr>
        <p:spPr>
          <a:xfrm>
            <a:off x="2027054" y="212030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7854FA9B-2A0F-BAA4-338F-8A09523F0A2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1165" y="3713737"/>
            <a:ext cx="2253003" cy="3094125"/>
          </a:xfrm>
          <a:prstGeom prst="rect">
            <a:avLst/>
          </a:prstGeom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4B4989E2-D72F-0BE7-B851-336B4FC6DB6E}"/>
              </a:ext>
            </a:extLst>
          </p:cNvPr>
          <p:cNvSpPr/>
          <p:nvPr/>
        </p:nvSpPr>
        <p:spPr>
          <a:xfrm>
            <a:off x="8588351" y="4944766"/>
            <a:ext cx="482600" cy="1320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639A334D-BDD2-61B0-314C-5DADCFBC04F8}"/>
              </a:ext>
            </a:extLst>
          </p:cNvPr>
          <p:cNvSpPr txBox="1"/>
          <p:nvPr/>
        </p:nvSpPr>
        <p:spPr>
          <a:xfrm>
            <a:off x="9032455" y="4885782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F15CD86-B9C2-4F91-BFBD-A6046BA746F2}"/>
              </a:ext>
            </a:extLst>
          </p:cNvPr>
          <p:cNvSpPr txBox="1"/>
          <p:nvPr/>
        </p:nvSpPr>
        <p:spPr>
          <a:xfrm>
            <a:off x="7494830" y="4871493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F4A5A488-80B4-4F07-CD53-62B3D7366388}"/>
              </a:ext>
            </a:extLst>
          </p:cNvPr>
          <p:cNvSpPr/>
          <p:nvPr/>
        </p:nvSpPr>
        <p:spPr>
          <a:xfrm>
            <a:off x="8047993" y="4940702"/>
            <a:ext cx="482600" cy="1320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47DC31B-3ADD-AF3F-C27E-51ED76636077}"/>
              </a:ext>
            </a:extLst>
          </p:cNvPr>
          <p:cNvSpPr txBox="1"/>
          <p:nvPr/>
        </p:nvSpPr>
        <p:spPr>
          <a:xfrm>
            <a:off x="8023835" y="4694481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G IP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3CE747D-5A11-0EB3-ABA6-FBBF990633FD}"/>
              </a:ext>
            </a:extLst>
          </p:cNvPr>
          <p:cNvSpPr txBox="1"/>
          <p:nvPr/>
        </p:nvSpPr>
        <p:spPr>
          <a:xfrm>
            <a:off x="8554687" y="4680692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9.6 IP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AD2CAC89-8F09-6000-4145-0006AF626F6C}"/>
              </a:ext>
            </a:extLst>
          </p:cNvPr>
          <p:cNvSpPr/>
          <p:nvPr/>
        </p:nvSpPr>
        <p:spPr>
          <a:xfrm>
            <a:off x="5850560" y="5445065"/>
            <a:ext cx="482600" cy="1320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4598687-D787-C8A0-3A56-EF5B6B804935}"/>
              </a:ext>
            </a:extLst>
          </p:cNvPr>
          <p:cNvSpPr txBox="1"/>
          <p:nvPr/>
        </p:nvSpPr>
        <p:spPr>
          <a:xfrm>
            <a:off x="6294664" y="538608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61245BB3-46ED-71FB-988B-2A53A242E9E6}"/>
              </a:ext>
            </a:extLst>
          </p:cNvPr>
          <p:cNvSpPr txBox="1"/>
          <p:nvPr/>
        </p:nvSpPr>
        <p:spPr>
          <a:xfrm>
            <a:off x="4829761" y="538391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FAE49417-26C5-A0BE-A9A7-556F447D3B16}"/>
              </a:ext>
            </a:extLst>
          </p:cNvPr>
          <p:cNvSpPr/>
          <p:nvPr/>
        </p:nvSpPr>
        <p:spPr>
          <a:xfrm>
            <a:off x="5310202" y="5441001"/>
            <a:ext cx="482600" cy="1320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0CCBCAA0-4A7A-E11E-4BEB-5A7CF873D079}"/>
              </a:ext>
            </a:extLst>
          </p:cNvPr>
          <p:cNvSpPr txBox="1"/>
          <p:nvPr/>
        </p:nvSpPr>
        <p:spPr>
          <a:xfrm>
            <a:off x="5286044" y="5194780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G IP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00605316-30CB-73AB-B3A6-C7EF4FF4D5ED}"/>
              </a:ext>
            </a:extLst>
          </p:cNvPr>
          <p:cNvSpPr txBox="1"/>
          <p:nvPr/>
        </p:nvSpPr>
        <p:spPr>
          <a:xfrm>
            <a:off x="5816896" y="5180991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9.6 IP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64B793C-1992-FB63-C20D-8A4D3DD84CC7}"/>
              </a:ext>
            </a:extLst>
          </p:cNvPr>
          <p:cNvSpPr txBox="1"/>
          <p:nvPr/>
        </p:nvSpPr>
        <p:spPr>
          <a:xfrm>
            <a:off x="331425" y="1838788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F19AFA6-89F1-798A-D55D-C777BA060F7F}"/>
              </a:ext>
            </a:extLst>
          </p:cNvPr>
          <p:cNvSpPr txBox="1"/>
          <p:nvPr/>
        </p:nvSpPr>
        <p:spPr>
          <a:xfrm>
            <a:off x="375777" y="4928258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604919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446F32C-04AA-DAFB-8C8E-1294F642111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702AC94-6ED3-41D3-9752-633F72614094}"/>
              </a:ext>
            </a:extLst>
          </p:cNvPr>
          <p:cNvSpPr txBox="1"/>
          <p:nvPr/>
        </p:nvSpPr>
        <p:spPr>
          <a:xfrm>
            <a:off x="271576" y="179943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CD209E8-C125-05B6-F099-AAF191BA03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2568" y="1302531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C0FF19F2-C7F7-9D2A-0B11-A89B1F0D106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100" y="1014855"/>
            <a:ext cx="3014505" cy="413992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6B9B967-E689-2793-29E2-96E42E0526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37830">
            <a:off x="4470594" y="675808"/>
            <a:ext cx="3014505" cy="4139921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32B5AAF8-5947-226F-DA90-1DF7FC42D599}"/>
              </a:ext>
            </a:extLst>
          </p:cNvPr>
          <p:cNvSpPr/>
          <p:nvPr/>
        </p:nvSpPr>
        <p:spPr>
          <a:xfrm>
            <a:off x="8625130" y="3695700"/>
            <a:ext cx="1233245" cy="1612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EC3025-2F71-B934-88A9-3A9E8279C5AF}"/>
              </a:ext>
            </a:extLst>
          </p:cNvPr>
          <p:cNvSpPr txBox="1"/>
          <p:nvPr/>
        </p:nvSpPr>
        <p:spPr>
          <a:xfrm>
            <a:off x="9834012" y="3653890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48B3189-0B4A-327D-3077-22C97B4F1779}"/>
              </a:ext>
            </a:extLst>
          </p:cNvPr>
          <p:cNvSpPr txBox="1"/>
          <p:nvPr/>
        </p:nvSpPr>
        <p:spPr>
          <a:xfrm>
            <a:off x="8135917" y="366158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165796E4-1240-59E0-DA6A-FDC34D17BC87}"/>
              </a:ext>
            </a:extLst>
          </p:cNvPr>
          <p:cNvSpPr/>
          <p:nvPr/>
        </p:nvSpPr>
        <p:spPr>
          <a:xfrm>
            <a:off x="1683591" y="3342585"/>
            <a:ext cx="1191372" cy="1690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593F499-EC30-EBC7-0E56-A19C2B25B298}"/>
              </a:ext>
            </a:extLst>
          </p:cNvPr>
          <p:cNvSpPr txBox="1"/>
          <p:nvPr/>
        </p:nvSpPr>
        <p:spPr>
          <a:xfrm>
            <a:off x="2860961" y="329160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26DC505-CB8F-5EDA-4DF2-91921D133FD6}"/>
              </a:ext>
            </a:extLst>
          </p:cNvPr>
          <p:cNvSpPr txBox="1"/>
          <p:nvPr/>
        </p:nvSpPr>
        <p:spPr>
          <a:xfrm>
            <a:off x="1218290" y="332017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929F4D05-66C7-8DEE-7E09-739F147D58DB}"/>
              </a:ext>
            </a:extLst>
          </p:cNvPr>
          <p:cNvSpPr/>
          <p:nvPr/>
        </p:nvSpPr>
        <p:spPr>
          <a:xfrm>
            <a:off x="5489581" y="3374231"/>
            <a:ext cx="1233245" cy="990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55A28C1-2072-C6DF-4086-93776FD13A84}"/>
              </a:ext>
            </a:extLst>
          </p:cNvPr>
          <p:cNvSpPr txBox="1"/>
          <p:nvPr/>
        </p:nvSpPr>
        <p:spPr>
          <a:xfrm>
            <a:off x="6678223" y="3288617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51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7190CC5-BC16-E0B3-1934-245F49656332}"/>
              </a:ext>
            </a:extLst>
          </p:cNvPr>
          <p:cNvSpPr txBox="1"/>
          <p:nvPr/>
        </p:nvSpPr>
        <p:spPr>
          <a:xfrm>
            <a:off x="5044863" y="3288618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088313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1A2CC0-9A88-CF37-8313-79AD8A3572C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FB3CF89-44A0-77E8-87A3-C0C421BF73D8}"/>
              </a:ext>
            </a:extLst>
          </p:cNvPr>
          <p:cNvSpPr txBox="1"/>
          <p:nvPr/>
        </p:nvSpPr>
        <p:spPr>
          <a:xfrm>
            <a:off x="271576" y="179943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8CA6BE5-1EEE-7499-38F8-67DEFB2A6D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2671" y="763137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34994CE-C2E1-A58C-041D-3080B434D1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20234">
            <a:off x="2287337" y="1210064"/>
            <a:ext cx="3014505" cy="4139921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C5C949EF-7CB7-3617-78D6-61D48D3C8708}"/>
              </a:ext>
            </a:extLst>
          </p:cNvPr>
          <p:cNvSpPr/>
          <p:nvPr/>
        </p:nvSpPr>
        <p:spPr>
          <a:xfrm>
            <a:off x="6898982" y="3029242"/>
            <a:ext cx="882943" cy="1425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0353A6F-CF6F-559F-95D7-3E968FCEEBF2}"/>
              </a:ext>
            </a:extLst>
          </p:cNvPr>
          <p:cNvSpPr txBox="1"/>
          <p:nvPr/>
        </p:nvSpPr>
        <p:spPr>
          <a:xfrm>
            <a:off x="7781925" y="2977423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ADFB1CB-57F6-FC92-CF55-58CF54ADAB88}"/>
              </a:ext>
            </a:extLst>
          </p:cNvPr>
          <p:cNvSpPr txBox="1"/>
          <p:nvPr/>
        </p:nvSpPr>
        <p:spPr>
          <a:xfrm>
            <a:off x="6424088" y="297767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53CEC21-8301-5509-D0E2-806354240A55}"/>
              </a:ext>
            </a:extLst>
          </p:cNvPr>
          <p:cNvSpPr txBox="1"/>
          <p:nvPr/>
        </p:nvSpPr>
        <p:spPr>
          <a:xfrm>
            <a:off x="4190073" y="2946389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FNβ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FB0987D-82D6-4F9D-84A9-9B8CCE2B95CC}"/>
              </a:ext>
            </a:extLst>
          </p:cNvPr>
          <p:cNvSpPr/>
          <p:nvPr/>
        </p:nvSpPr>
        <p:spPr>
          <a:xfrm>
            <a:off x="3487738" y="2997200"/>
            <a:ext cx="674687" cy="150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3" name="文本框 25">
            <a:extLst>
              <a:ext uri="{FF2B5EF4-FFF2-40B4-BE49-F238E27FC236}">
                <a16:creationId xmlns:a16="http://schemas.microsoft.com/office/drawing/2014/main" id="{CF7C7DDD-E495-6F1F-262F-FCA59ADFC59F}"/>
              </a:ext>
            </a:extLst>
          </p:cNvPr>
          <p:cNvSpPr txBox="1"/>
          <p:nvPr/>
        </p:nvSpPr>
        <p:spPr>
          <a:xfrm>
            <a:off x="2808820" y="292721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782448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0002A4-6DE9-19D6-F383-A72830B8C2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9334A03-6AD6-41C7-9692-B573F1FC04E5}"/>
              </a:ext>
            </a:extLst>
          </p:cNvPr>
          <p:cNvSpPr txBox="1"/>
          <p:nvPr/>
        </p:nvSpPr>
        <p:spPr>
          <a:xfrm>
            <a:off x="182676" y="46593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D6B5BC4-D381-98C1-25E6-1E63007A37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9626" y="3429000"/>
            <a:ext cx="2340274" cy="3213977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BC0BBCB-AD22-DF47-FB13-30B0687A9F0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5454" y="46593"/>
            <a:ext cx="2340274" cy="321397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77C70BF-C7C6-C9CB-23D5-187DDCE4CA8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5370" y="295372"/>
            <a:ext cx="2340274" cy="3213977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C59892E-5529-E6CA-0979-29F45FD0E2D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7540" y="401415"/>
            <a:ext cx="2244195" cy="3082028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7A3595C-3EC2-DC56-4E91-E771ED23099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2340" y="3661072"/>
            <a:ext cx="2107320" cy="2894054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E59A8E8F-0B9E-EF52-DC03-28D05D80DCE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643" y="3254889"/>
            <a:ext cx="2340274" cy="3213977"/>
          </a:xfrm>
          <a:prstGeom prst="rect">
            <a:avLst/>
          </a:prstGeom>
        </p:spPr>
      </p:pic>
      <p:sp>
        <p:nvSpPr>
          <p:cNvPr id="20" name="矩形 19">
            <a:extLst>
              <a:ext uri="{FF2B5EF4-FFF2-40B4-BE49-F238E27FC236}">
                <a16:creationId xmlns:a16="http://schemas.microsoft.com/office/drawing/2014/main" id="{4E84F19B-D9C6-2E51-1022-B6232B404142}"/>
              </a:ext>
            </a:extLst>
          </p:cNvPr>
          <p:cNvSpPr/>
          <p:nvPr/>
        </p:nvSpPr>
        <p:spPr>
          <a:xfrm>
            <a:off x="9156699" y="4861878"/>
            <a:ext cx="833727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C54DFD1-2323-0087-0129-92A61D5923E8}"/>
              </a:ext>
            </a:extLst>
          </p:cNvPr>
          <p:cNvSpPr txBox="1"/>
          <p:nvPr/>
        </p:nvSpPr>
        <p:spPr>
          <a:xfrm>
            <a:off x="9929978" y="4845401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D109D72-C5EF-FA8C-76FB-A628061C9C72}"/>
              </a:ext>
            </a:extLst>
          </p:cNvPr>
          <p:cNvSpPr txBox="1"/>
          <p:nvPr/>
        </p:nvSpPr>
        <p:spPr>
          <a:xfrm>
            <a:off x="8701892" y="487835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5BEA9822-8070-D4CB-9DF0-2E70F6155A19}"/>
              </a:ext>
            </a:extLst>
          </p:cNvPr>
          <p:cNvSpPr/>
          <p:nvPr/>
        </p:nvSpPr>
        <p:spPr>
          <a:xfrm>
            <a:off x="9100809" y="1776396"/>
            <a:ext cx="696707" cy="180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F388E711-1BEB-B7DA-D9BD-6DA50D0527F5}"/>
              </a:ext>
            </a:extLst>
          </p:cNvPr>
          <p:cNvSpPr txBox="1"/>
          <p:nvPr/>
        </p:nvSpPr>
        <p:spPr>
          <a:xfrm>
            <a:off x="9793584" y="1739259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IN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94DAFAF-F564-D654-021D-57D8CAD82A87}"/>
              </a:ext>
            </a:extLst>
          </p:cNvPr>
          <p:cNvSpPr txBox="1"/>
          <p:nvPr/>
        </p:nvSpPr>
        <p:spPr>
          <a:xfrm>
            <a:off x="8636531" y="173926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0B4D89AC-85ED-59FB-148C-AD9DB859415B}"/>
              </a:ext>
            </a:extLst>
          </p:cNvPr>
          <p:cNvSpPr/>
          <p:nvPr/>
        </p:nvSpPr>
        <p:spPr>
          <a:xfrm>
            <a:off x="5668378" y="1794395"/>
            <a:ext cx="619124" cy="2387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029604D-B3DF-076C-915D-44C39D072F0B}"/>
              </a:ext>
            </a:extLst>
          </p:cNvPr>
          <p:cNvSpPr txBox="1"/>
          <p:nvPr/>
        </p:nvSpPr>
        <p:spPr>
          <a:xfrm>
            <a:off x="6331549" y="1783262"/>
            <a:ext cx="6703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STIN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E9B97BC-9944-199B-EE07-B48F6DAA8772}"/>
              </a:ext>
            </a:extLst>
          </p:cNvPr>
          <p:cNvSpPr txBox="1"/>
          <p:nvPr/>
        </p:nvSpPr>
        <p:spPr>
          <a:xfrm>
            <a:off x="5222989" y="178326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1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E0F40AAD-CDA4-F2B5-82A8-93A21E507DA3}"/>
              </a:ext>
            </a:extLst>
          </p:cNvPr>
          <p:cNvSpPr/>
          <p:nvPr/>
        </p:nvSpPr>
        <p:spPr>
          <a:xfrm>
            <a:off x="5996092" y="4899995"/>
            <a:ext cx="498856" cy="1699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673DE9B-E160-D0AA-B838-86BA830B495D}"/>
              </a:ext>
            </a:extLst>
          </p:cNvPr>
          <p:cNvSpPr txBox="1"/>
          <p:nvPr/>
        </p:nvSpPr>
        <p:spPr>
          <a:xfrm>
            <a:off x="6495981" y="486187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E3B9A8C0-89A6-ED3D-7D1E-9C500D4B405C}"/>
              </a:ext>
            </a:extLst>
          </p:cNvPr>
          <p:cNvSpPr txBox="1"/>
          <p:nvPr/>
        </p:nvSpPr>
        <p:spPr>
          <a:xfrm>
            <a:off x="5456874" y="4865721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A6A343E2-D23D-287C-89EF-057743058A86}"/>
              </a:ext>
            </a:extLst>
          </p:cNvPr>
          <p:cNvSpPr/>
          <p:nvPr/>
        </p:nvSpPr>
        <p:spPr>
          <a:xfrm>
            <a:off x="2271341" y="4951166"/>
            <a:ext cx="481664" cy="871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8A000DD-251C-53DC-4C9A-44A0A9E36C48}"/>
              </a:ext>
            </a:extLst>
          </p:cNvPr>
          <p:cNvSpPr txBox="1"/>
          <p:nvPr/>
        </p:nvSpPr>
        <p:spPr>
          <a:xfrm>
            <a:off x="2770196" y="4875696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IRF3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33CA5AE4-456A-5C06-B9FB-E8B07A93ACA3}"/>
              </a:ext>
            </a:extLst>
          </p:cNvPr>
          <p:cNvSpPr txBox="1"/>
          <p:nvPr/>
        </p:nvSpPr>
        <p:spPr>
          <a:xfrm>
            <a:off x="1773300" y="487161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F94651B8-0802-810D-69E9-E2C23009D8BB}"/>
              </a:ext>
            </a:extLst>
          </p:cNvPr>
          <p:cNvSpPr/>
          <p:nvPr/>
        </p:nvSpPr>
        <p:spPr>
          <a:xfrm>
            <a:off x="2256420" y="1989769"/>
            <a:ext cx="675434" cy="1690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0243567-A4E8-5FA4-B453-FAB08FC4B51A}"/>
              </a:ext>
            </a:extLst>
          </p:cNvPr>
          <p:cNvSpPr txBox="1"/>
          <p:nvPr/>
        </p:nvSpPr>
        <p:spPr>
          <a:xfrm>
            <a:off x="2892478" y="195119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F9B3FD56-CA65-384C-2D5A-B59379555F8F}"/>
              </a:ext>
            </a:extLst>
          </p:cNvPr>
          <p:cNvSpPr txBox="1"/>
          <p:nvPr/>
        </p:nvSpPr>
        <p:spPr>
          <a:xfrm>
            <a:off x="1789813" y="196129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96774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70C44C-CB25-CF6E-BD20-4C37E3AA691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B31E3E9-3255-DD47-F4F3-E97687965759}"/>
              </a:ext>
            </a:extLst>
          </p:cNvPr>
          <p:cNvSpPr txBox="1"/>
          <p:nvPr/>
        </p:nvSpPr>
        <p:spPr>
          <a:xfrm>
            <a:off x="271576" y="179943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A6B0543-8555-8348-B893-EE61ECFB8B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2509" y="887552"/>
            <a:ext cx="3014505" cy="413992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320C3084-B939-8C38-59E2-7307CBD7750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1139" y="1460281"/>
            <a:ext cx="3014505" cy="413992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A9285453-EEFC-93DC-3557-C706395DA4B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222" y="1004778"/>
            <a:ext cx="3014505" cy="4139921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A86E9BCD-6C4F-823A-8047-A32A0F17594B}"/>
              </a:ext>
            </a:extLst>
          </p:cNvPr>
          <p:cNvSpPr/>
          <p:nvPr/>
        </p:nvSpPr>
        <p:spPr>
          <a:xfrm>
            <a:off x="1426416" y="3103217"/>
            <a:ext cx="675434" cy="1690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86EE381-6B88-68B1-4EE1-1AFB9C75909A}"/>
              </a:ext>
            </a:extLst>
          </p:cNvPr>
          <p:cNvSpPr txBox="1"/>
          <p:nvPr/>
        </p:nvSpPr>
        <p:spPr>
          <a:xfrm>
            <a:off x="2062474" y="306464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EF51C64-B6E3-C549-6163-7748743E57B6}"/>
              </a:ext>
            </a:extLst>
          </p:cNvPr>
          <p:cNvSpPr txBox="1"/>
          <p:nvPr/>
        </p:nvSpPr>
        <p:spPr>
          <a:xfrm>
            <a:off x="959809" y="3074738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7DF9D6D6-09E7-C9E3-4777-F924A91A16EC}"/>
              </a:ext>
            </a:extLst>
          </p:cNvPr>
          <p:cNvSpPr/>
          <p:nvPr/>
        </p:nvSpPr>
        <p:spPr>
          <a:xfrm>
            <a:off x="9060526" y="3002939"/>
            <a:ext cx="702599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8665064-E61F-2780-BF95-CD67549B00CA}"/>
              </a:ext>
            </a:extLst>
          </p:cNvPr>
          <p:cNvSpPr txBox="1"/>
          <p:nvPr/>
        </p:nvSpPr>
        <p:spPr>
          <a:xfrm>
            <a:off x="9721734" y="2951627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2D1A5A1-2FDA-1840-F5F3-F2E2BD20A6EC}"/>
              </a:ext>
            </a:extLst>
          </p:cNvPr>
          <p:cNvSpPr txBox="1"/>
          <p:nvPr/>
        </p:nvSpPr>
        <p:spPr>
          <a:xfrm>
            <a:off x="8627897" y="2980106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AED3A382-0F91-DC17-4BBC-3B1778811EF5}"/>
              </a:ext>
            </a:extLst>
          </p:cNvPr>
          <p:cNvSpPr/>
          <p:nvPr/>
        </p:nvSpPr>
        <p:spPr>
          <a:xfrm>
            <a:off x="3713698" y="3007945"/>
            <a:ext cx="605278" cy="2462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3E66FB4-7DD8-9BD7-5BBC-10D42BFAABE5}"/>
              </a:ext>
            </a:extLst>
          </p:cNvPr>
          <p:cNvSpPr txBox="1"/>
          <p:nvPr/>
        </p:nvSpPr>
        <p:spPr>
          <a:xfrm>
            <a:off x="4319887" y="3007944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zh-CN" sz="10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FκB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0E9D665-8E1E-8E2A-3646-C5BB65AE56C3}"/>
              </a:ext>
            </a:extLst>
          </p:cNvPr>
          <p:cNvSpPr txBox="1"/>
          <p:nvPr/>
        </p:nvSpPr>
        <p:spPr>
          <a:xfrm>
            <a:off x="3237487" y="3019388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A3B406A-A7AD-0C36-D27E-EA1B1D415F0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1939" y="1179199"/>
            <a:ext cx="3014505" cy="4139921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31615EB5-B66F-FAF6-E43A-08DEC7D92D14}"/>
              </a:ext>
            </a:extLst>
          </p:cNvPr>
          <p:cNvSpPr/>
          <p:nvPr/>
        </p:nvSpPr>
        <p:spPr>
          <a:xfrm>
            <a:off x="6683272" y="2969838"/>
            <a:ext cx="665054" cy="1946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E832A4D-C49B-0B6F-D0FB-A6CB50C7CA63}"/>
              </a:ext>
            </a:extLst>
          </p:cNvPr>
          <p:cNvSpPr txBox="1"/>
          <p:nvPr/>
        </p:nvSpPr>
        <p:spPr>
          <a:xfrm>
            <a:off x="7313852" y="2918268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FκB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F9EE56B-747E-DB64-C59B-CC5E4370A149}"/>
              </a:ext>
            </a:extLst>
          </p:cNvPr>
          <p:cNvSpPr txBox="1"/>
          <p:nvPr/>
        </p:nvSpPr>
        <p:spPr>
          <a:xfrm>
            <a:off x="6263123" y="294405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639259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E953043-DF88-390C-D254-46A883B30C2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19135D3-C209-9BD2-9C8A-BC666F3A6773}"/>
              </a:ext>
            </a:extLst>
          </p:cNvPr>
          <p:cNvSpPr txBox="1"/>
          <p:nvPr/>
        </p:nvSpPr>
        <p:spPr>
          <a:xfrm>
            <a:off x="271576" y="179943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5D36AC1-F443-39E1-1586-CB177BB12C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342310">
            <a:off x="8088470" y="1205369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6308FE6-F8A2-4385-1D31-089F1E9AACB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5397" y="1155838"/>
            <a:ext cx="3014505" cy="413992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009B653-63DD-6907-5CBB-55FE2DA36D4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847" y="1069975"/>
            <a:ext cx="3014505" cy="4139921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BA31C3A3-A6F8-C92D-80AE-9329CEED1456}"/>
              </a:ext>
            </a:extLst>
          </p:cNvPr>
          <p:cNvSpPr/>
          <p:nvPr/>
        </p:nvSpPr>
        <p:spPr>
          <a:xfrm>
            <a:off x="9527885" y="3395661"/>
            <a:ext cx="882943" cy="1425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0A43CF8-9075-AC78-3F28-89EBC2C80B6C}"/>
              </a:ext>
            </a:extLst>
          </p:cNvPr>
          <p:cNvSpPr txBox="1"/>
          <p:nvPr/>
        </p:nvSpPr>
        <p:spPr>
          <a:xfrm>
            <a:off x="10410828" y="3343842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AAE31BB-55A4-67FA-DF63-F4ADAFEC69E9}"/>
              </a:ext>
            </a:extLst>
          </p:cNvPr>
          <p:cNvSpPr txBox="1"/>
          <p:nvPr/>
        </p:nvSpPr>
        <p:spPr>
          <a:xfrm>
            <a:off x="9052991" y="3344091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5576C39F-6AAA-8E8E-E762-1E87D1D8DFAF}"/>
              </a:ext>
            </a:extLst>
          </p:cNvPr>
          <p:cNvSpPr/>
          <p:nvPr/>
        </p:nvSpPr>
        <p:spPr>
          <a:xfrm>
            <a:off x="5881712" y="2933992"/>
            <a:ext cx="882943" cy="1425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094F2B3-EC11-C6D3-3536-35311FB03EA1}"/>
              </a:ext>
            </a:extLst>
          </p:cNvPr>
          <p:cNvSpPr txBox="1"/>
          <p:nvPr/>
        </p:nvSpPr>
        <p:spPr>
          <a:xfrm>
            <a:off x="6764655" y="2882173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FκB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99C50DC-B6F0-CDAF-CEB0-F509571DBE5C}"/>
              </a:ext>
            </a:extLst>
          </p:cNvPr>
          <p:cNvSpPr txBox="1"/>
          <p:nvPr/>
        </p:nvSpPr>
        <p:spPr>
          <a:xfrm>
            <a:off x="5406818" y="288242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06D95F57-864E-AC9C-36AC-7F51CCC95E2C}"/>
              </a:ext>
            </a:extLst>
          </p:cNvPr>
          <p:cNvSpPr/>
          <p:nvPr/>
        </p:nvSpPr>
        <p:spPr>
          <a:xfrm>
            <a:off x="2103995" y="3086485"/>
            <a:ext cx="882943" cy="1425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03031DA-D28A-679E-BEE4-654326EA604C}"/>
              </a:ext>
            </a:extLst>
          </p:cNvPr>
          <p:cNvSpPr txBox="1"/>
          <p:nvPr/>
        </p:nvSpPr>
        <p:spPr>
          <a:xfrm>
            <a:off x="2986938" y="3034666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zh-CN" sz="10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FκB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7FD5CC1-6C57-33E3-435A-966271B20647}"/>
              </a:ext>
            </a:extLst>
          </p:cNvPr>
          <p:cNvSpPr txBox="1"/>
          <p:nvPr/>
        </p:nvSpPr>
        <p:spPr>
          <a:xfrm>
            <a:off x="1629101" y="303491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29766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B358FF4-465B-09BD-5A9C-33522264AD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0895" y="1816610"/>
            <a:ext cx="2065105" cy="137673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5B26916-037D-B75B-284B-DC6EE4CCEC47}"/>
              </a:ext>
            </a:extLst>
          </p:cNvPr>
          <p:cNvSpPr txBox="1"/>
          <p:nvPr/>
        </p:nvSpPr>
        <p:spPr>
          <a:xfrm>
            <a:off x="3645614" y="1256668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3803931B-F37B-7F1A-1492-781E3D748C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7671" y="3378485"/>
            <a:ext cx="2106202" cy="1404135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3DE97635-A121-54E7-6243-352579F49672}"/>
              </a:ext>
            </a:extLst>
          </p:cNvPr>
          <p:cNvSpPr/>
          <p:nvPr/>
        </p:nvSpPr>
        <p:spPr>
          <a:xfrm>
            <a:off x="4943202" y="4080552"/>
            <a:ext cx="471488" cy="1381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C66A76E-CDD9-E315-603A-4FE0B5436EAB}"/>
              </a:ext>
            </a:extLst>
          </p:cNvPr>
          <p:cNvSpPr txBox="1"/>
          <p:nvPr/>
        </p:nvSpPr>
        <p:spPr>
          <a:xfrm>
            <a:off x="5284449" y="2474437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25">
            <a:extLst>
              <a:ext uri="{FF2B5EF4-FFF2-40B4-BE49-F238E27FC236}">
                <a16:creationId xmlns:a16="http://schemas.microsoft.com/office/drawing/2014/main" id="{F51AC947-6DEF-8CC4-6AF2-FEE4BCBBDC0E}"/>
              </a:ext>
            </a:extLst>
          </p:cNvPr>
          <p:cNvSpPr txBox="1"/>
          <p:nvPr/>
        </p:nvSpPr>
        <p:spPr>
          <a:xfrm>
            <a:off x="4308650" y="2485979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90EA040-DA27-467D-6748-8748CB9A5585}"/>
              </a:ext>
            </a:extLst>
          </p:cNvPr>
          <p:cNvSpPr txBox="1"/>
          <p:nvPr/>
        </p:nvSpPr>
        <p:spPr>
          <a:xfrm>
            <a:off x="5379699" y="4031775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25">
            <a:extLst>
              <a:ext uri="{FF2B5EF4-FFF2-40B4-BE49-F238E27FC236}">
                <a16:creationId xmlns:a16="http://schemas.microsoft.com/office/drawing/2014/main" id="{3109A4E1-0011-A64F-FCE5-929D485C3256}"/>
              </a:ext>
            </a:extLst>
          </p:cNvPr>
          <p:cNvSpPr txBox="1"/>
          <p:nvPr/>
        </p:nvSpPr>
        <p:spPr>
          <a:xfrm>
            <a:off x="4442001" y="4033791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1ABCA83A-F713-F35A-8E91-86B18C777CDE}"/>
              </a:ext>
            </a:extLst>
          </p:cNvPr>
          <p:cNvSpPr/>
          <p:nvPr/>
        </p:nvSpPr>
        <p:spPr>
          <a:xfrm>
            <a:off x="4827703" y="2543881"/>
            <a:ext cx="471488" cy="1381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982272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A89313-1F16-6F01-4A61-2596C61FD1C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DA22978-FB7A-D86B-C967-AE859FB5B940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2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7EAA298-2F22-BFD4-CD13-A0954B750C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0597" y="1263789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267D75A-E2B0-311C-5C96-7C0365B0C5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6747" y="1263789"/>
            <a:ext cx="3014505" cy="4139921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3D658E42-3E2C-CDDC-37A8-D41C6612F34A}"/>
              </a:ext>
            </a:extLst>
          </p:cNvPr>
          <p:cNvSpPr/>
          <p:nvPr/>
        </p:nvSpPr>
        <p:spPr>
          <a:xfrm>
            <a:off x="3331369" y="3620408"/>
            <a:ext cx="610394" cy="1729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5379F99-255D-F645-0A5F-3922A2CDEEFC}"/>
              </a:ext>
            </a:extLst>
          </p:cNvPr>
          <p:cNvSpPr txBox="1"/>
          <p:nvPr/>
        </p:nvSpPr>
        <p:spPr>
          <a:xfrm>
            <a:off x="3910155" y="354722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F0E9FED-EE89-82EC-6374-079609ADCE9B}"/>
              </a:ext>
            </a:extLst>
          </p:cNvPr>
          <p:cNvSpPr txBox="1"/>
          <p:nvPr/>
        </p:nvSpPr>
        <p:spPr>
          <a:xfrm>
            <a:off x="2832514" y="358332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6F979B46-C4ED-3400-942D-AEBB1247DE56}"/>
              </a:ext>
            </a:extLst>
          </p:cNvPr>
          <p:cNvSpPr/>
          <p:nvPr/>
        </p:nvSpPr>
        <p:spPr>
          <a:xfrm>
            <a:off x="7434263" y="3829546"/>
            <a:ext cx="628970" cy="1311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98E189C-FCA8-BE49-ADD6-BF5EFE2BB6E5}"/>
              </a:ext>
            </a:extLst>
          </p:cNvPr>
          <p:cNvSpPr txBox="1"/>
          <p:nvPr/>
        </p:nvSpPr>
        <p:spPr>
          <a:xfrm>
            <a:off x="8018787" y="3726832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9D55EAF-6CFA-1018-8A15-040766D9EA0A}"/>
              </a:ext>
            </a:extLst>
          </p:cNvPr>
          <p:cNvSpPr txBox="1"/>
          <p:nvPr/>
        </p:nvSpPr>
        <p:spPr>
          <a:xfrm>
            <a:off x="6970867" y="375733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83880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AEDF64-166C-AA9F-C5D3-F447BBAB4BF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0B80E1E-1D81-8A38-27A3-2B0FAE739E17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2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86FA987-ACAB-9199-C76A-76E3D5ABD7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32793">
            <a:off x="2656881" y="1256383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53E742F-40E8-E87C-295A-428AE740F81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3640" y="994306"/>
            <a:ext cx="3014505" cy="4139921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A6F6A79C-797A-CFB7-A052-2822CAECE37A}"/>
              </a:ext>
            </a:extLst>
          </p:cNvPr>
          <p:cNvSpPr/>
          <p:nvPr/>
        </p:nvSpPr>
        <p:spPr>
          <a:xfrm>
            <a:off x="3731419" y="3725183"/>
            <a:ext cx="610394" cy="1729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6F96A31-C3AA-47BD-C5DC-E28273CB3957}"/>
              </a:ext>
            </a:extLst>
          </p:cNvPr>
          <p:cNvSpPr txBox="1"/>
          <p:nvPr/>
        </p:nvSpPr>
        <p:spPr>
          <a:xfrm>
            <a:off x="4312183" y="368810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7E54095-C0FF-06C0-B14B-561D3C754EAE}"/>
              </a:ext>
            </a:extLst>
          </p:cNvPr>
          <p:cNvSpPr txBox="1"/>
          <p:nvPr/>
        </p:nvSpPr>
        <p:spPr>
          <a:xfrm>
            <a:off x="3232564" y="368810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DFA478B3-07F2-E595-B7B1-7606C882C7FC}"/>
              </a:ext>
            </a:extLst>
          </p:cNvPr>
          <p:cNvSpPr/>
          <p:nvPr/>
        </p:nvSpPr>
        <p:spPr>
          <a:xfrm>
            <a:off x="7354888" y="3863029"/>
            <a:ext cx="628970" cy="1311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2EBA91A-DF9E-4E34-C0CB-EA9E9B377582}"/>
              </a:ext>
            </a:extLst>
          </p:cNvPr>
          <p:cNvSpPr txBox="1"/>
          <p:nvPr/>
        </p:nvSpPr>
        <p:spPr>
          <a:xfrm>
            <a:off x="7983858" y="3811210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4501F54-8A1E-41ED-0CF8-10890808B7A9}"/>
              </a:ext>
            </a:extLst>
          </p:cNvPr>
          <p:cNvSpPr txBox="1"/>
          <p:nvPr/>
        </p:nvSpPr>
        <p:spPr>
          <a:xfrm>
            <a:off x="6891492" y="379082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603169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4B7F45E-8C52-B38C-5005-6372ED7CFA4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0932B46-4D38-D758-C7C6-8FBCB77888A4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3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76257C9-85FF-675B-7556-B777A2E7AB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60473">
            <a:off x="1144334" y="1088710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10CB24F-0880-A73B-1BAF-47E81748C4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6727" y="1196865"/>
            <a:ext cx="3014505" cy="413992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89D3FBC-1113-A4C5-8A08-903907279E5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3980" y="1088709"/>
            <a:ext cx="3014505" cy="4139921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9797E6ED-8CDD-ACD0-F5BF-203E96C2FA74}"/>
              </a:ext>
            </a:extLst>
          </p:cNvPr>
          <p:cNvSpPr/>
          <p:nvPr/>
        </p:nvSpPr>
        <p:spPr>
          <a:xfrm>
            <a:off x="9773348" y="2746578"/>
            <a:ext cx="1085152" cy="221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F8310EA-35B4-F377-30D8-DF1D538DADFF}"/>
              </a:ext>
            </a:extLst>
          </p:cNvPr>
          <p:cNvSpPr txBox="1"/>
          <p:nvPr/>
        </p:nvSpPr>
        <p:spPr>
          <a:xfrm>
            <a:off x="10830270" y="2738187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903151C-814D-3D22-15B0-161C671C29BE}"/>
              </a:ext>
            </a:extLst>
          </p:cNvPr>
          <p:cNvSpPr txBox="1"/>
          <p:nvPr/>
        </p:nvSpPr>
        <p:spPr>
          <a:xfrm>
            <a:off x="9332266" y="2746578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FE1FA10-6C1E-674E-C705-2D3412BF4284}"/>
              </a:ext>
            </a:extLst>
          </p:cNvPr>
          <p:cNvSpPr txBox="1"/>
          <p:nvPr/>
        </p:nvSpPr>
        <p:spPr>
          <a:xfrm>
            <a:off x="7561016" y="2757886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25">
            <a:extLst>
              <a:ext uri="{FF2B5EF4-FFF2-40B4-BE49-F238E27FC236}">
                <a16:creationId xmlns:a16="http://schemas.microsoft.com/office/drawing/2014/main" id="{637965C5-CA72-AE76-A6EA-D67B1C6D1736}"/>
              </a:ext>
            </a:extLst>
          </p:cNvPr>
          <p:cNvSpPr txBox="1"/>
          <p:nvPr/>
        </p:nvSpPr>
        <p:spPr>
          <a:xfrm>
            <a:off x="5932827" y="275493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FDDC59FF-54B6-DF2A-E70D-02C105AF33F8}"/>
              </a:ext>
            </a:extLst>
          </p:cNvPr>
          <p:cNvSpPr/>
          <p:nvPr/>
        </p:nvSpPr>
        <p:spPr>
          <a:xfrm>
            <a:off x="6380360" y="2768024"/>
            <a:ext cx="1098519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9C82A662-596E-8F45-0E3D-0D93DBAA7F11}"/>
              </a:ext>
            </a:extLst>
          </p:cNvPr>
          <p:cNvSpPr/>
          <p:nvPr/>
        </p:nvSpPr>
        <p:spPr>
          <a:xfrm>
            <a:off x="2877671" y="2805106"/>
            <a:ext cx="1019636" cy="2091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5CAF417-4931-DE8E-7C0D-DD7BCD0DEAB9}"/>
              </a:ext>
            </a:extLst>
          </p:cNvPr>
          <p:cNvSpPr txBox="1"/>
          <p:nvPr/>
        </p:nvSpPr>
        <p:spPr>
          <a:xfrm>
            <a:off x="3924868" y="276802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C01A7C6-6BF1-ABD3-A909-7611C5F2C21A}"/>
              </a:ext>
            </a:extLst>
          </p:cNvPr>
          <p:cNvSpPr txBox="1"/>
          <p:nvPr/>
        </p:nvSpPr>
        <p:spPr>
          <a:xfrm>
            <a:off x="2442931" y="277236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493214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37FBDFD-302E-35E1-F54B-EA1C5FA173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2FF0300-AB94-76CC-2E51-B847C81E0804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3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C539C89-954A-4148-9107-B397841CB5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8428" y="1282338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996D450-CA92-BC8B-5439-FA8E5338E7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103" y="1431672"/>
            <a:ext cx="3010453" cy="413435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C8C99A9-CB8B-8BF9-BCF7-64CCD0AC1A1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8027" y="1666622"/>
            <a:ext cx="3010453" cy="4134356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9797E6ED-8CDD-ACD0-F5BF-203E96C2FA74}"/>
              </a:ext>
            </a:extLst>
          </p:cNvPr>
          <p:cNvSpPr/>
          <p:nvPr/>
        </p:nvSpPr>
        <p:spPr>
          <a:xfrm>
            <a:off x="8630678" y="3382134"/>
            <a:ext cx="609781" cy="1999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0" name="文本框 12">
            <a:extLst>
              <a:ext uri="{FF2B5EF4-FFF2-40B4-BE49-F238E27FC236}">
                <a16:creationId xmlns:a16="http://schemas.microsoft.com/office/drawing/2014/main" id="{3F8310EA-35B4-F377-30D8-DF1D538DADFF}"/>
              </a:ext>
            </a:extLst>
          </p:cNvPr>
          <p:cNvSpPr txBox="1"/>
          <p:nvPr/>
        </p:nvSpPr>
        <p:spPr>
          <a:xfrm>
            <a:off x="9184237" y="3352298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3">
            <a:extLst>
              <a:ext uri="{FF2B5EF4-FFF2-40B4-BE49-F238E27FC236}">
                <a16:creationId xmlns:a16="http://schemas.microsoft.com/office/drawing/2014/main" id="{C903151C-814D-3D22-15B0-161C671C29BE}"/>
              </a:ext>
            </a:extLst>
          </p:cNvPr>
          <p:cNvSpPr txBox="1"/>
          <p:nvPr/>
        </p:nvSpPr>
        <p:spPr>
          <a:xfrm>
            <a:off x="8189596" y="336069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7">
            <a:extLst>
              <a:ext uri="{FF2B5EF4-FFF2-40B4-BE49-F238E27FC236}">
                <a16:creationId xmlns:a16="http://schemas.microsoft.com/office/drawing/2014/main" id="{8FE1FA10-6C1E-674E-C705-2D3412BF4284}"/>
              </a:ext>
            </a:extLst>
          </p:cNvPr>
          <p:cNvSpPr txBox="1"/>
          <p:nvPr/>
        </p:nvSpPr>
        <p:spPr>
          <a:xfrm>
            <a:off x="5775621" y="3382135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25">
            <a:extLst>
              <a:ext uri="{FF2B5EF4-FFF2-40B4-BE49-F238E27FC236}">
                <a16:creationId xmlns:a16="http://schemas.microsoft.com/office/drawing/2014/main" id="{637965C5-CA72-AE76-A6EA-D67B1C6D1736}"/>
              </a:ext>
            </a:extLst>
          </p:cNvPr>
          <p:cNvSpPr txBox="1"/>
          <p:nvPr/>
        </p:nvSpPr>
        <p:spPr>
          <a:xfrm>
            <a:off x="4798050" y="3374836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DDC59FF-54B6-DF2A-E70D-02C105AF33F8}"/>
              </a:ext>
            </a:extLst>
          </p:cNvPr>
          <p:cNvSpPr/>
          <p:nvPr/>
        </p:nvSpPr>
        <p:spPr>
          <a:xfrm>
            <a:off x="5237690" y="3429000"/>
            <a:ext cx="583815" cy="1993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9C82A662-596E-8F45-0E3D-0D93DBAA7F11}"/>
              </a:ext>
            </a:extLst>
          </p:cNvPr>
          <p:cNvSpPr/>
          <p:nvPr/>
        </p:nvSpPr>
        <p:spPr>
          <a:xfrm>
            <a:off x="1844675" y="3382135"/>
            <a:ext cx="571500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6" name="文本框 21">
            <a:extLst>
              <a:ext uri="{FF2B5EF4-FFF2-40B4-BE49-F238E27FC236}">
                <a16:creationId xmlns:a16="http://schemas.microsoft.com/office/drawing/2014/main" id="{55CAF417-4931-DE8E-7C0D-DD7BCD0DEAB9}"/>
              </a:ext>
            </a:extLst>
          </p:cNvPr>
          <p:cNvSpPr txBox="1"/>
          <p:nvPr/>
        </p:nvSpPr>
        <p:spPr>
          <a:xfrm>
            <a:off x="2348274" y="337155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22">
            <a:extLst>
              <a:ext uri="{FF2B5EF4-FFF2-40B4-BE49-F238E27FC236}">
                <a16:creationId xmlns:a16="http://schemas.microsoft.com/office/drawing/2014/main" id="{0C01A7C6-6BF1-ABD3-A909-7611C5F2C21A}"/>
              </a:ext>
            </a:extLst>
          </p:cNvPr>
          <p:cNvSpPr txBox="1"/>
          <p:nvPr/>
        </p:nvSpPr>
        <p:spPr>
          <a:xfrm>
            <a:off x="1370546" y="338213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457122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31738B1-0E90-E0AB-4029-7F0D91AE48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0A81657-84CF-6EF2-081B-7B0031244CDE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4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223310AD-D438-4952-1A72-41B558C7EE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9788" y="0"/>
            <a:ext cx="2443669" cy="335597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DC6982EC-336C-898E-547F-DA78EB98DC8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114" y="41224"/>
            <a:ext cx="2443669" cy="335597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7E4AAD0-D87A-4811-4B08-D0B9C15CE39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7851" y="3355973"/>
            <a:ext cx="2443669" cy="3355973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F7B74B03-B256-6261-F24C-49CFCC1972A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5325" y="3502027"/>
            <a:ext cx="2443669" cy="3355973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691429C2-6CA2-8764-06CF-2FE5C1A40C7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3144" y="3502027"/>
            <a:ext cx="2443669" cy="3355973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FA005E44-4EDF-EABE-EEDE-F0CE81410774}"/>
              </a:ext>
            </a:extLst>
          </p:cNvPr>
          <p:cNvSpPr/>
          <p:nvPr/>
        </p:nvSpPr>
        <p:spPr>
          <a:xfrm>
            <a:off x="2442832" y="4617064"/>
            <a:ext cx="625484" cy="1525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EE1F5E7-8BD5-87BF-4B5E-51BCC978D641}"/>
              </a:ext>
            </a:extLst>
          </p:cNvPr>
          <p:cNvSpPr txBox="1"/>
          <p:nvPr/>
        </p:nvSpPr>
        <p:spPr>
          <a:xfrm>
            <a:off x="3028550" y="4571803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776C931-A0AC-CF63-547B-3F791070E3CF}"/>
              </a:ext>
            </a:extLst>
          </p:cNvPr>
          <p:cNvSpPr txBox="1"/>
          <p:nvPr/>
        </p:nvSpPr>
        <p:spPr>
          <a:xfrm>
            <a:off x="1893975" y="4569748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4DDE65C5-6DC4-2AF1-631B-C7C726856D9C}"/>
              </a:ext>
            </a:extLst>
          </p:cNvPr>
          <p:cNvSpPr/>
          <p:nvPr/>
        </p:nvSpPr>
        <p:spPr>
          <a:xfrm>
            <a:off x="7700535" y="4597402"/>
            <a:ext cx="570028" cy="1357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3D18B2D-928A-1B9F-6CD8-B709B4221EC4}"/>
              </a:ext>
            </a:extLst>
          </p:cNvPr>
          <p:cNvSpPr txBox="1"/>
          <p:nvPr/>
        </p:nvSpPr>
        <p:spPr>
          <a:xfrm>
            <a:off x="8224792" y="452172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57B2807-013A-1743-B1B1-FF2E38B3BEF7}"/>
              </a:ext>
            </a:extLst>
          </p:cNvPr>
          <p:cNvSpPr txBox="1"/>
          <p:nvPr/>
        </p:nvSpPr>
        <p:spPr>
          <a:xfrm>
            <a:off x="7202843" y="455684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5B931405-408E-608A-B99E-6608354E897F}"/>
              </a:ext>
            </a:extLst>
          </p:cNvPr>
          <p:cNvSpPr/>
          <p:nvPr/>
        </p:nvSpPr>
        <p:spPr>
          <a:xfrm>
            <a:off x="5297501" y="4447417"/>
            <a:ext cx="641906" cy="133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3D00A71-050D-F87F-D212-70A4D04CDDE3}"/>
              </a:ext>
            </a:extLst>
          </p:cNvPr>
          <p:cNvSpPr txBox="1"/>
          <p:nvPr/>
        </p:nvSpPr>
        <p:spPr>
          <a:xfrm>
            <a:off x="5939407" y="4390942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DX5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5E7014F5-5B7A-C0F3-1F99-9E9DC829630D}"/>
              </a:ext>
            </a:extLst>
          </p:cNvPr>
          <p:cNvSpPr txBox="1"/>
          <p:nvPr/>
        </p:nvSpPr>
        <p:spPr>
          <a:xfrm>
            <a:off x="4830404" y="437832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6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B1FAC174-AC72-2758-FE52-EFCEF085B66C}"/>
              </a:ext>
            </a:extLst>
          </p:cNvPr>
          <p:cNvSpPr/>
          <p:nvPr/>
        </p:nvSpPr>
        <p:spPr>
          <a:xfrm>
            <a:off x="1737882" y="1143614"/>
            <a:ext cx="476207" cy="1594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FD150ED-BE4F-EA84-4603-6BE11D3C760B}"/>
              </a:ext>
            </a:extLst>
          </p:cNvPr>
          <p:cNvSpPr txBox="1"/>
          <p:nvPr/>
        </p:nvSpPr>
        <p:spPr>
          <a:xfrm>
            <a:off x="2162587" y="1096298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B5E6D70-888F-17D5-77B3-2CBB2FF7DE90}"/>
              </a:ext>
            </a:extLst>
          </p:cNvPr>
          <p:cNvSpPr txBox="1"/>
          <p:nvPr/>
        </p:nvSpPr>
        <p:spPr>
          <a:xfrm>
            <a:off x="1216094" y="1101507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00A0CF27-6455-A6A6-64D1-DEBCCA89ED0A}"/>
              </a:ext>
            </a:extLst>
          </p:cNvPr>
          <p:cNvSpPr/>
          <p:nvPr/>
        </p:nvSpPr>
        <p:spPr>
          <a:xfrm>
            <a:off x="2678229" y="1143614"/>
            <a:ext cx="476207" cy="1594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BB9FE5E-2882-0A6E-F223-C087EE76B640}"/>
              </a:ext>
            </a:extLst>
          </p:cNvPr>
          <p:cNvSpPr txBox="1"/>
          <p:nvPr/>
        </p:nvSpPr>
        <p:spPr>
          <a:xfrm>
            <a:off x="1687172" y="897393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YSE30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A533090-8DE7-06C1-819E-2CACAA3BF712}"/>
              </a:ext>
            </a:extLst>
          </p:cNvPr>
          <p:cNvSpPr txBox="1"/>
          <p:nvPr/>
        </p:nvSpPr>
        <p:spPr>
          <a:xfrm>
            <a:off x="2592365" y="897393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YSE510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60E56744-5B04-68FE-A5C3-C399E508A18C}"/>
              </a:ext>
            </a:extLst>
          </p:cNvPr>
          <p:cNvSpPr/>
          <p:nvPr/>
        </p:nvSpPr>
        <p:spPr>
          <a:xfrm>
            <a:off x="4869888" y="1120177"/>
            <a:ext cx="476207" cy="1594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A2F29948-7DD0-0DA5-FDAA-F0D0ED7CB4DB}"/>
              </a:ext>
            </a:extLst>
          </p:cNvPr>
          <p:cNvSpPr txBox="1"/>
          <p:nvPr/>
        </p:nvSpPr>
        <p:spPr>
          <a:xfrm>
            <a:off x="5294593" y="1072861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DX5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3176B32-3064-1693-1945-EEDA1F5E5DD6}"/>
              </a:ext>
            </a:extLst>
          </p:cNvPr>
          <p:cNvSpPr txBox="1"/>
          <p:nvPr/>
        </p:nvSpPr>
        <p:spPr>
          <a:xfrm>
            <a:off x="4348100" y="107807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6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B1969DC8-C046-6630-5FE7-7A1E3AE8127F}"/>
              </a:ext>
            </a:extLst>
          </p:cNvPr>
          <p:cNvSpPr/>
          <p:nvPr/>
        </p:nvSpPr>
        <p:spPr>
          <a:xfrm>
            <a:off x="5810235" y="1120177"/>
            <a:ext cx="476207" cy="1594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A30C58B-E657-4F14-85FC-8FB04D86C723}"/>
              </a:ext>
            </a:extLst>
          </p:cNvPr>
          <p:cNvSpPr txBox="1"/>
          <p:nvPr/>
        </p:nvSpPr>
        <p:spPr>
          <a:xfrm>
            <a:off x="4819178" y="873956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YSE30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1B31B0F-6C16-FFAB-72E7-00E1B48901DF}"/>
              </a:ext>
            </a:extLst>
          </p:cNvPr>
          <p:cNvSpPr txBox="1"/>
          <p:nvPr/>
        </p:nvSpPr>
        <p:spPr>
          <a:xfrm>
            <a:off x="5724371" y="873956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YSE510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2">
            <a:extLst>
              <a:ext uri="{FF2B5EF4-FFF2-40B4-BE49-F238E27FC236}">
                <a16:creationId xmlns:a16="http://schemas.microsoft.com/office/drawing/2014/main" id="{348D88BA-1A5B-B705-EB32-A20EFFDEEEB5}"/>
              </a:ext>
            </a:extLst>
          </p:cNvPr>
          <p:cNvSpPr txBox="1"/>
          <p:nvPr/>
        </p:nvSpPr>
        <p:spPr>
          <a:xfrm>
            <a:off x="527877" y="1120177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">
            <a:extLst>
              <a:ext uri="{FF2B5EF4-FFF2-40B4-BE49-F238E27FC236}">
                <a16:creationId xmlns:a16="http://schemas.microsoft.com/office/drawing/2014/main" id="{49382609-2AD9-10AE-8D5F-B44FB1D7D744}"/>
              </a:ext>
            </a:extLst>
          </p:cNvPr>
          <p:cNvSpPr txBox="1"/>
          <p:nvPr/>
        </p:nvSpPr>
        <p:spPr>
          <a:xfrm>
            <a:off x="637002" y="4323526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1F14DA2-D581-A73B-A170-FB5FD29ED35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4963" y="2846389"/>
            <a:ext cx="2443669" cy="3355972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8B9D41C5-78C3-2CFE-02DD-72E39D324069}"/>
              </a:ext>
            </a:extLst>
          </p:cNvPr>
          <p:cNvSpPr/>
          <p:nvPr/>
        </p:nvSpPr>
        <p:spPr>
          <a:xfrm>
            <a:off x="10072601" y="4524374"/>
            <a:ext cx="476207" cy="1594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4F88555F-6306-6A79-AE6D-74A6BE30059E}"/>
              </a:ext>
            </a:extLst>
          </p:cNvPr>
          <p:cNvSpPr/>
          <p:nvPr/>
        </p:nvSpPr>
        <p:spPr>
          <a:xfrm>
            <a:off x="11065616" y="4524374"/>
            <a:ext cx="476207" cy="1594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0A409CD-D239-5D73-2673-0FAC38158694}"/>
              </a:ext>
            </a:extLst>
          </p:cNvPr>
          <p:cNvSpPr txBox="1"/>
          <p:nvPr/>
        </p:nvSpPr>
        <p:spPr>
          <a:xfrm>
            <a:off x="9471388" y="452437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902B3AAF-3691-432F-3B7D-706B9F518EBD}"/>
              </a:ext>
            </a:extLst>
          </p:cNvPr>
          <p:cNvSpPr txBox="1"/>
          <p:nvPr/>
        </p:nvSpPr>
        <p:spPr>
          <a:xfrm>
            <a:off x="11637129" y="4486912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868502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341DE0-B07E-10DA-207C-93357FE18F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8B8F07B-4660-5146-48BE-9D350BD9A2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774" y="97402"/>
            <a:ext cx="2415661" cy="331750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0D3F235-2E68-15B1-F5DC-1CB43A85B49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5580" y="123851"/>
            <a:ext cx="2415661" cy="331750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594A638-4FA4-DFAB-58C5-EB21077F14F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6954" y="38809"/>
            <a:ext cx="2415661" cy="3317509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829D5FF-A882-CBA3-65FA-1F72EA64CDDD}"/>
              </a:ext>
            </a:extLst>
          </p:cNvPr>
          <p:cNvSpPr txBox="1"/>
          <p:nvPr/>
        </p:nvSpPr>
        <p:spPr>
          <a:xfrm>
            <a:off x="112327" y="38809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4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9FF25674-5288-1626-216D-E218076C9B7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9447" y="77618"/>
            <a:ext cx="2415661" cy="331750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303993FD-CE20-15B3-15ED-453CCCA086F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9244" y="123850"/>
            <a:ext cx="2415661" cy="3317509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E7150657-4997-0A91-84FC-02CB4041BB7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774" y="3501682"/>
            <a:ext cx="2415661" cy="3317509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BFB501CC-C518-25A9-1E3C-9240C97C71D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4896" y="3467808"/>
            <a:ext cx="2415661" cy="3317509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33A73DBB-F910-64CE-114D-A61568DCE2C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4942" y="3467808"/>
            <a:ext cx="2415661" cy="3317509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00BBCCAB-E762-57A1-7EEC-432F697EC8BC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76339" y="3467807"/>
            <a:ext cx="2415661" cy="3317509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92509805-7723-3E04-710A-D2B3C8D5F1F7}"/>
              </a:ext>
            </a:extLst>
          </p:cNvPr>
          <p:cNvSpPr/>
          <p:nvPr/>
        </p:nvSpPr>
        <p:spPr>
          <a:xfrm>
            <a:off x="1823565" y="2338243"/>
            <a:ext cx="378083" cy="1430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15AFE42-E64E-1646-4CF9-A4738A26FA2C}"/>
              </a:ext>
            </a:extLst>
          </p:cNvPr>
          <p:cNvSpPr txBox="1"/>
          <p:nvPr/>
        </p:nvSpPr>
        <p:spPr>
          <a:xfrm>
            <a:off x="2191887" y="2286631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069B9FEC-6563-1E5A-A2FC-FC0828CAA6D0}"/>
              </a:ext>
            </a:extLst>
          </p:cNvPr>
          <p:cNvSpPr txBox="1"/>
          <p:nvPr/>
        </p:nvSpPr>
        <p:spPr>
          <a:xfrm>
            <a:off x="1274708" y="2281401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78CB2A71-0E51-93CC-7F24-FB04506B3A49}"/>
              </a:ext>
            </a:extLst>
          </p:cNvPr>
          <p:cNvSpPr/>
          <p:nvPr/>
        </p:nvSpPr>
        <p:spPr>
          <a:xfrm>
            <a:off x="4035304" y="2209889"/>
            <a:ext cx="346197" cy="1300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BDCAC0C-F596-99F9-DDA5-5B3239713D1E}"/>
              </a:ext>
            </a:extLst>
          </p:cNvPr>
          <p:cNvSpPr txBox="1"/>
          <p:nvPr/>
        </p:nvSpPr>
        <p:spPr>
          <a:xfrm>
            <a:off x="4389076" y="217021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5338AAE-2F8A-A229-19BD-510C1D60BD5D}"/>
              </a:ext>
            </a:extLst>
          </p:cNvPr>
          <p:cNvSpPr txBox="1"/>
          <p:nvPr/>
        </p:nvSpPr>
        <p:spPr>
          <a:xfrm>
            <a:off x="3536449" y="215182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F1309BE1-F403-253C-1F81-3549A8D7176C}"/>
              </a:ext>
            </a:extLst>
          </p:cNvPr>
          <p:cNvSpPr/>
          <p:nvPr/>
        </p:nvSpPr>
        <p:spPr>
          <a:xfrm>
            <a:off x="10584367" y="1996841"/>
            <a:ext cx="722308" cy="2259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AFCB552-506C-6FD4-BEC3-CC91D307115D}"/>
              </a:ext>
            </a:extLst>
          </p:cNvPr>
          <p:cNvSpPr txBox="1"/>
          <p:nvPr/>
        </p:nvSpPr>
        <p:spPr>
          <a:xfrm>
            <a:off x="11292989" y="1996842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1FA1353B-D13E-429B-CC9D-B75D668EBC71}"/>
              </a:ext>
            </a:extLst>
          </p:cNvPr>
          <p:cNvSpPr txBox="1"/>
          <p:nvPr/>
        </p:nvSpPr>
        <p:spPr>
          <a:xfrm>
            <a:off x="10143285" y="199684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AF8D19F9-2682-86E1-95BE-FA5F8E8367EC}"/>
              </a:ext>
            </a:extLst>
          </p:cNvPr>
          <p:cNvSpPr/>
          <p:nvPr/>
        </p:nvSpPr>
        <p:spPr>
          <a:xfrm>
            <a:off x="4490613" y="5638799"/>
            <a:ext cx="312360" cy="1951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342694FF-B22A-C15A-3CBA-305253FB4329}"/>
              </a:ext>
            </a:extLst>
          </p:cNvPr>
          <p:cNvSpPr txBox="1"/>
          <p:nvPr/>
        </p:nvSpPr>
        <p:spPr>
          <a:xfrm>
            <a:off x="4793684" y="561328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7D4E217-DC07-DFBC-317B-79C9E973F61D}"/>
              </a:ext>
            </a:extLst>
          </p:cNvPr>
          <p:cNvSpPr txBox="1"/>
          <p:nvPr/>
        </p:nvSpPr>
        <p:spPr>
          <a:xfrm>
            <a:off x="4032989" y="559535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E3EE34A2-40D6-112F-A010-39A4DDDC5069}"/>
              </a:ext>
            </a:extLst>
          </p:cNvPr>
          <p:cNvSpPr/>
          <p:nvPr/>
        </p:nvSpPr>
        <p:spPr>
          <a:xfrm>
            <a:off x="1823565" y="5062393"/>
            <a:ext cx="378083" cy="1430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130B453F-1FD2-DD97-838F-099B73C9DDAD}"/>
              </a:ext>
            </a:extLst>
          </p:cNvPr>
          <p:cNvSpPr txBox="1"/>
          <p:nvPr/>
        </p:nvSpPr>
        <p:spPr>
          <a:xfrm>
            <a:off x="2191887" y="5010781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5B5EA981-F60F-3C5E-E0BD-6D5742FB7AD5}"/>
              </a:ext>
            </a:extLst>
          </p:cNvPr>
          <p:cNvSpPr txBox="1"/>
          <p:nvPr/>
        </p:nvSpPr>
        <p:spPr>
          <a:xfrm>
            <a:off x="1274708" y="5005551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ADCAE6FB-96B5-D626-CB4D-E4BE65F5CD41}"/>
              </a:ext>
            </a:extLst>
          </p:cNvPr>
          <p:cNvSpPr/>
          <p:nvPr/>
        </p:nvSpPr>
        <p:spPr>
          <a:xfrm>
            <a:off x="6143626" y="1927303"/>
            <a:ext cx="326789" cy="133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8A77C9CF-0009-2B11-323B-8A7F66F7703F}"/>
              </a:ext>
            </a:extLst>
          </p:cNvPr>
          <p:cNvSpPr txBox="1"/>
          <p:nvPr/>
        </p:nvSpPr>
        <p:spPr>
          <a:xfrm>
            <a:off x="6484940" y="1873731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DX5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C1018AD5-5E5B-EA7E-38FB-317551255A4B}"/>
              </a:ext>
            </a:extLst>
          </p:cNvPr>
          <p:cNvSpPr txBox="1"/>
          <p:nvPr/>
        </p:nvSpPr>
        <p:spPr>
          <a:xfrm>
            <a:off x="5644771" y="186360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6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1575E984-9E27-E238-E739-A55EEBCEE1E1}"/>
              </a:ext>
            </a:extLst>
          </p:cNvPr>
          <p:cNvSpPr/>
          <p:nvPr/>
        </p:nvSpPr>
        <p:spPr>
          <a:xfrm>
            <a:off x="7684496" y="5595359"/>
            <a:ext cx="326789" cy="133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EBBD4C8C-FAAE-D793-B6AD-BB334B4F9640}"/>
              </a:ext>
            </a:extLst>
          </p:cNvPr>
          <p:cNvSpPr txBox="1"/>
          <p:nvPr/>
        </p:nvSpPr>
        <p:spPr>
          <a:xfrm>
            <a:off x="8025810" y="5541787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DX5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697ED614-52B3-C082-B99A-98D302D95EBF}"/>
              </a:ext>
            </a:extLst>
          </p:cNvPr>
          <p:cNvSpPr txBox="1"/>
          <p:nvPr/>
        </p:nvSpPr>
        <p:spPr>
          <a:xfrm>
            <a:off x="7185641" y="553165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6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id="{1B23B56C-B9FE-B9A4-FABF-B26EFE5F1732}"/>
              </a:ext>
            </a:extLst>
          </p:cNvPr>
          <p:cNvSpPr/>
          <p:nvPr/>
        </p:nvSpPr>
        <p:spPr>
          <a:xfrm>
            <a:off x="8553519" y="2119952"/>
            <a:ext cx="326789" cy="133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3053ADDB-0352-4BAE-0391-C9E53282050F}"/>
              </a:ext>
            </a:extLst>
          </p:cNvPr>
          <p:cNvSpPr txBox="1"/>
          <p:nvPr/>
        </p:nvSpPr>
        <p:spPr>
          <a:xfrm>
            <a:off x="8894833" y="2066380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PS15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15E3CC5-D2F0-5926-631C-A282E4562562}"/>
              </a:ext>
            </a:extLst>
          </p:cNvPr>
          <p:cNvSpPr txBox="1"/>
          <p:nvPr/>
        </p:nvSpPr>
        <p:spPr>
          <a:xfrm>
            <a:off x="8054664" y="205625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57775E78-92FF-7301-3F20-455862047714}"/>
              </a:ext>
            </a:extLst>
          </p:cNvPr>
          <p:cNvSpPr/>
          <p:nvPr/>
        </p:nvSpPr>
        <p:spPr>
          <a:xfrm>
            <a:off x="10915651" y="5059907"/>
            <a:ext cx="326789" cy="133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A1F62061-CB04-B550-0CDD-AF571449A74F}"/>
              </a:ext>
            </a:extLst>
          </p:cNvPr>
          <p:cNvSpPr txBox="1"/>
          <p:nvPr/>
        </p:nvSpPr>
        <p:spPr>
          <a:xfrm>
            <a:off x="11256965" y="5006335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PS15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7FCECA5D-61B7-7E8F-17C3-363EC6FBE322}"/>
              </a:ext>
            </a:extLst>
          </p:cNvPr>
          <p:cNvSpPr txBox="1"/>
          <p:nvPr/>
        </p:nvSpPr>
        <p:spPr>
          <a:xfrm>
            <a:off x="10416796" y="499620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2">
            <a:extLst>
              <a:ext uri="{FF2B5EF4-FFF2-40B4-BE49-F238E27FC236}">
                <a16:creationId xmlns:a16="http://schemas.microsoft.com/office/drawing/2014/main" id="{E72D9D27-91A6-6D80-52A0-6F158F2034B0}"/>
              </a:ext>
            </a:extLst>
          </p:cNvPr>
          <p:cNvSpPr txBox="1"/>
          <p:nvPr/>
        </p:nvSpPr>
        <p:spPr>
          <a:xfrm>
            <a:off x="236648" y="2143644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3">
            <a:extLst>
              <a:ext uri="{FF2B5EF4-FFF2-40B4-BE49-F238E27FC236}">
                <a16:creationId xmlns:a16="http://schemas.microsoft.com/office/drawing/2014/main" id="{5E728E3E-12AA-ED5B-0E18-C052F4075DDA}"/>
              </a:ext>
            </a:extLst>
          </p:cNvPr>
          <p:cNvSpPr txBox="1"/>
          <p:nvPr/>
        </p:nvSpPr>
        <p:spPr>
          <a:xfrm>
            <a:off x="345773" y="5346993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095130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FDE415-0BA3-5566-27B7-064744ABF2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4096405-F1BF-C616-DD73-46A36A35128E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4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509B920-3F98-C3B0-3F91-55DB295D64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4761" y="511968"/>
            <a:ext cx="2173510" cy="2984954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1F48941-9CBC-BF8E-A76A-C696E3C097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1783" y="705025"/>
            <a:ext cx="2173510" cy="298495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E075B61-043A-3351-1DB3-EB9C81A205F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5458" y="426165"/>
            <a:ext cx="2173510" cy="2984954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70889A1-5EA1-65E6-CDA1-F4962EA9610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2282" y="3799553"/>
            <a:ext cx="2173510" cy="298495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88CE9D0A-E183-0883-6935-036DA66B5FD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2222" y="3622852"/>
            <a:ext cx="2173510" cy="2984954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9C5F5ABE-5959-A75F-0E59-7459C238F028}"/>
              </a:ext>
            </a:extLst>
          </p:cNvPr>
          <p:cNvSpPr/>
          <p:nvPr/>
        </p:nvSpPr>
        <p:spPr>
          <a:xfrm>
            <a:off x="5859992" y="2260250"/>
            <a:ext cx="828961" cy="139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238E8C1-1125-ED13-1264-B012A89E6D5F}"/>
              </a:ext>
            </a:extLst>
          </p:cNvPr>
          <p:cNvSpPr txBox="1"/>
          <p:nvPr/>
        </p:nvSpPr>
        <p:spPr>
          <a:xfrm>
            <a:off x="6650456" y="2199452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C6B82E7-2286-11FD-4706-E8470CF33AAB}"/>
              </a:ext>
            </a:extLst>
          </p:cNvPr>
          <p:cNvSpPr txBox="1"/>
          <p:nvPr/>
        </p:nvSpPr>
        <p:spPr>
          <a:xfrm>
            <a:off x="5350635" y="2197245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F51BAD8D-EC35-4647-92C4-DA9712678BD0}"/>
              </a:ext>
            </a:extLst>
          </p:cNvPr>
          <p:cNvSpPr/>
          <p:nvPr/>
        </p:nvSpPr>
        <p:spPr>
          <a:xfrm>
            <a:off x="6437619" y="5231925"/>
            <a:ext cx="828961" cy="139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7E709C0-177B-6D64-B0B5-14CCAE0A7487}"/>
              </a:ext>
            </a:extLst>
          </p:cNvPr>
          <p:cNvSpPr txBox="1"/>
          <p:nvPr/>
        </p:nvSpPr>
        <p:spPr>
          <a:xfrm>
            <a:off x="7228083" y="5171127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ABB994C-E7E0-564E-9283-C62AD60C1BA5}"/>
              </a:ext>
            </a:extLst>
          </p:cNvPr>
          <p:cNvSpPr txBox="1"/>
          <p:nvPr/>
        </p:nvSpPr>
        <p:spPr>
          <a:xfrm>
            <a:off x="5928262" y="5168920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A45FA61E-1FF0-578C-E6DA-A5B0837E092F}"/>
              </a:ext>
            </a:extLst>
          </p:cNvPr>
          <p:cNvSpPr/>
          <p:nvPr/>
        </p:nvSpPr>
        <p:spPr>
          <a:xfrm>
            <a:off x="3676103" y="2356701"/>
            <a:ext cx="603480" cy="1793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A77B7C4-E149-645D-5CB1-D06B6DDC0CAE}"/>
              </a:ext>
            </a:extLst>
          </p:cNvPr>
          <p:cNvSpPr txBox="1"/>
          <p:nvPr/>
        </p:nvSpPr>
        <p:spPr>
          <a:xfrm>
            <a:off x="4234110" y="232613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3C73D15-9BE8-A402-9BE9-82F4B779FE94}"/>
              </a:ext>
            </a:extLst>
          </p:cNvPr>
          <p:cNvSpPr txBox="1"/>
          <p:nvPr/>
        </p:nvSpPr>
        <p:spPr>
          <a:xfrm>
            <a:off x="3232547" y="232324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8BBD94B4-D778-464B-1B88-C4B88F0A1723}"/>
              </a:ext>
            </a:extLst>
          </p:cNvPr>
          <p:cNvSpPr/>
          <p:nvPr/>
        </p:nvSpPr>
        <p:spPr>
          <a:xfrm>
            <a:off x="4153875" y="5292030"/>
            <a:ext cx="566661" cy="1247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BD99276-373D-9B14-8862-1C93D6DDDCE8}"/>
              </a:ext>
            </a:extLst>
          </p:cNvPr>
          <p:cNvSpPr txBox="1"/>
          <p:nvPr/>
        </p:nvSpPr>
        <p:spPr>
          <a:xfrm>
            <a:off x="4888755" y="5234079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C73E2B6-47CF-67D2-D317-5F8C532D759E}"/>
              </a:ext>
            </a:extLst>
          </p:cNvPr>
          <p:cNvSpPr txBox="1"/>
          <p:nvPr/>
        </p:nvSpPr>
        <p:spPr>
          <a:xfrm>
            <a:off x="3655020" y="525857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A09BA289-61B5-6B1D-9B35-0E7518CA006F}"/>
              </a:ext>
            </a:extLst>
          </p:cNvPr>
          <p:cNvSpPr/>
          <p:nvPr/>
        </p:nvSpPr>
        <p:spPr>
          <a:xfrm>
            <a:off x="8672664" y="2293509"/>
            <a:ext cx="722308" cy="2259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0B39DE6-04DE-A05A-6FE4-FC26D396B9B6}"/>
              </a:ext>
            </a:extLst>
          </p:cNvPr>
          <p:cNvSpPr txBox="1"/>
          <p:nvPr/>
        </p:nvSpPr>
        <p:spPr>
          <a:xfrm>
            <a:off x="9381286" y="2293510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985693A-5DDA-67AE-A504-20C6C6457D46}"/>
              </a:ext>
            </a:extLst>
          </p:cNvPr>
          <p:cNvSpPr txBox="1"/>
          <p:nvPr/>
        </p:nvSpPr>
        <p:spPr>
          <a:xfrm>
            <a:off x="8231582" y="229351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2">
            <a:extLst>
              <a:ext uri="{FF2B5EF4-FFF2-40B4-BE49-F238E27FC236}">
                <a16:creationId xmlns:a16="http://schemas.microsoft.com/office/drawing/2014/main" id="{83EFB905-A500-E0EB-2392-815151EC5C06}"/>
              </a:ext>
            </a:extLst>
          </p:cNvPr>
          <p:cNvSpPr txBox="1"/>
          <p:nvPr/>
        </p:nvSpPr>
        <p:spPr>
          <a:xfrm>
            <a:off x="1746784" y="2229770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3">
            <a:extLst>
              <a:ext uri="{FF2B5EF4-FFF2-40B4-BE49-F238E27FC236}">
                <a16:creationId xmlns:a16="http://schemas.microsoft.com/office/drawing/2014/main" id="{02E8B957-5A2C-AA37-E22F-70FE27B93ABF}"/>
              </a:ext>
            </a:extLst>
          </p:cNvPr>
          <p:cNvSpPr txBox="1"/>
          <p:nvPr/>
        </p:nvSpPr>
        <p:spPr>
          <a:xfrm>
            <a:off x="1805414" y="4806102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499196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0FFAC7B-468B-376A-74CE-76A5F4CC8AF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9AFBD62-6BEE-9A97-515C-6A9545485BAC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4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451134B-A6D1-85BF-B30A-193CE0C37E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57419">
            <a:off x="1560962" y="198993"/>
            <a:ext cx="2464090" cy="338401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F74DBF4-24ED-F919-984D-FBA34D2D525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28500">
            <a:off x="4267690" y="175670"/>
            <a:ext cx="2464090" cy="3384018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0E16B6D-F0A6-9572-C92D-7E438BEAB3D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5223" y="0"/>
            <a:ext cx="2464090" cy="3384018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815B3798-21BE-2523-D706-D78C1607AA5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57440" y="74015"/>
            <a:ext cx="2464090" cy="3384018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3346A558-BC4B-E0A0-A9BA-A78B36EA13C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20085">
            <a:off x="7569523" y="3382197"/>
            <a:ext cx="2464090" cy="3384018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C9078561-6472-A2E1-4EF7-DF06AA7A4C8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0419" y="3473983"/>
            <a:ext cx="2464090" cy="3384018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BC75A7AA-9AC2-A93E-419D-648B7CA4D56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5486" y="3388707"/>
            <a:ext cx="2464090" cy="3384018"/>
          </a:xfrm>
          <a:prstGeom prst="rect">
            <a:avLst/>
          </a:prstGeom>
        </p:spPr>
      </p:pic>
      <p:sp>
        <p:nvSpPr>
          <p:cNvPr id="34" name="文本框 2">
            <a:extLst>
              <a:ext uri="{FF2B5EF4-FFF2-40B4-BE49-F238E27FC236}">
                <a16:creationId xmlns:a16="http://schemas.microsoft.com/office/drawing/2014/main" id="{83EFB905-A500-E0EB-2392-815151EC5C06}"/>
              </a:ext>
            </a:extLst>
          </p:cNvPr>
          <p:cNvSpPr txBox="1"/>
          <p:nvPr/>
        </p:nvSpPr>
        <p:spPr>
          <a:xfrm>
            <a:off x="1184742" y="2152111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">
            <a:extLst>
              <a:ext uri="{FF2B5EF4-FFF2-40B4-BE49-F238E27FC236}">
                <a16:creationId xmlns:a16="http://schemas.microsoft.com/office/drawing/2014/main" id="{02E8B957-5A2C-AA37-E22F-70FE27B93ABF}"/>
              </a:ext>
            </a:extLst>
          </p:cNvPr>
          <p:cNvSpPr txBox="1"/>
          <p:nvPr/>
        </p:nvSpPr>
        <p:spPr>
          <a:xfrm>
            <a:off x="1210561" y="5165992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F5738936-4D49-2DE9-CF4E-066F9B6D9682}"/>
              </a:ext>
            </a:extLst>
          </p:cNvPr>
          <p:cNvSpPr/>
          <p:nvPr/>
        </p:nvSpPr>
        <p:spPr>
          <a:xfrm>
            <a:off x="2648211" y="2265511"/>
            <a:ext cx="678666" cy="14164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7" name="文本框 17">
            <a:extLst>
              <a:ext uri="{FF2B5EF4-FFF2-40B4-BE49-F238E27FC236}">
                <a16:creationId xmlns:a16="http://schemas.microsoft.com/office/drawing/2014/main" id="{A253F711-4CBD-07A9-E550-2B57AA2890FE}"/>
              </a:ext>
            </a:extLst>
          </p:cNvPr>
          <p:cNvSpPr txBox="1"/>
          <p:nvPr/>
        </p:nvSpPr>
        <p:spPr>
          <a:xfrm>
            <a:off x="3273498" y="2209375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25">
            <a:extLst>
              <a:ext uri="{FF2B5EF4-FFF2-40B4-BE49-F238E27FC236}">
                <a16:creationId xmlns:a16="http://schemas.microsoft.com/office/drawing/2014/main" id="{E47C3C96-7A17-9336-2353-E135B754C2CB}"/>
              </a:ext>
            </a:extLst>
          </p:cNvPr>
          <p:cNvSpPr txBox="1"/>
          <p:nvPr/>
        </p:nvSpPr>
        <p:spPr>
          <a:xfrm>
            <a:off x="2202161" y="2209375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4D7F25A6-7A79-6FCE-3D95-4E072FF25DD1}"/>
              </a:ext>
            </a:extLst>
          </p:cNvPr>
          <p:cNvSpPr/>
          <p:nvPr/>
        </p:nvSpPr>
        <p:spPr>
          <a:xfrm>
            <a:off x="5221065" y="1983229"/>
            <a:ext cx="721068" cy="154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40" name="文本框 17">
            <a:extLst>
              <a:ext uri="{FF2B5EF4-FFF2-40B4-BE49-F238E27FC236}">
                <a16:creationId xmlns:a16="http://schemas.microsoft.com/office/drawing/2014/main" id="{D0D15E2E-ACC9-D281-5751-53045862F668}"/>
              </a:ext>
            </a:extLst>
          </p:cNvPr>
          <p:cNvSpPr txBox="1"/>
          <p:nvPr/>
        </p:nvSpPr>
        <p:spPr>
          <a:xfrm>
            <a:off x="5887558" y="1914337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25">
            <a:extLst>
              <a:ext uri="{FF2B5EF4-FFF2-40B4-BE49-F238E27FC236}">
                <a16:creationId xmlns:a16="http://schemas.microsoft.com/office/drawing/2014/main" id="{1B8FE926-930B-ADD1-CCE3-4E1D29B66E61}"/>
              </a:ext>
            </a:extLst>
          </p:cNvPr>
          <p:cNvSpPr txBox="1"/>
          <p:nvPr/>
        </p:nvSpPr>
        <p:spPr>
          <a:xfrm>
            <a:off x="4715423" y="1933453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7AB81C3A-1B32-AE14-0CE8-424654BD4C5C}"/>
              </a:ext>
            </a:extLst>
          </p:cNvPr>
          <p:cNvSpPr/>
          <p:nvPr/>
        </p:nvSpPr>
        <p:spPr>
          <a:xfrm>
            <a:off x="10409129" y="1810176"/>
            <a:ext cx="761671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43" name="文本框 17">
            <a:extLst>
              <a:ext uri="{FF2B5EF4-FFF2-40B4-BE49-F238E27FC236}">
                <a16:creationId xmlns:a16="http://schemas.microsoft.com/office/drawing/2014/main" id="{546CA906-DF6E-6565-113B-9FAB06EF3F25}"/>
              </a:ext>
            </a:extLst>
          </p:cNvPr>
          <p:cNvSpPr txBox="1"/>
          <p:nvPr/>
        </p:nvSpPr>
        <p:spPr>
          <a:xfrm>
            <a:off x="11141932" y="1810175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25">
            <a:extLst>
              <a:ext uri="{FF2B5EF4-FFF2-40B4-BE49-F238E27FC236}">
                <a16:creationId xmlns:a16="http://schemas.microsoft.com/office/drawing/2014/main" id="{150351AF-827D-566F-DAE6-B424F8B0670E}"/>
              </a:ext>
            </a:extLst>
          </p:cNvPr>
          <p:cNvSpPr txBox="1"/>
          <p:nvPr/>
        </p:nvSpPr>
        <p:spPr>
          <a:xfrm>
            <a:off x="9968483" y="181017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431789A8-24A1-864F-C9FB-B1BBF2C181AC}"/>
              </a:ext>
            </a:extLst>
          </p:cNvPr>
          <p:cNvSpPr/>
          <p:nvPr/>
        </p:nvSpPr>
        <p:spPr>
          <a:xfrm>
            <a:off x="2524126" y="5319687"/>
            <a:ext cx="671512" cy="1428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46" name="文本框 17">
            <a:extLst>
              <a:ext uri="{FF2B5EF4-FFF2-40B4-BE49-F238E27FC236}">
                <a16:creationId xmlns:a16="http://schemas.microsoft.com/office/drawing/2014/main" id="{7AF8818C-87E9-C1D0-CE0A-1AB01A76799B}"/>
              </a:ext>
            </a:extLst>
          </p:cNvPr>
          <p:cNvSpPr txBox="1"/>
          <p:nvPr/>
        </p:nvSpPr>
        <p:spPr>
          <a:xfrm>
            <a:off x="3147600" y="5267985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25">
            <a:extLst>
              <a:ext uri="{FF2B5EF4-FFF2-40B4-BE49-F238E27FC236}">
                <a16:creationId xmlns:a16="http://schemas.microsoft.com/office/drawing/2014/main" id="{F4213B9B-347E-CF00-5C4E-499D7728467F}"/>
              </a:ext>
            </a:extLst>
          </p:cNvPr>
          <p:cNvSpPr txBox="1"/>
          <p:nvPr/>
        </p:nvSpPr>
        <p:spPr>
          <a:xfrm>
            <a:off x="2071562" y="5281408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id="{65A7A7B2-2D6B-16E9-F394-0B4AFD535A24}"/>
              </a:ext>
            </a:extLst>
          </p:cNvPr>
          <p:cNvSpPr/>
          <p:nvPr/>
        </p:nvSpPr>
        <p:spPr>
          <a:xfrm>
            <a:off x="7992203" y="1827352"/>
            <a:ext cx="648893" cy="1084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52" name="文本框 17">
            <a:extLst>
              <a:ext uri="{FF2B5EF4-FFF2-40B4-BE49-F238E27FC236}">
                <a16:creationId xmlns:a16="http://schemas.microsoft.com/office/drawing/2014/main" id="{1F034BBE-1429-9FA1-2EAA-DD9C45AD21E3}"/>
              </a:ext>
            </a:extLst>
          </p:cNvPr>
          <p:cNvSpPr txBox="1"/>
          <p:nvPr/>
        </p:nvSpPr>
        <p:spPr>
          <a:xfrm>
            <a:off x="8585405" y="1764203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25">
            <a:extLst>
              <a:ext uri="{FF2B5EF4-FFF2-40B4-BE49-F238E27FC236}">
                <a16:creationId xmlns:a16="http://schemas.microsoft.com/office/drawing/2014/main" id="{56769CE7-3F4F-ADE0-5A45-ED0B421B2C4C}"/>
              </a:ext>
            </a:extLst>
          </p:cNvPr>
          <p:cNvSpPr txBox="1"/>
          <p:nvPr/>
        </p:nvSpPr>
        <p:spPr>
          <a:xfrm>
            <a:off x="7481755" y="1765774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56EFFAAB-6172-4095-2817-3C6D855327E6}"/>
              </a:ext>
            </a:extLst>
          </p:cNvPr>
          <p:cNvSpPr/>
          <p:nvPr/>
        </p:nvSpPr>
        <p:spPr>
          <a:xfrm>
            <a:off x="8651241" y="4586114"/>
            <a:ext cx="648970" cy="1478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55" name="文本框 17">
            <a:extLst>
              <a:ext uri="{FF2B5EF4-FFF2-40B4-BE49-F238E27FC236}">
                <a16:creationId xmlns:a16="http://schemas.microsoft.com/office/drawing/2014/main" id="{7ECE28F2-7C54-8FCB-FDC9-FC2154F64E52}"/>
              </a:ext>
            </a:extLst>
          </p:cNvPr>
          <p:cNvSpPr txBox="1"/>
          <p:nvPr/>
        </p:nvSpPr>
        <p:spPr>
          <a:xfrm>
            <a:off x="9269429" y="4532309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25">
            <a:extLst>
              <a:ext uri="{FF2B5EF4-FFF2-40B4-BE49-F238E27FC236}">
                <a16:creationId xmlns:a16="http://schemas.microsoft.com/office/drawing/2014/main" id="{64CE4357-24F6-4E7A-38B3-DFBCEF9DC782}"/>
              </a:ext>
            </a:extLst>
          </p:cNvPr>
          <p:cNvSpPr txBox="1"/>
          <p:nvPr/>
        </p:nvSpPr>
        <p:spPr>
          <a:xfrm>
            <a:off x="8111650" y="4522081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3CDB284E-26C6-2070-054F-A10EA00C2E3B}"/>
              </a:ext>
            </a:extLst>
          </p:cNvPr>
          <p:cNvSpPr/>
          <p:nvPr/>
        </p:nvSpPr>
        <p:spPr>
          <a:xfrm>
            <a:off x="5349241" y="5059681"/>
            <a:ext cx="693110" cy="1375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58" name="文本框 17">
            <a:extLst>
              <a:ext uri="{FF2B5EF4-FFF2-40B4-BE49-F238E27FC236}">
                <a16:creationId xmlns:a16="http://schemas.microsoft.com/office/drawing/2014/main" id="{69E09C9C-C310-E1BC-3C85-1C2883BF7ADF}"/>
              </a:ext>
            </a:extLst>
          </p:cNvPr>
          <p:cNvSpPr txBox="1"/>
          <p:nvPr/>
        </p:nvSpPr>
        <p:spPr>
          <a:xfrm>
            <a:off x="6011569" y="5003192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25">
            <a:extLst>
              <a:ext uri="{FF2B5EF4-FFF2-40B4-BE49-F238E27FC236}">
                <a16:creationId xmlns:a16="http://schemas.microsoft.com/office/drawing/2014/main" id="{0931C5BB-C711-9247-FA3C-69FA249F3984}"/>
              </a:ext>
            </a:extLst>
          </p:cNvPr>
          <p:cNvSpPr txBox="1"/>
          <p:nvPr/>
        </p:nvSpPr>
        <p:spPr>
          <a:xfrm>
            <a:off x="4746004" y="4991058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1183036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C3FF462-CA22-EABC-3A7F-E694481C535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65B6A9A-A730-FF29-0E96-74D85447BB8B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6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1E2CE1A-79FD-1E28-DA08-7F57BC0531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671" y="549275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CE556014-1B20-E229-1AFA-695B8B4108C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1877" y="549275"/>
            <a:ext cx="3014505" cy="413992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645D7B3-F449-4261-4DF9-3E21980000F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5716" y="529232"/>
            <a:ext cx="3014505" cy="4139921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CC7A9AAA-A70B-57DD-C19B-179DE904FC6B}"/>
              </a:ext>
            </a:extLst>
          </p:cNvPr>
          <p:cNvSpPr/>
          <p:nvPr/>
        </p:nvSpPr>
        <p:spPr>
          <a:xfrm>
            <a:off x="1207460" y="2399321"/>
            <a:ext cx="828961" cy="1397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2449597-F44B-E5A2-151F-A19AE60A7A5E}"/>
              </a:ext>
            </a:extLst>
          </p:cNvPr>
          <p:cNvSpPr txBox="1"/>
          <p:nvPr/>
        </p:nvSpPr>
        <p:spPr>
          <a:xfrm>
            <a:off x="1979235" y="2276210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E2CE13C-F031-6108-9A43-47EF6779DE4D}"/>
              </a:ext>
            </a:extLst>
          </p:cNvPr>
          <p:cNvSpPr txBox="1"/>
          <p:nvPr/>
        </p:nvSpPr>
        <p:spPr>
          <a:xfrm>
            <a:off x="698103" y="2336316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DB45A47B-F546-58BD-1B1A-E06E190D9098}"/>
              </a:ext>
            </a:extLst>
          </p:cNvPr>
          <p:cNvSpPr/>
          <p:nvPr/>
        </p:nvSpPr>
        <p:spPr>
          <a:xfrm>
            <a:off x="8613548" y="2276210"/>
            <a:ext cx="1085152" cy="221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2FCC330-CED1-81CE-5947-E78FCD366331}"/>
              </a:ext>
            </a:extLst>
          </p:cNvPr>
          <p:cNvSpPr txBox="1"/>
          <p:nvPr/>
        </p:nvSpPr>
        <p:spPr>
          <a:xfrm>
            <a:off x="9669026" y="2301273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964AB41-7F19-AFC2-15DA-571542D6A84C}"/>
              </a:ext>
            </a:extLst>
          </p:cNvPr>
          <p:cNvSpPr txBox="1"/>
          <p:nvPr/>
        </p:nvSpPr>
        <p:spPr>
          <a:xfrm>
            <a:off x="8155716" y="225777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E5B2AE8-0C03-E9DB-8603-BFAF23018AD1}"/>
              </a:ext>
            </a:extLst>
          </p:cNvPr>
          <p:cNvSpPr txBox="1"/>
          <p:nvPr/>
        </p:nvSpPr>
        <p:spPr>
          <a:xfrm>
            <a:off x="5535834" y="1898718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25">
            <a:extLst>
              <a:ext uri="{FF2B5EF4-FFF2-40B4-BE49-F238E27FC236}">
                <a16:creationId xmlns:a16="http://schemas.microsoft.com/office/drawing/2014/main" id="{0AF9E1C8-675E-FE0A-5D7D-DD6530286BA0}"/>
              </a:ext>
            </a:extLst>
          </p:cNvPr>
          <p:cNvSpPr txBox="1"/>
          <p:nvPr/>
        </p:nvSpPr>
        <p:spPr>
          <a:xfrm>
            <a:off x="3907645" y="189576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AF8195B6-5E76-7FE8-FB55-3D946F6D1EF8}"/>
              </a:ext>
            </a:extLst>
          </p:cNvPr>
          <p:cNvSpPr/>
          <p:nvPr/>
        </p:nvSpPr>
        <p:spPr>
          <a:xfrm>
            <a:off x="4355178" y="1908856"/>
            <a:ext cx="1098519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367673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120B63B-3802-3EF8-D7E1-2F73637E830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BAD254D-621D-680C-16EF-9E34F18623D9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6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E556014-1B20-E229-1AFA-695B8B4108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0203" y="861950"/>
            <a:ext cx="3014505" cy="413992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5645D7B3-F449-4261-4DF9-3E21980000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4170" y="861950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FCD39FB-2C73-E2D6-AD16-0738FB79D30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576" y="745348"/>
            <a:ext cx="3014505" cy="4139921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9797E6ED-8CDD-ACD0-F5BF-203E96C2FA74}"/>
              </a:ext>
            </a:extLst>
          </p:cNvPr>
          <p:cNvSpPr/>
          <p:nvPr/>
        </p:nvSpPr>
        <p:spPr>
          <a:xfrm>
            <a:off x="10241951" y="2583285"/>
            <a:ext cx="1085152" cy="221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8" name="文本框 12">
            <a:extLst>
              <a:ext uri="{FF2B5EF4-FFF2-40B4-BE49-F238E27FC236}">
                <a16:creationId xmlns:a16="http://schemas.microsoft.com/office/drawing/2014/main" id="{3F8310EA-35B4-F377-30D8-DF1D538DADFF}"/>
              </a:ext>
            </a:extLst>
          </p:cNvPr>
          <p:cNvSpPr txBox="1"/>
          <p:nvPr/>
        </p:nvSpPr>
        <p:spPr>
          <a:xfrm>
            <a:off x="11300911" y="2583285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13">
            <a:extLst>
              <a:ext uri="{FF2B5EF4-FFF2-40B4-BE49-F238E27FC236}">
                <a16:creationId xmlns:a16="http://schemas.microsoft.com/office/drawing/2014/main" id="{C903151C-814D-3D22-15B0-161C671C29BE}"/>
              </a:ext>
            </a:extLst>
          </p:cNvPr>
          <p:cNvSpPr txBox="1"/>
          <p:nvPr/>
        </p:nvSpPr>
        <p:spPr>
          <a:xfrm>
            <a:off x="9794048" y="256908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17">
            <a:extLst>
              <a:ext uri="{FF2B5EF4-FFF2-40B4-BE49-F238E27FC236}">
                <a16:creationId xmlns:a16="http://schemas.microsoft.com/office/drawing/2014/main" id="{8FE1FA10-6C1E-674E-C705-2D3412BF4284}"/>
              </a:ext>
            </a:extLst>
          </p:cNvPr>
          <p:cNvSpPr txBox="1"/>
          <p:nvPr/>
        </p:nvSpPr>
        <p:spPr>
          <a:xfrm>
            <a:off x="7125136" y="2163255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25">
            <a:extLst>
              <a:ext uri="{FF2B5EF4-FFF2-40B4-BE49-F238E27FC236}">
                <a16:creationId xmlns:a16="http://schemas.microsoft.com/office/drawing/2014/main" id="{637965C5-CA72-AE76-A6EA-D67B1C6D1736}"/>
              </a:ext>
            </a:extLst>
          </p:cNvPr>
          <p:cNvSpPr txBox="1"/>
          <p:nvPr/>
        </p:nvSpPr>
        <p:spPr>
          <a:xfrm>
            <a:off x="5579084" y="216819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FDDC59FF-54B6-DF2A-E70D-02C105AF33F8}"/>
              </a:ext>
            </a:extLst>
          </p:cNvPr>
          <p:cNvSpPr/>
          <p:nvPr/>
        </p:nvSpPr>
        <p:spPr>
          <a:xfrm>
            <a:off x="6026617" y="2181284"/>
            <a:ext cx="1098519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5" name="文本框 17">
            <a:extLst>
              <a:ext uri="{FF2B5EF4-FFF2-40B4-BE49-F238E27FC236}">
                <a16:creationId xmlns:a16="http://schemas.microsoft.com/office/drawing/2014/main" id="{E4F53514-A9B9-E97E-CA0C-A4F8C7C2C7A2}"/>
              </a:ext>
            </a:extLst>
          </p:cNvPr>
          <p:cNvSpPr txBox="1"/>
          <p:nvPr/>
        </p:nvSpPr>
        <p:spPr>
          <a:xfrm>
            <a:off x="3175250" y="2427505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51</a:t>
            </a:r>
          </a:p>
        </p:txBody>
      </p:sp>
      <p:sp>
        <p:nvSpPr>
          <p:cNvPr id="13" name="文本框 25">
            <a:extLst>
              <a:ext uri="{FF2B5EF4-FFF2-40B4-BE49-F238E27FC236}">
                <a16:creationId xmlns:a16="http://schemas.microsoft.com/office/drawing/2014/main" id="{7BA19584-19B3-CE1A-7238-B50CB5FFF4EE}"/>
              </a:ext>
            </a:extLst>
          </p:cNvPr>
          <p:cNvSpPr txBox="1"/>
          <p:nvPr/>
        </p:nvSpPr>
        <p:spPr>
          <a:xfrm>
            <a:off x="1629198" y="243244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2E30D53E-4167-0888-C44B-D195D2E930B5}"/>
              </a:ext>
            </a:extLst>
          </p:cNvPr>
          <p:cNvSpPr/>
          <p:nvPr/>
        </p:nvSpPr>
        <p:spPr>
          <a:xfrm>
            <a:off x="2076731" y="2445534"/>
            <a:ext cx="1098519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372698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05C2BAA-645A-53D7-43D8-4E8BA84927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5266955-91BC-DA05-1128-1D85435F3F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7320" y="1776745"/>
            <a:ext cx="2266065" cy="3112063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BD33B8E9-C1D9-A0B8-A416-851A74C6A40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1053" y="1583227"/>
            <a:ext cx="2266065" cy="3112063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86AEDAB5-797F-8365-902E-6ED9A6DB970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1291" y="1583227"/>
            <a:ext cx="2266065" cy="3112063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13E4284E-837B-BBE6-8B6F-2355338118B7}"/>
              </a:ext>
            </a:extLst>
          </p:cNvPr>
          <p:cNvSpPr txBox="1"/>
          <p:nvPr/>
        </p:nvSpPr>
        <p:spPr>
          <a:xfrm>
            <a:off x="3496960" y="2948056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5">
            <a:extLst>
              <a:ext uri="{FF2B5EF4-FFF2-40B4-BE49-F238E27FC236}">
                <a16:creationId xmlns:a16="http://schemas.microsoft.com/office/drawing/2014/main" id="{20A4E80A-272D-981E-0683-283B258AF685}"/>
              </a:ext>
            </a:extLst>
          </p:cNvPr>
          <p:cNvSpPr txBox="1"/>
          <p:nvPr/>
        </p:nvSpPr>
        <p:spPr>
          <a:xfrm>
            <a:off x="2402090" y="2950072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3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ACCFAA6-9F67-3E70-4F2E-2F0BCC3B62C6}"/>
              </a:ext>
            </a:extLst>
          </p:cNvPr>
          <p:cNvSpPr txBox="1"/>
          <p:nvPr/>
        </p:nvSpPr>
        <p:spPr>
          <a:xfrm>
            <a:off x="6494033" y="3245028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3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5">
            <a:extLst>
              <a:ext uri="{FF2B5EF4-FFF2-40B4-BE49-F238E27FC236}">
                <a16:creationId xmlns:a16="http://schemas.microsoft.com/office/drawing/2014/main" id="{8AFD6090-CEDC-69C5-BCFE-9783C38CCB7D}"/>
              </a:ext>
            </a:extLst>
          </p:cNvPr>
          <p:cNvSpPr txBox="1"/>
          <p:nvPr/>
        </p:nvSpPr>
        <p:spPr>
          <a:xfrm>
            <a:off x="5378550" y="325043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7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13A2ADA6-0FD5-FFAA-6D6B-DD356409A306}"/>
              </a:ext>
            </a:extLst>
          </p:cNvPr>
          <p:cNvSpPr txBox="1"/>
          <p:nvPr/>
        </p:nvSpPr>
        <p:spPr>
          <a:xfrm>
            <a:off x="8658155" y="3194277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25">
            <a:extLst>
              <a:ext uri="{FF2B5EF4-FFF2-40B4-BE49-F238E27FC236}">
                <a16:creationId xmlns:a16="http://schemas.microsoft.com/office/drawing/2014/main" id="{CD6ACFF8-56AA-4905-5468-6CD1B8369E37}"/>
              </a:ext>
            </a:extLst>
          </p:cNvPr>
          <p:cNvSpPr txBox="1"/>
          <p:nvPr/>
        </p:nvSpPr>
        <p:spPr>
          <a:xfrm>
            <a:off x="7634727" y="320581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5E235267-081E-2196-6C17-0A7D4FD5FB73}"/>
              </a:ext>
            </a:extLst>
          </p:cNvPr>
          <p:cNvSpPr txBox="1"/>
          <p:nvPr/>
        </p:nvSpPr>
        <p:spPr>
          <a:xfrm>
            <a:off x="3491195" y="3077235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PARP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F30F184-5EEE-B393-1AC8-9A7F7981AD15}"/>
              </a:ext>
            </a:extLst>
          </p:cNvPr>
          <p:cNvSpPr txBox="1"/>
          <p:nvPr/>
        </p:nvSpPr>
        <p:spPr>
          <a:xfrm>
            <a:off x="2130364" y="903965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19CFE0E9-8F85-2884-A5B9-475A5DA5115F}"/>
              </a:ext>
            </a:extLst>
          </p:cNvPr>
          <p:cNvSpPr/>
          <p:nvPr/>
        </p:nvSpPr>
        <p:spPr>
          <a:xfrm>
            <a:off x="2896010" y="3001145"/>
            <a:ext cx="664414" cy="2900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F6B3C223-2E24-59BB-0885-13BC0114E3CB}"/>
              </a:ext>
            </a:extLst>
          </p:cNvPr>
          <p:cNvSpPr/>
          <p:nvPr/>
        </p:nvSpPr>
        <p:spPr>
          <a:xfrm>
            <a:off x="5806792" y="3308335"/>
            <a:ext cx="687331" cy="1514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DA1A6D57-4EEC-E9EE-FD95-FA87BDF4B957}"/>
              </a:ext>
            </a:extLst>
          </p:cNvPr>
          <p:cNvSpPr/>
          <p:nvPr/>
        </p:nvSpPr>
        <p:spPr>
          <a:xfrm>
            <a:off x="8063851" y="3250433"/>
            <a:ext cx="656593" cy="1514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" name="文本框 25">
            <a:extLst>
              <a:ext uri="{FF2B5EF4-FFF2-40B4-BE49-F238E27FC236}">
                <a16:creationId xmlns:a16="http://schemas.microsoft.com/office/drawing/2014/main" id="{D9D34008-DAF8-61CD-968D-56462A822580}"/>
              </a:ext>
            </a:extLst>
          </p:cNvPr>
          <p:cNvSpPr txBox="1"/>
          <p:nvPr/>
        </p:nvSpPr>
        <p:spPr>
          <a:xfrm>
            <a:off x="2473524" y="308818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9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00544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1E57B6-D27C-06C7-8965-7D3E4B247FC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8D0B74A-D170-D5B7-479B-36DA362ABA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53" y="1454822"/>
            <a:ext cx="3014505" cy="413992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2DAA6B43-6404-DC8D-2F5C-661165ECEB4C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7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541EB5F-C3C6-0D26-8EE5-B858971BD40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8776" y="1359039"/>
            <a:ext cx="3014505" cy="413992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C003F2F-5CE3-2C05-3C9D-EE399C2FDE1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8597" y="1567694"/>
            <a:ext cx="3014505" cy="4139921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FA56B2E4-7206-4CB4-BFE5-9012AF3A8031}"/>
              </a:ext>
            </a:extLst>
          </p:cNvPr>
          <p:cNvSpPr/>
          <p:nvPr/>
        </p:nvSpPr>
        <p:spPr>
          <a:xfrm>
            <a:off x="8885591" y="3480818"/>
            <a:ext cx="1418286" cy="2193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8E57C2B-A1BF-9116-DA6F-92F33EA4BA25}"/>
              </a:ext>
            </a:extLst>
          </p:cNvPr>
          <p:cNvSpPr txBox="1"/>
          <p:nvPr/>
        </p:nvSpPr>
        <p:spPr>
          <a:xfrm>
            <a:off x="10243428" y="3464340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A703F3A-E322-1773-9EAD-4AD6EA4EBBC2}"/>
              </a:ext>
            </a:extLst>
          </p:cNvPr>
          <p:cNvSpPr txBox="1"/>
          <p:nvPr/>
        </p:nvSpPr>
        <p:spPr>
          <a:xfrm>
            <a:off x="8410697" y="3480818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1DE3794C-6638-600D-6B2E-DAA0E3845E17}"/>
              </a:ext>
            </a:extLst>
          </p:cNvPr>
          <p:cNvSpPr/>
          <p:nvPr/>
        </p:nvSpPr>
        <p:spPr>
          <a:xfrm>
            <a:off x="5241857" y="3557942"/>
            <a:ext cx="1403568" cy="1946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DCC721B-80E5-DA24-C034-EB9DA48BC546}"/>
              </a:ext>
            </a:extLst>
          </p:cNvPr>
          <p:cNvSpPr txBox="1"/>
          <p:nvPr/>
        </p:nvSpPr>
        <p:spPr>
          <a:xfrm>
            <a:off x="6645425" y="3524783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FκB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0F0973A-C22A-8DD5-1C27-F45769A1CD14}"/>
              </a:ext>
            </a:extLst>
          </p:cNvPr>
          <p:cNvSpPr txBox="1"/>
          <p:nvPr/>
        </p:nvSpPr>
        <p:spPr>
          <a:xfrm>
            <a:off x="4766963" y="352478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2C0C937A-8758-0CA2-B8D5-3EAA4A9AF6E4}"/>
              </a:ext>
            </a:extLst>
          </p:cNvPr>
          <p:cNvSpPr/>
          <p:nvPr/>
        </p:nvSpPr>
        <p:spPr>
          <a:xfrm>
            <a:off x="1555200" y="3524784"/>
            <a:ext cx="1332675" cy="2462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55D9354-F917-64D5-3C2E-9EF1F396A782}"/>
              </a:ext>
            </a:extLst>
          </p:cNvPr>
          <p:cNvSpPr txBox="1"/>
          <p:nvPr/>
        </p:nvSpPr>
        <p:spPr>
          <a:xfrm>
            <a:off x="2837539" y="3524784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zh-CN" sz="10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FκB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5ECCE13-1373-54E6-8537-EF16D1E4B9E6}"/>
              </a:ext>
            </a:extLst>
          </p:cNvPr>
          <p:cNvSpPr txBox="1"/>
          <p:nvPr/>
        </p:nvSpPr>
        <p:spPr>
          <a:xfrm>
            <a:off x="1080306" y="347321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19634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2000D09-4E1E-3981-23AE-9E485C6E6BD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405C77A-0248-6A3F-81F5-8FC9BA02095E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7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8F39A60-95CB-C3FE-F9DC-F1B9384816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8840" y="1279260"/>
            <a:ext cx="2428907" cy="333569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78DEF280-C517-1ED7-7AA9-047B3E2E9D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1631" y="1293605"/>
            <a:ext cx="2428907" cy="333569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CAA9FCD-D485-A267-24C3-469D9BF0FF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2990" y="1437426"/>
            <a:ext cx="2428907" cy="333569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4C620CA8-AD10-971C-5FAF-E5B39ACBD2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4083" y="1215217"/>
            <a:ext cx="2428907" cy="333569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514D58FC-F572-A899-4B5B-30776422E0F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99" y="1532366"/>
            <a:ext cx="2428907" cy="3335699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CE6790D5-72E6-65FA-F256-D8F387ADF511}"/>
              </a:ext>
            </a:extLst>
          </p:cNvPr>
          <p:cNvSpPr/>
          <p:nvPr/>
        </p:nvSpPr>
        <p:spPr>
          <a:xfrm>
            <a:off x="10572749" y="2842578"/>
            <a:ext cx="833727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3F4F10D-9095-A163-FF25-42405BBB9204}"/>
              </a:ext>
            </a:extLst>
          </p:cNvPr>
          <p:cNvSpPr txBox="1"/>
          <p:nvPr/>
        </p:nvSpPr>
        <p:spPr>
          <a:xfrm>
            <a:off x="11346028" y="2826101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3921DC2-55D6-3FDF-5FB0-16F7BAA4D6B1}"/>
              </a:ext>
            </a:extLst>
          </p:cNvPr>
          <p:cNvSpPr txBox="1"/>
          <p:nvPr/>
        </p:nvSpPr>
        <p:spPr>
          <a:xfrm>
            <a:off x="10117942" y="2859055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230A906D-FA47-9ED7-91B4-3FD9CD0641C7}"/>
              </a:ext>
            </a:extLst>
          </p:cNvPr>
          <p:cNvSpPr/>
          <p:nvPr/>
        </p:nvSpPr>
        <p:spPr>
          <a:xfrm>
            <a:off x="3335858" y="2961455"/>
            <a:ext cx="870822" cy="2130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5194637-E623-12ED-4C3B-D57BC83D4072}"/>
              </a:ext>
            </a:extLst>
          </p:cNvPr>
          <p:cNvSpPr txBox="1"/>
          <p:nvPr/>
        </p:nvSpPr>
        <p:spPr>
          <a:xfrm>
            <a:off x="4206047" y="2944978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IN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72789EC-D89A-0990-29CF-EA898AE78BCD}"/>
              </a:ext>
            </a:extLst>
          </p:cNvPr>
          <p:cNvSpPr txBox="1"/>
          <p:nvPr/>
        </p:nvSpPr>
        <p:spPr>
          <a:xfrm>
            <a:off x="2860964" y="292829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742B0957-4F5B-3F1D-32D8-000DE032CBEA}"/>
              </a:ext>
            </a:extLst>
          </p:cNvPr>
          <p:cNvSpPr/>
          <p:nvPr/>
        </p:nvSpPr>
        <p:spPr>
          <a:xfrm>
            <a:off x="1064218" y="2927518"/>
            <a:ext cx="754287" cy="2387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07460FE-C5B1-070D-E68C-6A27AC630CEF}"/>
              </a:ext>
            </a:extLst>
          </p:cNvPr>
          <p:cNvSpPr txBox="1"/>
          <p:nvPr/>
        </p:nvSpPr>
        <p:spPr>
          <a:xfrm>
            <a:off x="1916444" y="2920057"/>
            <a:ext cx="6703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STIN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D062B5C6-C56A-B660-5CC8-CFB4F51A56F0}"/>
              </a:ext>
            </a:extLst>
          </p:cNvPr>
          <p:cNvSpPr txBox="1"/>
          <p:nvPr/>
        </p:nvSpPr>
        <p:spPr>
          <a:xfrm>
            <a:off x="394793" y="2927518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B4198041-16D1-0BB4-B5C2-6B2514178047}"/>
              </a:ext>
            </a:extLst>
          </p:cNvPr>
          <p:cNvSpPr/>
          <p:nvPr/>
        </p:nvSpPr>
        <p:spPr>
          <a:xfrm>
            <a:off x="8465414" y="2889937"/>
            <a:ext cx="754287" cy="2387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A59F802-989D-50E5-CCC9-465439BF8422}"/>
              </a:ext>
            </a:extLst>
          </p:cNvPr>
          <p:cNvSpPr txBox="1"/>
          <p:nvPr/>
        </p:nvSpPr>
        <p:spPr>
          <a:xfrm>
            <a:off x="9274354" y="2878834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F36104B-28C5-261E-DA4B-071D31B72572}"/>
              </a:ext>
            </a:extLst>
          </p:cNvPr>
          <p:cNvSpPr txBox="1"/>
          <p:nvPr/>
        </p:nvSpPr>
        <p:spPr>
          <a:xfrm>
            <a:off x="7982123" y="288993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FF7666A0-DA85-501C-4795-B301A2969841}"/>
              </a:ext>
            </a:extLst>
          </p:cNvPr>
          <p:cNvSpPr/>
          <p:nvPr/>
        </p:nvSpPr>
        <p:spPr>
          <a:xfrm>
            <a:off x="5978227" y="2981597"/>
            <a:ext cx="754287" cy="2387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96BA1A6-C0B3-BC37-5848-C3167FE0572F}"/>
              </a:ext>
            </a:extLst>
          </p:cNvPr>
          <p:cNvSpPr txBox="1"/>
          <p:nvPr/>
        </p:nvSpPr>
        <p:spPr>
          <a:xfrm>
            <a:off x="6787167" y="2970494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IRF3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4A81376-C3C2-1F82-1620-F07DE68F2B8E}"/>
              </a:ext>
            </a:extLst>
          </p:cNvPr>
          <p:cNvSpPr txBox="1"/>
          <p:nvPr/>
        </p:nvSpPr>
        <p:spPr>
          <a:xfrm>
            <a:off x="5494936" y="298159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826675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E8D7668-2195-7654-5C83-DAAA21D60C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68295F5-3DF7-8ADF-D5DC-0CF477E39DED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7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688B646-C91F-F601-3486-2A5A18CC59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0999" y="941729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81205D5-D6E1-8750-F54C-0C7DE648ACF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1534" y="940194"/>
            <a:ext cx="3014505" cy="4139921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A45FA61E-1FF0-578C-E6DA-A5B0837E092F}"/>
              </a:ext>
            </a:extLst>
          </p:cNvPr>
          <p:cNvSpPr/>
          <p:nvPr/>
        </p:nvSpPr>
        <p:spPr>
          <a:xfrm>
            <a:off x="3260460" y="3231758"/>
            <a:ext cx="603480" cy="1793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8" name="文本框 19">
            <a:extLst>
              <a:ext uri="{FF2B5EF4-FFF2-40B4-BE49-F238E27FC236}">
                <a16:creationId xmlns:a16="http://schemas.microsoft.com/office/drawing/2014/main" id="{EA77B7C4-E149-645D-5CB1-D06B6DDC0CAE}"/>
              </a:ext>
            </a:extLst>
          </p:cNvPr>
          <p:cNvSpPr txBox="1"/>
          <p:nvPr/>
        </p:nvSpPr>
        <p:spPr>
          <a:xfrm>
            <a:off x="3818467" y="320119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20">
            <a:extLst>
              <a:ext uri="{FF2B5EF4-FFF2-40B4-BE49-F238E27FC236}">
                <a16:creationId xmlns:a16="http://schemas.microsoft.com/office/drawing/2014/main" id="{33C73D15-9BE8-A402-9BE9-82F4B779FE94}"/>
              </a:ext>
            </a:extLst>
          </p:cNvPr>
          <p:cNvSpPr txBox="1"/>
          <p:nvPr/>
        </p:nvSpPr>
        <p:spPr>
          <a:xfrm>
            <a:off x="2816904" y="3198301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71DFBCB0-BECA-0F76-F97D-ADFBBBA1AB4D}"/>
              </a:ext>
            </a:extLst>
          </p:cNvPr>
          <p:cNvSpPr/>
          <p:nvPr/>
        </p:nvSpPr>
        <p:spPr>
          <a:xfrm>
            <a:off x="6677734" y="3481343"/>
            <a:ext cx="588371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1" name="文本框 12">
            <a:extLst>
              <a:ext uri="{FF2B5EF4-FFF2-40B4-BE49-F238E27FC236}">
                <a16:creationId xmlns:a16="http://schemas.microsoft.com/office/drawing/2014/main" id="{6FC362BE-6D0F-A4B3-50BA-6D4E1DB6FC0D}"/>
              </a:ext>
            </a:extLst>
          </p:cNvPr>
          <p:cNvSpPr txBox="1"/>
          <p:nvPr/>
        </p:nvSpPr>
        <p:spPr>
          <a:xfrm>
            <a:off x="7225493" y="3462932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3">
            <a:extLst>
              <a:ext uri="{FF2B5EF4-FFF2-40B4-BE49-F238E27FC236}">
                <a16:creationId xmlns:a16="http://schemas.microsoft.com/office/drawing/2014/main" id="{C5BEC014-11A3-07C7-96CA-9C7E8B79D9BC}"/>
              </a:ext>
            </a:extLst>
          </p:cNvPr>
          <p:cNvSpPr txBox="1"/>
          <p:nvPr/>
        </p:nvSpPr>
        <p:spPr>
          <a:xfrm>
            <a:off x="6203331" y="346293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5402622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2C7261E-44A4-8ECA-6E24-F453E98B77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4B70B0A-6FCF-1DB7-0F70-A8A7DD9E4F86}"/>
              </a:ext>
            </a:extLst>
          </p:cNvPr>
          <p:cNvSpPr txBox="1"/>
          <p:nvPr/>
        </p:nvSpPr>
        <p:spPr>
          <a:xfrm>
            <a:off x="271576" y="179943"/>
            <a:ext cx="959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7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7642572-29A0-D831-FCD7-10D3FC25A0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4197" y="1263789"/>
            <a:ext cx="3014505" cy="4139921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140FBC1E-F688-4BF5-011E-9791D45853DD}"/>
              </a:ext>
            </a:extLst>
          </p:cNvPr>
          <p:cNvSpPr/>
          <p:nvPr/>
        </p:nvSpPr>
        <p:spPr>
          <a:xfrm>
            <a:off x="7560384" y="3932193"/>
            <a:ext cx="588371" cy="246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5" name="文本框 12">
            <a:extLst>
              <a:ext uri="{FF2B5EF4-FFF2-40B4-BE49-F238E27FC236}">
                <a16:creationId xmlns:a16="http://schemas.microsoft.com/office/drawing/2014/main" id="{96333E9D-1F45-2403-0B6A-3CF9F42400DE}"/>
              </a:ext>
            </a:extLst>
          </p:cNvPr>
          <p:cNvSpPr txBox="1"/>
          <p:nvPr/>
        </p:nvSpPr>
        <p:spPr>
          <a:xfrm>
            <a:off x="8108143" y="3913782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13">
            <a:extLst>
              <a:ext uri="{FF2B5EF4-FFF2-40B4-BE49-F238E27FC236}">
                <a16:creationId xmlns:a16="http://schemas.microsoft.com/office/drawing/2014/main" id="{99FA251F-61C8-A18E-1DD4-463D8D4BCD81}"/>
              </a:ext>
            </a:extLst>
          </p:cNvPr>
          <p:cNvSpPr txBox="1"/>
          <p:nvPr/>
        </p:nvSpPr>
        <p:spPr>
          <a:xfrm>
            <a:off x="7085981" y="391378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8EADE7D7-432E-FAAA-DB3A-5F77A24F938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3102" y="1610652"/>
            <a:ext cx="3014505" cy="4139921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E541913B-E989-E4D8-D8AB-97E95EA0E1A8}"/>
              </a:ext>
            </a:extLst>
          </p:cNvPr>
          <p:cNvSpPr/>
          <p:nvPr/>
        </p:nvSpPr>
        <p:spPr>
          <a:xfrm>
            <a:off x="4409435" y="3839650"/>
            <a:ext cx="498856" cy="1793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0" name="文本框 19">
            <a:extLst>
              <a:ext uri="{FF2B5EF4-FFF2-40B4-BE49-F238E27FC236}">
                <a16:creationId xmlns:a16="http://schemas.microsoft.com/office/drawing/2014/main" id="{E576590C-C715-AC93-4E60-3DD0B6BA9359}"/>
              </a:ext>
            </a:extLst>
          </p:cNvPr>
          <p:cNvSpPr txBox="1"/>
          <p:nvPr/>
        </p:nvSpPr>
        <p:spPr>
          <a:xfrm>
            <a:off x="4900918" y="380908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20">
            <a:extLst>
              <a:ext uri="{FF2B5EF4-FFF2-40B4-BE49-F238E27FC236}">
                <a16:creationId xmlns:a16="http://schemas.microsoft.com/office/drawing/2014/main" id="{4B5BC462-585F-10E5-CCF2-C412A30007B4}"/>
              </a:ext>
            </a:extLst>
          </p:cNvPr>
          <p:cNvSpPr txBox="1"/>
          <p:nvPr/>
        </p:nvSpPr>
        <p:spPr>
          <a:xfrm>
            <a:off x="3899355" y="380619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36278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79C6329-CBB8-73E6-4C18-D98D95178A2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9B0DEC8-0B78-3A31-D710-AC529F260C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1947" y="1484451"/>
            <a:ext cx="3014505" cy="413992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EC6196FF-9E95-6F79-9122-A2F7489799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7323" y="1359039"/>
            <a:ext cx="3014505" cy="413992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E402DD1A-6C50-628D-1EBF-FF92E6784417}"/>
              </a:ext>
            </a:extLst>
          </p:cNvPr>
          <p:cNvSpPr txBox="1"/>
          <p:nvPr/>
        </p:nvSpPr>
        <p:spPr>
          <a:xfrm>
            <a:off x="898299" y="902210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F21B1F3A-ED83-9C0E-83FA-1EBBAAA17919}"/>
              </a:ext>
            </a:extLst>
          </p:cNvPr>
          <p:cNvSpPr/>
          <p:nvPr/>
        </p:nvSpPr>
        <p:spPr>
          <a:xfrm>
            <a:off x="5172449" y="3012281"/>
            <a:ext cx="1199775" cy="2500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19FA98D3-4A58-4FF4-F16D-3FDF8E6703A1}"/>
              </a:ext>
            </a:extLst>
          </p:cNvPr>
          <p:cNvSpPr/>
          <p:nvPr/>
        </p:nvSpPr>
        <p:spPr>
          <a:xfrm>
            <a:off x="8796338" y="2999184"/>
            <a:ext cx="1138237" cy="2202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8F9291F2-8722-E13E-6969-BC3A25DF22C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835" y="1271542"/>
            <a:ext cx="3014505" cy="4139921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97013482-F0EC-4DF9-C532-F778BE628C58}"/>
              </a:ext>
            </a:extLst>
          </p:cNvPr>
          <p:cNvSpPr/>
          <p:nvPr/>
        </p:nvSpPr>
        <p:spPr>
          <a:xfrm>
            <a:off x="1434680" y="2984301"/>
            <a:ext cx="1199775" cy="2500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A199359-6ACA-E92C-5880-6CB9F5D2E890}"/>
              </a:ext>
            </a:extLst>
          </p:cNvPr>
          <p:cNvSpPr txBox="1"/>
          <p:nvPr/>
        </p:nvSpPr>
        <p:spPr>
          <a:xfrm>
            <a:off x="9869902" y="2891075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25">
            <a:extLst>
              <a:ext uri="{FF2B5EF4-FFF2-40B4-BE49-F238E27FC236}">
                <a16:creationId xmlns:a16="http://schemas.microsoft.com/office/drawing/2014/main" id="{B56AA7FE-F6A8-F137-0F84-6F3D9A6E852C}"/>
              </a:ext>
            </a:extLst>
          </p:cNvPr>
          <p:cNvSpPr txBox="1"/>
          <p:nvPr/>
        </p:nvSpPr>
        <p:spPr>
          <a:xfrm>
            <a:off x="8342860" y="2980416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52CF815-E050-9989-64AD-6F59123C8188}"/>
              </a:ext>
            </a:extLst>
          </p:cNvPr>
          <p:cNvSpPr txBox="1"/>
          <p:nvPr/>
        </p:nvSpPr>
        <p:spPr>
          <a:xfrm>
            <a:off x="2557404" y="298041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25">
            <a:extLst>
              <a:ext uri="{FF2B5EF4-FFF2-40B4-BE49-F238E27FC236}">
                <a16:creationId xmlns:a16="http://schemas.microsoft.com/office/drawing/2014/main" id="{F0A611E0-2809-CCC8-4D0D-746EE8C07D14}"/>
              </a:ext>
            </a:extLst>
          </p:cNvPr>
          <p:cNvSpPr txBox="1"/>
          <p:nvPr/>
        </p:nvSpPr>
        <p:spPr>
          <a:xfrm>
            <a:off x="986987" y="2995991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C3D42E1-647B-A30E-02B9-5AD2FB44ADE4}"/>
              </a:ext>
            </a:extLst>
          </p:cNvPr>
          <p:cNvSpPr txBox="1"/>
          <p:nvPr/>
        </p:nvSpPr>
        <p:spPr>
          <a:xfrm>
            <a:off x="6307727" y="3010330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25">
            <a:extLst>
              <a:ext uri="{FF2B5EF4-FFF2-40B4-BE49-F238E27FC236}">
                <a16:creationId xmlns:a16="http://schemas.microsoft.com/office/drawing/2014/main" id="{8A9E419F-2E92-8BB6-9E85-FCF54EC3CE67}"/>
              </a:ext>
            </a:extLst>
          </p:cNvPr>
          <p:cNvSpPr txBox="1"/>
          <p:nvPr/>
        </p:nvSpPr>
        <p:spPr>
          <a:xfrm>
            <a:off x="4714988" y="3007533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57747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AFA80A-D4D8-DA7C-3640-B83007B8933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D437DC8-0E48-8A1A-8426-F19876452A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4158466"/>
            <a:ext cx="3559995" cy="237333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C9E48EB-D51D-A3AF-DBD1-FBF519E17F6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0328" y="1130157"/>
            <a:ext cx="3729519" cy="248634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6973E6A-116B-0E50-F46F-81C9BB4F737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629" y="1055670"/>
            <a:ext cx="3559995" cy="237333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6DB1146-10BE-348F-E94B-47A2E2C5F043}"/>
              </a:ext>
            </a:extLst>
          </p:cNvPr>
          <p:cNvSpPr txBox="1"/>
          <p:nvPr/>
        </p:nvSpPr>
        <p:spPr>
          <a:xfrm>
            <a:off x="477059" y="647809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BCF4461-5F45-B87D-DEF4-DDB0AAAC0241}"/>
              </a:ext>
            </a:extLst>
          </p:cNvPr>
          <p:cNvSpPr txBox="1"/>
          <p:nvPr/>
        </p:nvSpPr>
        <p:spPr>
          <a:xfrm>
            <a:off x="7723487" y="2419093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25">
            <a:extLst>
              <a:ext uri="{FF2B5EF4-FFF2-40B4-BE49-F238E27FC236}">
                <a16:creationId xmlns:a16="http://schemas.microsoft.com/office/drawing/2014/main" id="{50EC3E49-7F80-D67C-37B0-BE4A80A30D81}"/>
              </a:ext>
            </a:extLst>
          </p:cNvPr>
          <p:cNvSpPr txBox="1"/>
          <p:nvPr/>
        </p:nvSpPr>
        <p:spPr>
          <a:xfrm>
            <a:off x="6683298" y="244247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5EC45CB-9F22-CD12-32FA-6A1AD111CA89}"/>
              </a:ext>
            </a:extLst>
          </p:cNvPr>
          <p:cNvSpPr txBox="1"/>
          <p:nvPr/>
        </p:nvSpPr>
        <p:spPr>
          <a:xfrm>
            <a:off x="3166772" y="230080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25">
            <a:extLst>
              <a:ext uri="{FF2B5EF4-FFF2-40B4-BE49-F238E27FC236}">
                <a16:creationId xmlns:a16="http://schemas.microsoft.com/office/drawing/2014/main" id="{70343FF4-2A9A-A01B-E622-99A7231C8FC0}"/>
              </a:ext>
            </a:extLst>
          </p:cNvPr>
          <p:cNvSpPr txBox="1"/>
          <p:nvPr/>
        </p:nvSpPr>
        <p:spPr>
          <a:xfrm>
            <a:off x="2097603" y="2293105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5459F76-34CB-A297-1659-EE9795FB376E}"/>
              </a:ext>
            </a:extLst>
          </p:cNvPr>
          <p:cNvSpPr txBox="1"/>
          <p:nvPr/>
        </p:nvSpPr>
        <p:spPr>
          <a:xfrm>
            <a:off x="2795783" y="5358930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25">
            <a:extLst>
              <a:ext uri="{FF2B5EF4-FFF2-40B4-BE49-F238E27FC236}">
                <a16:creationId xmlns:a16="http://schemas.microsoft.com/office/drawing/2014/main" id="{E1C58827-3895-EB32-C70B-F5C0CAA3A5C2}"/>
              </a:ext>
            </a:extLst>
          </p:cNvPr>
          <p:cNvSpPr txBox="1"/>
          <p:nvPr/>
        </p:nvSpPr>
        <p:spPr>
          <a:xfrm>
            <a:off x="1760649" y="537500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11FCCDCC-9520-C352-3F2D-9839F05646A1}"/>
              </a:ext>
            </a:extLst>
          </p:cNvPr>
          <p:cNvSpPr/>
          <p:nvPr/>
        </p:nvSpPr>
        <p:spPr>
          <a:xfrm>
            <a:off x="2532153" y="2337772"/>
            <a:ext cx="669635" cy="1645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9F014784-6DC7-8622-A9D0-D6F7A0FEF479}"/>
              </a:ext>
            </a:extLst>
          </p:cNvPr>
          <p:cNvSpPr/>
          <p:nvPr/>
        </p:nvSpPr>
        <p:spPr>
          <a:xfrm>
            <a:off x="7139673" y="2494841"/>
            <a:ext cx="583814" cy="1493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11FCCDCC-9520-C352-3F2D-9839F05646A1}"/>
              </a:ext>
            </a:extLst>
          </p:cNvPr>
          <p:cNvSpPr/>
          <p:nvPr/>
        </p:nvSpPr>
        <p:spPr>
          <a:xfrm>
            <a:off x="2246359" y="5398770"/>
            <a:ext cx="543739" cy="2063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01638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D94B609-EFFD-D374-0167-4088C4E427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297ACE98-F194-19B4-9DBB-03B1A22E552E}"/>
              </a:ext>
            </a:extLst>
          </p:cNvPr>
          <p:cNvSpPr txBox="1"/>
          <p:nvPr/>
        </p:nvSpPr>
        <p:spPr>
          <a:xfrm>
            <a:off x="898299" y="902210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38E520D-DFD4-3A83-ED3A-4D774F9EA0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1147" y="1486039"/>
            <a:ext cx="3014505" cy="41399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AEDCF9C-3C72-5583-ED4D-8182115791E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6550" y="1689239"/>
            <a:ext cx="3014505" cy="413992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AD3A319-0BC0-90AF-4BFE-3BD2C308123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604" y="1621771"/>
            <a:ext cx="3014505" cy="4139921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E00160E7-CD53-F450-ED18-4BEE0EC0081E}"/>
              </a:ext>
            </a:extLst>
          </p:cNvPr>
          <p:cNvSpPr/>
          <p:nvPr/>
        </p:nvSpPr>
        <p:spPr>
          <a:xfrm>
            <a:off x="985836" y="2859319"/>
            <a:ext cx="1124324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2886C91-DAD4-8100-1099-9C21173580C6}"/>
              </a:ext>
            </a:extLst>
          </p:cNvPr>
          <p:cNvSpPr txBox="1"/>
          <p:nvPr/>
        </p:nvSpPr>
        <p:spPr>
          <a:xfrm>
            <a:off x="2036705" y="281701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25">
            <a:extLst>
              <a:ext uri="{FF2B5EF4-FFF2-40B4-BE49-F238E27FC236}">
                <a16:creationId xmlns:a16="http://schemas.microsoft.com/office/drawing/2014/main" id="{4C70C38B-2C5B-FE0B-A54A-6291A964B8EF}"/>
              </a:ext>
            </a:extLst>
          </p:cNvPr>
          <p:cNvSpPr txBox="1"/>
          <p:nvPr/>
        </p:nvSpPr>
        <p:spPr>
          <a:xfrm>
            <a:off x="547978" y="2861157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978083A-CAB7-4ECC-CB98-BB58E4F9D2A6}"/>
              </a:ext>
            </a:extLst>
          </p:cNvPr>
          <p:cNvSpPr txBox="1"/>
          <p:nvPr/>
        </p:nvSpPr>
        <p:spPr>
          <a:xfrm>
            <a:off x="6237584" y="2817012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5">
            <a:extLst>
              <a:ext uri="{FF2B5EF4-FFF2-40B4-BE49-F238E27FC236}">
                <a16:creationId xmlns:a16="http://schemas.microsoft.com/office/drawing/2014/main" id="{A56E8009-FF72-4D1A-B54B-83D745CDE32B}"/>
              </a:ext>
            </a:extLst>
          </p:cNvPr>
          <p:cNvSpPr txBox="1"/>
          <p:nvPr/>
        </p:nvSpPr>
        <p:spPr>
          <a:xfrm>
            <a:off x="4607550" y="281605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7B2DC37-0817-F417-763C-3C78A08E2B46}"/>
              </a:ext>
            </a:extLst>
          </p:cNvPr>
          <p:cNvSpPr txBox="1"/>
          <p:nvPr/>
        </p:nvSpPr>
        <p:spPr>
          <a:xfrm>
            <a:off x="9452848" y="3033423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5">
            <a:extLst>
              <a:ext uri="{FF2B5EF4-FFF2-40B4-BE49-F238E27FC236}">
                <a16:creationId xmlns:a16="http://schemas.microsoft.com/office/drawing/2014/main" id="{81498547-08B0-277C-B5F8-D05EB0F8D101}"/>
              </a:ext>
            </a:extLst>
          </p:cNvPr>
          <p:cNvSpPr txBox="1"/>
          <p:nvPr/>
        </p:nvSpPr>
        <p:spPr>
          <a:xfrm>
            <a:off x="7946500" y="303098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04C0415B-DEC2-8F11-2DBB-6E9B5AF40BD7}"/>
              </a:ext>
            </a:extLst>
          </p:cNvPr>
          <p:cNvSpPr/>
          <p:nvPr/>
        </p:nvSpPr>
        <p:spPr>
          <a:xfrm>
            <a:off x="5055083" y="2829144"/>
            <a:ext cx="1124324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82A2D834-918C-06F8-84E0-6F4404068DDF}"/>
              </a:ext>
            </a:extLst>
          </p:cNvPr>
          <p:cNvSpPr/>
          <p:nvPr/>
        </p:nvSpPr>
        <p:spPr>
          <a:xfrm>
            <a:off x="8383049" y="3051163"/>
            <a:ext cx="1124324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53691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78B8E9-37A6-CC7F-4E43-31442B08C5A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485AF06-FAC8-231F-DFF2-98C550C223C9}"/>
              </a:ext>
            </a:extLst>
          </p:cNvPr>
          <p:cNvSpPr txBox="1"/>
          <p:nvPr/>
        </p:nvSpPr>
        <p:spPr>
          <a:xfrm>
            <a:off x="149454" y="0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D9DAB039-6432-E337-6742-F9FC759F79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8572" y="3429000"/>
            <a:ext cx="2253726" cy="3095118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9F10CA0E-C475-485A-FE9B-B96A09BA3B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1917" y="708706"/>
            <a:ext cx="2253726" cy="3095118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2764AB8F-6661-E457-9109-C28D413A147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8572" y="653083"/>
            <a:ext cx="2253726" cy="309511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293A005C-60B4-6447-6F2F-183B92808CC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8645" y="549275"/>
            <a:ext cx="2253726" cy="3095118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BB604C9E-2703-6C59-32A1-64776D35C82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0685" y="3106057"/>
            <a:ext cx="2253726" cy="3095118"/>
          </a:xfrm>
          <a:prstGeom prst="rect">
            <a:avLst/>
          </a:prstGeom>
        </p:spPr>
      </p:pic>
      <p:sp>
        <p:nvSpPr>
          <p:cNvPr id="35" name="矩形 34">
            <a:extLst>
              <a:ext uri="{FF2B5EF4-FFF2-40B4-BE49-F238E27FC236}">
                <a16:creationId xmlns:a16="http://schemas.microsoft.com/office/drawing/2014/main" id="{E00160E7-CD53-F450-ED18-4BEE0EC0081E}"/>
              </a:ext>
            </a:extLst>
          </p:cNvPr>
          <p:cNvSpPr/>
          <p:nvPr/>
        </p:nvSpPr>
        <p:spPr>
          <a:xfrm>
            <a:off x="5556717" y="2336439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6" name="文本框 17">
            <a:extLst>
              <a:ext uri="{FF2B5EF4-FFF2-40B4-BE49-F238E27FC236}">
                <a16:creationId xmlns:a16="http://schemas.microsoft.com/office/drawing/2014/main" id="{02886C91-DAD4-8100-1099-9C21173580C6}"/>
              </a:ext>
            </a:extLst>
          </p:cNvPr>
          <p:cNvSpPr txBox="1"/>
          <p:nvPr/>
        </p:nvSpPr>
        <p:spPr>
          <a:xfrm>
            <a:off x="5839396" y="2336439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25">
            <a:extLst>
              <a:ext uri="{FF2B5EF4-FFF2-40B4-BE49-F238E27FC236}">
                <a16:creationId xmlns:a16="http://schemas.microsoft.com/office/drawing/2014/main" id="{4C70C38B-2C5B-FE0B-A54A-6291A964B8EF}"/>
              </a:ext>
            </a:extLst>
          </p:cNvPr>
          <p:cNvSpPr txBox="1"/>
          <p:nvPr/>
        </p:nvSpPr>
        <p:spPr>
          <a:xfrm>
            <a:off x="5133176" y="2320490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B5955E8E-C50D-A38E-C6CB-9A425C721C76}"/>
              </a:ext>
            </a:extLst>
          </p:cNvPr>
          <p:cNvSpPr/>
          <p:nvPr/>
        </p:nvSpPr>
        <p:spPr>
          <a:xfrm>
            <a:off x="2697760" y="2558458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40" name="文本框 17">
            <a:extLst>
              <a:ext uri="{FF2B5EF4-FFF2-40B4-BE49-F238E27FC236}">
                <a16:creationId xmlns:a16="http://schemas.microsoft.com/office/drawing/2014/main" id="{6B30292D-AB38-8737-AA01-77C0DDD4BCB2}"/>
              </a:ext>
            </a:extLst>
          </p:cNvPr>
          <p:cNvSpPr txBox="1"/>
          <p:nvPr/>
        </p:nvSpPr>
        <p:spPr>
          <a:xfrm>
            <a:off x="2980439" y="2558458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25">
            <a:extLst>
              <a:ext uri="{FF2B5EF4-FFF2-40B4-BE49-F238E27FC236}">
                <a16:creationId xmlns:a16="http://schemas.microsoft.com/office/drawing/2014/main" id="{6CB07AC4-A779-CC05-0EBF-4528BE3B2297}"/>
              </a:ext>
            </a:extLst>
          </p:cNvPr>
          <p:cNvSpPr txBox="1"/>
          <p:nvPr/>
        </p:nvSpPr>
        <p:spPr>
          <a:xfrm>
            <a:off x="2182563" y="2542599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42EDFECB-2B91-EFCD-05A3-3C359459C5D2}"/>
              </a:ext>
            </a:extLst>
          </p:cNvPr>
          <p:cNvSpPr/>
          <p:nvPr/>
        </p:nvSpPr>
        <p:spPr>
          <a:xfrm>
            <a:off x="8681150" y="2431499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43" name="文本框 17">
            <a:extLst>
              <a:ext uri="{FF2B5EF4-FFF2-40B4-BE49-F238E27FC236}">
                <a16:creationId xmlns:a16="http://schemas.microsoft.com/office/drawing/2014/main" id="{3D995F95-0A8D-3463-F6A2-410080DF9DEC}"/>
              </a:ext>
            </a:extLst>
          </p:cNvPr>
          <p:cNvSpPr txBox="1"/>
          <p:nvPr/>
        </p:nvSpPr>
        <p:spPr>
          <a:xfrm>
            <a:off x="8963829" y="2431499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25">
            <a:extLst>
              <a:ext uri="{FF2B5EF4-FFF2-40B4-BE49-F238E27FC236}">
                <a16:creationId xmlns:a16="http://schemas.microsoft.com/office/drawing/2014/main" id="{A5199059-FB9F-D04D-CB66-DAD24FF84F84}"/>
              </a:ext>
            </a:extLst>
          </p:cNvPr>
          <p:cNvSpPr txBox="1"/>
          <p:nvPr/>
        </p:nvSpPr>
        <p:spPr>
          <a:xfrm>
            <a:off x="8257609" y="2415550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F7BBFED1-1292-86DE-661B-86FC236760D0}"/>
              </a:ext>
            </a:extLst>
          </p:cNvPr>
          <p:cNvSpPr/>
          <p:nvPr/>
        </p:nvSpPr>
        <p:spPr>
          <a:xfrm>
            <a:off x="2745538" y="4953996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46" name="文本框 17">
            <a:extLst>
              <a:ext uri="{FF2B5EF4-FFF2-40B4-BE49-F238E27FC236}">
                <a16:creationId xmlns:a16="http://schemas.microsoft.com/office/drawing/2014/main" id="{E053301C-1FDA-CD56-1123-19C3CF66F620}"/>
              </a:ext>
            </a:extLst>
          </p:cNvPr>
          <p:cNvSpPr txBox="1"/>
          <p:nvPr/>
        </p:nvSpPr>
        <p:spPr>
          <a:xfrm>
            <a:off x="3028217" y="4953996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25">
            <a:extLst>
              <a:ext uri="{FF2B5EF4-FFF2-40B4-BE49-F238E27FC236}">
                <a16:creationId xmlns:a16="http://schemas.microsoft.com/office/drawing/2014/main" id="{3BA15452-8281-CE55-769B-8188E1F32EB8}"/>
              </a:ext>
            </a:extLst>
          </p:cNvPr>
          <p:cNvSpPr txBox="1"/>
          <p:nvPr/>
        </p:nvSpPr>
        <p:spPr>
          <a:xfrm>
            <a:off x="2230341" y="4938137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47911D53-2DBB-30DA-919D-145A8DD8862E}"/>
              </a:ext>
            </a:extLst>
          </p:cNvPr>
          <p:cNvSpPr/>
          <p:nvPr/>
        </p:nvSpPr>
        <p:spPr>
          <a:xfrm>
            <a:off x="6166566" y="4831418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49" name="文本框 17">
            <a:extLst>
              <a:ext uri="{FF2B5EF4-FFF2-40B4-BE49-F238E27FC236}">
                <a16:creationId xmlns:a16="http://schemas.microsoft.com/office/drawing/2014/main" id="{1378A5A0-FA92-D36F-886F-8E2DAF8E008F}"/>
              </a:ext>
            </a:extLst>
          </p:cNvPr>
          <p:cNvSpPr txBox="1"/>
          <p:nvPr/>
        </p:nvSpPr>
        <p:spPr>
          <a:xfrm>
            <a:off x="6449245" y="4831418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25">
            <a:extLst>
              <a:ext uri="{FF2B5EF4-FFF2-40B4-BE49-F238E27FC236}">
                <a16:creationId xmlns:a16="http://schemas.microsoft.com/office/drawing/2014/main" id="{2D9AFA45-2149-0F3B-8818-3E5D618BA3D0}"/>
              </a:ext>
            </a:extLst>
          </p:cNvPr>
          <p:cNvSpPr txBox="1"/>
          <p:nvPr/>
        </p:nvSpPr>
        <p:spPr>
          <a:xfrm>
            <a:off x="5651369" y="481555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3EFB905-A500-E0EB-2392-815151EC5C06}"/>
              </a:ext>
            </a:extLst>
          </p:cNvPr>
          <p:cNvSpPr txBox="1"/>
          <p:nvPr/>
        </p:nvSpPr>
        <p:spPr>
          <a:xfrm>
            <a:off x="1057717" y="2292439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2E8B957-5A2C-AA37-E22F-70FE27B93ABF}"/>
              </a:ext>
            </a:extLst>
          </p:cNvPr>
          <p:cNvSpPr txBox="1"/>
          <p:nvPr/>
        </p:nvSpPr>
        <p:spPr>
          <a:xfrm>
            <a:off x="1116347" y="4868771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34592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EFB557-5679-C60B-E81D-07B8B8AEDB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E184266-8908-5E1E-06A9-8D5C9736E1C0}"/>
              </a:ext>
            </a:extLst>
          </p:cNvPr>
          <p:cNvSpPr txBox="1"/>
          <p:nvPr/>
        </p:nvSpPr>
        <p:spPr>
          <a:xfrm>
            <a:off x="191309" y="0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f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7FFC2F5D-5010-52A1-5A60-E845FFD7CC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0850" y="470933"/>
            <a:ext cx="2235841" cy="307055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1B31E0F-3F39-4693-CB9A-1BED2EF00D5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229" y="470931"/>
            <a:ext cx="2235841" cy="307055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B76C3F8B-241F-F6A1-013F-FD8B1F08A0C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1735" y="470931"/>
            <a:ext cx="2235841" cy="307055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FB0DB59-2199-9FB7-5E50-307831220D1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6556" y="498823"/>
            <a:ext cx="2235841" cy="307055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F49E1750-E8F5-0B26-A884-42A7F3DA03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6125" y="3643090"/>
            <a:ext cx="2235841" cy="307055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4BC64D17-0E79-C9A9-4842-879BC445EC0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6504" y="3643088"/>
            <a:ext cx="2235841" cy="307055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381908D2-3E20-5F2F-F581-C2486F1075C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7010" y="3643088"/>
            <a:ext cx="2235841" cy="3070556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FF7AC28C-8EFF-24A5-92B1-28AEC53AF32C}"/>
              </a:ext>
            </a:extLst>
          </p:cNvPr>
          <p:cNvSpPr/>
          <p:nvPr/>
        </p:nvSpPr>
        <p:spPr>
          <a:xfrm>
            <a:off x="7840356" y="1750878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7" name="文本框 17">
            <a:extLst>
              <a:ext uri="{FF2B5EF4-FFF2-40B4-BE49-F238E27FC236}">
                <a16:creationId xmlns:a16="http://schemas.microsoft.com/office/drawing/2014/main" id="{05977B9E-39DF-E635-1D13-F09804D2A54D}"/>
              </a:ext>
            </a:extLst>
          </p:cNvPr>
          <p:cNvSpPr txBox="1"/>
          <p:nvPr/>
        </p:nvSpPr>
        <p:spPr>
          <a:xfrm>
            <a:off x="8123035" y="1750878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25">
            <a:extLst>
              <a:ext uri="{FF2B5EF4-FFF2-40B4-BE49-F238E27FC236}">
                <a16:creationId xmlns:a16="http://schemas.microsoft.com/office/drawing/2014/main" id="{00BCA090-6168-2491-BE06-75BCE04D5C47}"/>
              </a:ext>
            </a:extLst>
          </p:cNvPr>
          <p:cNvSpPr txBox="1"/>
          <p:nvPr/>
        </p:nvSpPr>
        <p:spPr>
          <a:xfrm>
            <a:off x="7416815" y="1734929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9EC800DE-CC2B-C8E7-F35B-DF1256FB86B1}"/>
              </a:ext>
            </a:extLst>
          </p:cNvPr>
          <p:cNvSpPr/>
          <p:nvPr/>
        </p:nvSpPr>
        <p:spPr>
          <a:xfrm>
            <a:off x="5161160" y="2170502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0" name="文本框 17">
            <a:extLst>
              <a:ext uri="{FF2B5EF4-FFF2-40B4-BE49-F238E27FC236}">
                <a16:creationId xmlns:a16="http://schemas.microsoft.com/office/drawing/2014/main" id="{CEDA66CA-B228-9065-31F1-124FDE2791B2}"/>
              </a:ext>
            </a:extLst>
          </p:cNvPr>
          <p:cNvSpPr txBox="1"/>
          <p:nvPr/>
        </p:nvSpPr>
        <p:spPr>
          <a:xfrm>
            <a:off x="5443839" y="2170502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5">
            <a:extLst>
              <a:ext uri="{FF2B5EF4-FFF2-40B4-BE49-F238E27FC236}">
                <a16:creationId xmlns:a16="http://schemas.microsoft.com/office/drawing/2014/main" id="{A76DE952-964C-F5E9-51CE-B4A1EC046212}"/>
              </a:ext>
            </a:extLst>
          </p:cNvPr>
          <p:cNvSpPr txBox="1"/>
          <p:nvPr/>
        </p:nvSpPr>
        <p:spPr>
          <a:xfrm>
            <a:off x="4645963" y="2154643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6A7CD966-164A-0E14-7742-DB0BBB88DC19}"/>
              </a:ext>
            </a:extLst>
          </p:cNvPr>
          <p:cNvSpPr/>
          <p:nvPr/>
        </p:nvSpPr>
        <p:spPr>
          <a:xfrm>
            <a:off x="10771648" y="2293613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3" name="文本框 17">
            <a:extLst>
              <a:ext uri="{FF2B5EF4-FFF2-40B4-BE49-F238E27FC236}">
                <a16:creationId xmlns:a16="http://schemas.microsoft.com/office/drawing/2014/main" id="{0E0C3661-FDBA-72EC-73E3-04F42F93EBEB}"/>
              </a:ext>
            </a:extLst>
          </p:cNvPr>
          <p:cNvSpPr txBox="1"/>
          <p:nvPr/>
        </p:nvSpPr>
        <p:spPr>
          <a:xfrm>
            <a:off x="11054327" y="2293613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5">
            <a:extLst>
              <a:ext uri="{FF2B5EF4-FFF2-40B4-BE49-F238E27FC236}">
                <a16:creationId xmlns:a16="http://schemas.microsoft.com/office/drawing/2014/main" id="{51FF9022-7100-0769-03F8-69D49633C76B}"/>
              </a:ext>
            </a:extLst>
          </p:cNvPr>
          <p:cNvSpPr txBox="1"/>
          <p:nvPr/>
        </p:nvSpPr>
        <p:spPr>
          <a:xfrm>
            <a:off x="10335833" y="2283801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10196D31-99CB-E101-9F82-0F70886ECEE7}"/>
              </a:ext>
            </a:extLst>
          </p:cNvPr>
          <p:cNvSpPr/>
          <p:nvPr/>
        </p:nvSpPr>
        <p:spPr>
          <a:xfrm>
            <a:off x="8254252" y="4919528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9" name="文本框 17">
            <a:extLst>
              <a:ext uri="{FF2B5EF4-FFF2-40B4-BE49-F238E27FC236}">
                <a16:creationId xmlns:a16="http://schemas.microsoft.com/office/drawing/2014/main" id="{85C9C675-E550-93B4-B230-CB96A84B2075}"/>
              </a:ext>
            </a:extLst>
          </p:cNvPr>
          <p:cNvSpPr txBox="1"/>
          <p:nvPr/>
        </p:nvSpPr>
        <p:spPr>
          <a:xfrm>
            <a:off x="8536931" y="4919528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5">
            <a:extLst>
              <a:ext uri="{FF2B5EF4-FFF2-40B4-BE49-F238E27FC236}">
                <a16:creationId xmlns:a16="http://schemas.microsoft.com/office/drawing/2014/main" id="{D1A0A740-85F6-2021-577B-4DCB317AD9CA}"/>
              </a:ext>
            </a:extLst>
          </p:cNvPr>
          <p:cNvSpPr txBox="1"/>
          <p:nvPr/>
        </p:nvSpPr>
        <p:spPr>
          <a:xfrm>
            <a:off x="7830711" y="4903579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31CE9ABA-7C76-EF3A-4A58-7A122028E26D}"/>
              </a:ext>
            </a:extLst>
          </p:cNvPr>
          <p:cNvSpPr/>
          <p:nvPr/>
        </p:nvSpPr>
        <p:spPr>
          <a:xfrm>
            <a:off x="5529460" y="5339152"/>
            <a:ext cx="338138" cy="2220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2" name="文本框 17">
            <a:extLst>
              <a:ext uri="{FF2B5EF4-FFF2-40B4-BE49-F238E27FC236}">
                <a16:creationId xmlns:a16="http://schemas.microsoft.com/office/drawing/2014/main" id="{478327DE-DD03-9245-CBE7-BAD99F7DEFE4}"/>
              </a:ext>
            </a:extLst>
          </p:cNvPr>
          <p:cNvSpPr txBox="1"/>
          <p:nvPr/>
        </p:nvSpPr>
        <p:spPr>
          <a:xfrm>
            <a:off x="5812139" y="5339152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25">
            <a:extLst>
              <a:ext uri="{FF2B5EF4-FFF2-40B4-BE49-F238E27FC236}">
                <a16:creationId xmlns:a16="http://schemas.microsoft.com/office/drawing/2014/main" id="{132E474D-72CF-BACA-2221-3E5B85EC2FAE}"/>
              </a:ext>
            </a:extLst>
          </p:cNvPr>
          <p:cNvSpPr txBox="1"/>
          <p:nvPr/>
        </p:nvSpPr>
        <p:spPr>
          <a:xfrm>
            <a:off x="5014263" y="5323293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15DE37E6-0EAE-5AA8-084D-1142898A90FF}"/>
              </a:ext>
            </a:extLst>
          </p:cNvPr>
          <p:cNvSpPr/>
          <p:nvPr/>
        </p:nvSpPr>
        <p:spPr>
          <a:xfrm>
            <a:off x="3155420" y="2066923"/>
            <a:ext cx="338138" cy="956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5" name="文本框 17">
            <a:extLst>
              <a:ext uri="{FF2B5EF4-FFF2-40B4-BE49-F238E27FC236}">
                <a16:creationId xmlns:a16="http://schemas.microsoft.com/office/drawing/2014/main" id="{038DEF44-407F-17DF-826D-68B727198272}"/>
              </a:ext>
            </a:extLst>
          </p:cNvPr>
          <p:cNvSpPr txBox="1"/>
          <p:nvPr/>
        </p:nvSpPr>
        <p:spPr>
          <a:xfrm>
            <a:off x="3438099" y="1988845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25">
            <a:extLst>
              <a:ext uri="{FF2B5EF4-FFF2-40B4-BE49-F238E27FC236}">
                <a16:creationId xmlns:a16="http://schemas.microsoft.com/office/drawing/2014/main" id="{1955F7DE-68DB-72C8-CDC5-BD9E02808686}"/>
              </a:ext>
            </a:extLst>
          </p:cNvPr>
          <p:cNvSpPr txBox="1"/>
          <p:nvPr/>
        </p:nvSpPr>
        <p:spPr>
          <a:xfrm>
            <a:off x="2640223" y="1987005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1117F6AD-4BD9-0C07-BEE1-529F50D56830}"/>
              </a:ext>
            </a:extLst>
          </p:cNvPr>
          <p:cNvSpPr/>
          <p:nvPr/>
        </p:nvSpPr>
        <p:spPr>
          <a:xfrm>
            <a:off x="2813711" y="5256688"/>
            <a:ext cx="338138" cy="956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8" name="文本框 17">
            <a:extLst>
              <a:ext uri="{FF2B5EF4-FFF2-40B4-BE49-F238E27FC236}">
                <a16:creationId xmlns:a16="http://schemas.microsoft.com/office/drawing/2014/main" id="{6BD337C5-650B-0BA8-5ECE-AE2D463D507D}"/>
              </a:ext>
            </a:extLst>
          </p:cNvPr>
          <p:cNvSpPr txBox="1"/>
          <p:nvPr/>
        </p:nvSpPr>
        <p:spPr>
          <a:xfrm>
            <a:off x="3096390" y="5178610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25">
            <a:extLst>
              <a:ext uri="{FF2B5EF4-FFF2-40B4-BE49-F238E27FC236}">
                <a16:creationId xmlns:a16="http://schemas.microsoft.com/office/drawing/2014/main" id="{060FE0F0-9F08-7C6E-47F2-1545545A1375}"/>
              </a:ext>
            </a:extLst>
          </p:cNvPr>
          <p:cNvSpPr txBox="1"/>
          <p:nvPr/>
        </p:nvSpPr>
        <p:spPr>
          <a:xfrm>
            <a:off x="2298514" y="5176770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3EFB905-A500-E0EB-2392-815151EC5C06}"/>
              </a:ext>
            </a:extLst>
          </p:cNvPr>
          <p:cNvSpPr txBox="1"/>
          <p:nvPr/>
        </p:nvSpPr>
        <p:spPr>
          <a:xfrm>
            <a:off x="1009422" y="2095568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2E8B957-5A2C-AA37-E22F-70FE27B93ABF}"/>
              </a:ext>
            </a:extLst>
          </p:cNvPr>
          <p:cNvSpPr txBox="1"/>
          <p:nvPr/>
        </p:nvSpPr>
        <p:spPr>
          <a:xfrm>
            <a:off x="1068052" y="4671900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42423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44DB57D-C147-A59F-9D1C-92FA14AB6BE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1925E26-651F-093A-E26D-504E21437782}"/>
              </a:ext>
            </a:extLst>
          </p:cNvPr>
          <p:cNvSpPr txBox="1"/>
          <p:nvPr/>
        </p:nvSpPr>
        <p:spPr>
          <a:xfrm>
            <a:off x="318309" y="179943"/>
            <a:ext cx="801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81521B6-4F61-4B02-5697-EE45B76EEA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6936" y="3635782"/>
            <a:ext cx="2187744" cy="300450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32E3C260-D283-D532-02A6-5545A86E50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8917" y="469494"/>
            <a:ext cx="2187744" cy="3004503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CE651B5-E1ED-8131-5228-7225E34250B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8549" y="549276"/>
            <a:ext cx="2187744" cy="300450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326ED4F-9E1C-2F70-4666-6DCD23087A0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3890" y="539749"/>
            <a:ext cx="2187744" cy="3004503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3D56EF90-931E-08CD-1ADE-01E0E98951E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0220" y="549275"/>
            <a:ext cx="2187744" cy="300450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38BDBEA-A1DE-2D0C-6574-B6ECFB73BFE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6129" y="3780926"/>
            <a:ext cx="2187744" cy="3004503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420594B5-61DD-C799-6382-56978FEB913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2380" y="3676597"/>
            <a:ext cx="2187744" cy="3004503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8EB81B10-BC38-B850-CDDE-BFA913E4C7EC}"/>
              </a:ext>
            </a:extLst>
          </p:cNvPr>
          <p:cNvSpPr txBox="1"/>
          <p:nvPr/>
        </p:nvSpPr>
        <p:spPr>
          <a:xfrm>
            <a:off x="9566205" y="2239689"/>
            <a:ext cx="5437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25">
            <a:extLst>
              <a:ext uri="{FF2B5EF4-FFF2-40B4-BE49-F238E27FC236}">
                <a16:creationId xmlns:a16="http://schemas.microsoft.com/office/drawing/2014/main" id="{852925F9-30C8-F226-6BB7-9CA07A4BA9B6}"/>
              </a:ext>
            </a:extLst>
          </p:cNvPr>
          <p:cNvSpPr txBox="1"/>
          <p:nvPr/>
        </p:nvSpPr>
        <p:spPr>
          <a:xfrm>
            <a:off x="8341829" y="2231994"/>
            <a:ext cx="5148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E38FA4F-4421-D3B9-062F-D767A5C013F3}"/>
              </a:ext>
            </a:extLst>
          </p:cNvPr>
          <p:cNvSpPr/>
          <p:nvPr/>
        </p:nvSpPr>
        <p:spPr>
          <a:xfrm>
            <a:off x="8856714" y="2257429"/>
            <a:ext cx="729725" cy="2284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86B565F6-04E3-586D-AB6F-83F1F1BA365D}"/>
              </a:ext>
            </a:extLst>
          </p:cNvPr>
          <p:cNvSpPr/>
          <p:nvPr/>
        </p:nvSpPr>
        <p:spPr>
          <a:xfrm>
            <a:off x="2459924" y="1903994"/>
            <a:ext cx="666773" cy="1528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5213005-36E7-C730-BD57-C43F1024EBAA}"/>
              </a:ext>
            </a:extLst>
          </p:cNvPr>
          <p:cNvSpPr txBox="1"/>
          <p:nvPr/>
        </p:nvSpPr>
        <p:spPr>
          <a:xfrm>
            <a:off x="3099823" y="1859975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2E11275-A483-5A8E-A7FA-0038038FA126}"/>
              </a:ext>
            </a:extLst>
          </p:cNvPr>
          <p:cNvSpPr txBox="1"/>
          <p:nvPr/>
        </p:nvSpPr>
        <p:spPr>
          <a:xfrm>
            <a:off x="1915000" y="1859975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995F6DDF-AD6A-6249-B175-DA9D0018B9CA}"/>
              </a:ext>
            </a:extLst>
          </p:cNvPr>
          <p:cNvSpPr/>
          <p:nvPr/>
        </p:nvSpPr>
        <p:spPr>
          <a:xfrm>
            <a:off x="4771849" y="2106196"/>
            <a:ext cx="597847" cy="1949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BDED9BF-629A-84AA-B88D-E00053B03F39}"/>
              </a:ext>
            </a:extLst>
          </p:cNvPr>
          <p:cNvSpPr txBox="1"/>
          <p:nvPr/>
        </p:nvSpPr>
        <p:spPr>
          <a:xfrm>
            <a:off x="5354546" y="2080579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994A236-05BF-8D52-1BFD-C07DDD28F608}"/>
              </a:ext>
            </a:extLst>
          </p:cNvPr>
          <p:cNvSpPr txBox="1"/>
          <p:nvPr/>
        </p:nvSpPr>
        <p:spPr>
          <a:xfrm>
            <a:off x="4231073" y="2072007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2273AC04-0DB6-A461-1D4B-FC99A1CD3446}"/>
              </a:ext>
            </a:extLst>
          </p:cNvPr>
          <p:cNvSpPr/>
          <p:nvPr/>
        </p:nvSpPr>
        <p:spPr>
          <a:xfrm>
            <a:off x="6764254" y="2029043"/>
            <a:ext cx="648582" cy="1543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676B118-8B36-8E40-F51A-48615A15C603}"/>
              </a:ext>
            </a:extLst>
          </p:cNvPr>
          <p:cNvSpPr txBox="1"/>
          <p:nvPr/>
        </p:nvSpPr>
        <p:spPr>
          <a:xfrm>
            <a:off x="7424201" y="1968620"/>
            <a:ext cx="7922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G-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28A80D0B-8B8C-93B1-3DB1-2EB237A49B83}"/>
              </a:ext>
            </a:extLst>
          </p:cNvPr>
          <p:cNvSpPr txBox="1"/>
          <p:nvPr/>
        </p:nvSpPr>
        <p:spPr>
          <a:xfrm>
            <a:off x="6308194" y="1977882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044CEF36-A4AE-5F0D-0988-9C8764640CFD}"/>
              </a:ext>
            </a:extLst>
          </p:cNvPr>
          <p:cNvSpPr/>
          <p:nvPr/>
        </p:nvSpPr>
        <p:spPr>
          <a:xfrm>
            <a:off x="5454971" y="5108419"/>
            <a:ext cx="595313" cy="1435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65CCB75-91A5-D90B-F8D8-5E8D72EE7894}"/>
              </a:ext>
            </a:extLst>
          </p:cNvPr>
          <p:cNvSpPr txBox="1"/>
          <p:nvPr/>
        </p:nvSpPr>
        <p:spPr>
          <a:xfrm>
            <a:off x="6101246" y="5078355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CE6E029-5C5D-F9E8-F9C4-D03392B55AE1}"/>
              </a:ext>
            </a:extLst>
          </p:cNvPr>
          <p:cNvSpPr txBox="1"/>
          <p:nvPr/>
        </p:nvSpPr>
        <p:spPr>
          <a:xfrm>
            <a:off x="4905154" y="5081844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BD687FF2-3435-AFE3-C649-EEB2650AEF13}"/>
              </a:ext>
            </a:extLst>
          </p:cNvPr>
          <p:cNvSpPr/>
          <p:nvPr/>
        </p:nvSpPr>
        <p:spPr>
          <a:xfrm>
            <a:off x="3024086" y="5078355"/>
            <a:ext cx="666773" cy="1528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A3223D1-F64E-EABE-41C9-5870D133F3A2}"/>
              </a:ext>
            </a:extLst>
          </p:cNvPr>
          <p:cNvSpPr txBox="1"/>
          <p:nvPr/>
        </p:nvSpPr>
        <p:spPr>
          <a:xfrm>
            <a:off x="3663985" y="5034336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BA8772E-A1C4-4902-7642-17560A4DCCF5}"/>
              </a:ext>
            </a:extLst>
          </p:cNvPr>
          <p:cNvSpPr txBox="1"/>
          <p:nvPr/>
        </p:nvSpPr>
        <p:spPr>
          <a:xfrm>
            <a:off x="2479162" y="5034336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3DA5D47D-D28C-212D-7BCB-1DEF8F6F9AE0}"/>
              </a:ext>
            </a:extLst>
          </p:cNvPr>
          <p:cNvSpPr/>
          <p:nvPr/>
        </p:nvSpPr>
        <p:spPr>
          <a:xfrm>
            <a:off x="8704873" y="4383662"/>
            <a:ext cx="648582" cy="1543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6DBF3ED-D97C-FA3E-E43B-DF146F019FCA}"/>
              </a:ext>
            </a:extLst>
          </p:cNvPr>
          <p:cNvSpPr txBox="1"/>
          <p:nvPr/>
        </p:nvSpPr>
        <p:spPr>
          <a:xfrm>
            <a:off x="9364820" y="4323239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HX9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C0D82A9-67F1-5B7F-E150-77CDDF9A85F4}"/>
              </a:ext>
            </a:extLst>
          </p:cNvPr>
          <p:cNvSpPr txBox="1"/>
          <p:nvPr/>
        </p:nvSpPr>
        <p:spPr>
          <a:xfrm>
            <a:off x="8173441" y="4346738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0KD</a:t>
            </a:r>
            <a:endParaRPr lang="zh-CN" altLang="en-US" sz="1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3EFB905-A500-E0EB-2392-815151EC5C06}"/>
              </a:ext>
            </a:extLst>
          </p:cNvPr>
          <p:cNvSpPr txBox="1"/>
          <p:nvPr/>
        </p:nvSpPr>
        <p:spPr>
          <a:xfrm>
            <a:off x="801354" y="1845099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2E8B957-5A2C-AA37-E22F-70FE27B93ABF}"/>
              </a:ext>
            </a:extLst>
          </p:cNvPr>
          <p:cNvSpPr txBox="1"/>
          <p:nvPr/>
        </p:nvSpPr>
        <p:spPr>
          <a:xfrm>
            <a:off x="1039356" y="4934569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3059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9</TotalTime>
  <Words>425</Words>
  <Application>Microsoft Office PowerPoint</Application>
  <PresentationFormat>宽屏</PresentationFormat>
  <Paragraphs>348</Paragraphs>
  <Slides>3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3</vt:i4>
      </vt:variant>
    </vt:vector>
  </HeadingPairs>
  <TitlesOfParts>
    <vt:vector size="3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子超 魏</dc:creator>
  <cp:lastModifiedBy>子超 魏</cp:lastModifiedBy>
  <cp:revision>74</cp:revision>
  <dcterms:created xsi:type="dcterms:W3CDTF">2025-06-08T10:22:37Z</dcterms:created>
  <dcterms:modified xsi:type="dcterms:W3CDTF">2025-06-29T15:53:16Z</dcterms:modified>
</cp:coreProperties>
</file>